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5" r:id="rId2"/>
    <p:sldId id="258" r:id="rId3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CC"/>
    <a:srgbClr val="CCCCFF"/>
    <a:srgbClr val="FFCCFF"/>
    <a:srgbClr val="CC99FF"/>
    <a:srgbClr val="CC66FF"/>
    <a:srgbClr val="404040"/>
    <a:srgbClr val="990000"/>
    <a:srgbClr val="CCFF99"/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1CEF96-62B4-4845-980C-633C6D42E13D}" v="469" dt="2020-05-07T16:40:19.34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84" autoAdjust="0"/>
    <p:restoredTop sz="75583" autoAdjust="0"/>
  </p:normalViewPr>
  <p:slideViewPr>
    <p:cSldViewPr snapToGrid="0">
      <p:cViewPr varScale="1">
        <p:scale>
          <a:sx n="86" d="100"/>
          <a:sy n="86" d="100"/>
        </p:scale>
        <p:origin x="24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ggie Bohm" userId="571282b2550de325" providerId="LiveId" clId="{BC1CEF96-62B4-4845-980C-633C6D42E13D}"/>
    <pc:docChg chg="undo custSel mod addSld delSld modSld sldOrd modMainMaster">
      <pc:chgData name="Maggie Bohm" userId="571282b2550de325" providerId="LiveId" clId="{BC1CEF96-62B4-4845-980C-633C6D42E13D}" dt="2020-05-08T18:16:33.242" v="12495" actId="14100"/>
      <pc:docMkLst>
        <pc:docMk/>
      </pc:docMkLst>
      <pc:sldChg chg="addSp delSp modSp del ord">
        <pc:chgData name="Maggie Bohm" userId="571282b2550de325" providerId="LiveId" clId="{BC1CEF96-62B4-4845-980C-633C6D42E13D}" dt="2020-04-15T19:13:19.594" v="3350" actId="47"/>
        <pc:sldMkLst>
          <pc:docMk/>
          <pc:sldMk cId="2573009564" sldId="256"/>
        </pc:sldMkLst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4" creationId="{CE4C7954-A59C-4A5D-B56E-C13A6C948906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46" creationId="{018C9784-F4FE-4491-8E16-99834604DB72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47" creationId="{3C69BB34-CD9F-4363-8FB9-2F0213EF3393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116" creationId="{DF4D9E1F-DADA-4743-814E-3674CDFAFDB6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136" creationId="{ED73FA10-9CDE-4DC5-B9CB-427F1BC2158B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2573009564" sldId="256"/>
            <ac:spMk id="187" creationId="{C37A332B-4D74-436F-81B3-B426C200AF8E}"/>
          </ac:spMkLst>
        </pc:s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44" creationId="{D2CA5063-BD6D-4A60-AED2-F38173F1728E}"/>
          </ac:grpSpMkLst>
        </pc:grpChg>
        <pc:grpChg chg="del mod">
          <ac:chgData name="Maggie Bohm" userId="571282b2550de325" providerId="LiveId" clId="{BC1CEF96-62B4-4845-980C-633C6D42E13D}" dt="2020-04-13T01:05:03.588" v="2868"/>
          <ac:grpSpMkLst>
            <pc:docMk/>
            <pc:sldMk cId="2573009564" sldId="256"/>
            <ac:grpSpMk id="53" creationId="{96F745A3-B5F5-47D6-82DF-638BA077503D}"/>
          </ac:grpSpMkLst>
        </pc:grpChg>
        <pc:grpChg chg="del mod">
          <ac:chgData name="Maggie Bohm" userId="571282b2550de325" providerId="LiveId" clId="{BC1CEF96-62B4-4845-980C-633C6D42E13D}" dt="2020-04-13T01:05:12.270" v="2873"/>
          <ac:grpSpMkLst>
            <pc:docMk/>
            <pc:sldMk cId="2573009564" sldId="256"/>
            <ac:grpSpMk id="57" creationId="{8FFBC842-4237-486D-8540-E8D176C68194}"/>
          </ac:grpSpMkLst>
        </pc:grpChg>
        <pc:grpChg chg="mod">
          <ac:chgData name="Maggie Bohm" userId="571282b2550de325" providerId="LiveId" clId="{BC1CEF96-62B4-4845-980C-633C6D42E13D}" dt="2020-04-13T01:05:12.270" v="2873"/>
          <ac:grpSpMkLst>
            <pc:docMk/>
            <pc:sldMk cId="2573009564" sldId="256"/>
            <ac:grpSpMk id="62" creationId="{7E2EB9FB-2899-451D-851F-CE50FC727546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83" creationId="{229D73BF-709D-4CA9-97AE-80F21ED156A8}"/>
          </ac:grpSpMkLst>
        </pc:grpChg>
        <pc:grpChg chg="mod">
          <ac:chgData name="Maggie Bohm" userId="571282b2550de325" providerId="LiveId" clId="{BC1CEF96-62B4-4845-980C-633C6D42E13D}" dt="2020-04-15T19:03:45.291" v="3345"/>
          <ac:grpSpMkLst>
            <pc:docMk/>
            <pc:sldMk cId="2573009564" sldId="256"/>
            <ac:grpSpMk id="95" creationId="{0029DB4A-6C15-4A1C-BA08-93E0F6D9D3D9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115" creationId="{BAA0679B-E414-4B0C-A6DB-89BF7D956F0A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135" creationId="{B71B50D7-8FA1-414C-9D38-BB0F4B72327A}"/>
          </ac:grpSpMkLst>
        </pc:grpChg>
        <pc:grpChg chg="mod">
          <ac:chgData name="Maggie Bohm" userId="571282b2550de325" providerId="LiveId" clId="{BC1CEF96-62B4-4845-980C-633C6D42E13D}" dt="2020-04-15T19:03:47.663" v="3349"/>
          <ac:grpSpMkLst>
            <pc:docMk/>
            <pc:sldMk cId="2573009564" sldId="256"/>
            <ac:grpSpMk id="154" creationId="{240950B3-A7C5-4D5A-B696-165D136E6336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186" creationId="{0DBC0500-F48E-4D61-9395-C7F83EA68BC4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209" creationId="{34AECCA6-78D6-404A-99E5-608012F06D1A}"/>
          </ac:grpSpMkLst>
        </pc:grpChg>
        <pc:grpChg chg="del mod">
          <ac:chgData name="Maggie Bohm" userId="571282b2550de325" providerId="LiveId" clId="{BC1CEF96-62B4-4845-980C-633C6D42E13D}" dt="2020-03-10T03:02:31.780" v="354"/>
          <ac:grpSpMkLst>
            <pc:docMk/>
            <pc:sldMk cId="2573009564" sldId="256"/>
            <ac:grpSpMk id="212" creationId="{72F93A02-3526-44D0-9000-50DBBEAAC659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573009564" sldId="256"/>
            <ac:grpSpMk id="223" creationId="{9A5219A5-F53B-401A-8F4C-7F2B686742AC}"/>
          </ac:grpSpMkLst>
        </pc:grp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2" creationId="{FBA2AF6C-9246-463A-ADD4-6E2BFAA457AF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3" creationId="{A3BCA356-6FA9-4D69-AF5A-8043252535C5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" creationId="{ECA18C63-E407-42D3-9993-45BFBBBCCB97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26" creationId="{F10F7B3A-1AD6-49B1-A6DE-E042D033F4F6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31" creationId="{C3956A27-358E-4F4D-A707-42569775C749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35" creationId="{9CFB66B6-0197-4E05-B34F-44C4DA4107F0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45" creationId="{BB5CAB00-00A8-4AAE-BD9E-1FB7C43D43A9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48" creationId="{2915D852-9691-48FF-A599-7D2B324830ED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49" creationId="{7D0DE2F5-9E6E-411B-88A2-0CDDD5910163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0" creationId="{95742563-DA9A-4A3C-8887-A261410155E1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1" creationId="{5394764C-AFAD-40D7-8FEA-1943EB0D0AB5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2" creationId="{FCB5F7C8-6137-448A-823F-50C0EB6E6BB0}"/>
          </ac:inkMkLst>
        </pc:inkChg>
        <pc:inkChg chg="add mod">
          <ac:chgData name="Maggie Bohm" userId="571282b2550de325" providerId="LiveId" clId="{BC1CEF96-62B4-4845-980C-633C6D42E13D}" dt="2020-04-15T19:03:45.291" v="3345"/>
          <ac:inkMkLst>
            <pc:docMk/>
            <pc:sldMk cId="2573009564" sldId="256"/>
            <ac:inkMk id="53" creationId="{CE4BAF16-7CA8-4623-BEC7-22B2B4C494EE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4" creationId="{D5E4077C-F614-4962-B746-3F084D36F33D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5" creationId="{9359E598-98F5-4E74-BE55-9C8F383779E2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6" creationId="{78DB6B13-5AA2-4BD2-9CBB-941676862996}"/>
          </ac:inkMkLst>
        </pc:inkChg>
        <pc:inkChg chg="add mod">
          <ac:chgData name="Maggie Bohm" userId="571282b2550de325" providerId="LiveId" clId="{BC1CEF96-62B4-4845-980C-633C6D42E13D}" dt="2020-04-15T19:03:45.291" v="3345"/>
          <ac:inkMkLst>
            <pc:docMk/>
            <pc:sldMk cId="2573009564" sldId="256"/>
            <ac:inkMk id="57" creationId="{1673C3F9-3208-400F-99F8-72995A701D39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8" creationId="{BAC0A374-9B21-48DD-9E03-227F528DF6B6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59" creationId="{02A0E63E-02D7-44D2-BBDF-1D09733B70F7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60" creationId="{E55DABB8-19D6-411B-88CF-1930434426B2}"/>
          </ac:inkMkLst>
        </pc:inkChg>
        <pc:inkChg chg="add mod">
          <ac:chgData name="Maggie Bohm" userId="571282b2550de325" providerId="LiveId" clId="{BC1CEF96-62B4-4845-980C-633C6D42E13D}" dt="2020-04-13T01:05:12.270" v="2873"/>
          <ac:inkMkLst>
            <pc:docMk/>
            <pc:sldMk cId="2573009564" sldId="256"/>
            <ac:inkMk id="61" creationId="{A155CA3D-C4F6-4CC4-AD5D-4CAB2CFE2223}"/>
          </ac:inkMkLst>
        </pc:inkChg>
        <pc:inkChg chg="add mod">
          <ac:chgData name="Maggie Bohm" userId="571282b2550de325" providerId="LiveId" clId="{BC1CEF96-62B4-4845-980C-633C6D42E13D}" dt="2020-04-15T19:03:47.663" v="3349"/>
          <ac:inkMkLst>
            <pc:docMk/>
            <pc:sldMk cId="2573009564" sldId="256"/>
            <ac:inkMk id="109" creationId="{9D14DDB0-F102-4396-BAE8-D7A4A9564DD2}"/>
          </ac:inkMkLst>
        </pc:inkChg>
        <pc:inkChg chg="add mod">
          <ac:chgData name="Maggie Bohm" userId="571282b2550de325" providerId="LiveId" clId="{BC1CEF96-62B4-4845-980C-633C6D42E13D}" dt="2020-04-15T19:03:47.663" v="3349"/>
          <ac:inkMkLst>
            <pc:docMk/>
            <pc:sldMk cId="2573009564" sldId="256"/>
            <ac:inkMk id="151" creationId="{AD9EB9BC-5B81-4110-A8EC-AB7BEE86AD7A}"/>
          </ac:inkMkLst>
        </pc:inkChg>
        <pc:inkChg chg="add mod">
          <ac:chgData name="Maggie Bohm" userId="571282b2550de325" providerId="LiveId" clId="{BC1CEF96-62B4-4845-980C-633C6D42E13D}" dt="2020-04-15T19:03:47.663" v="3349"/>
          <ac:inkMkLst>
            <pc:docMk/>
            <pc:sldMk cId="2573009564" sldId="256"/>
            <ac:inkMk id="153" creationId="{80D4527B-60D5-4ED9-BD27-114C7B2B1CE2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0" creationId="{4A09CCFB-C3F5-4538-87AB-1FBDCB9B835D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1" creationId="{4B5194EE-59C0-4257-8DFF-05CB50B71BD6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3" creationId="{0A48BF29-6A60-4A41-8EA4-6C8622329CED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4" creationId="{881EC7E4-D01D-4BB5-ADD8-D4D839CE550F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5" creationId="{EE1C3174-317F-4E84-A601-6FDF277689EA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6" creationId="{E5C63661-DF35-401B-890B-9B992B43B7A8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7" creationId="{02AA4BFE-431A-4C10-8F96-A39E678F5929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8" creationId="{FA846EE1-1676-4907-A24B-E37731D971CA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19" creationId="{15D91071-AC5A-4400-8116-FDD0066413CE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20" creationId="{124FE029-6E19-4F09-B5FB-31FC9A9C5642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21" creationId="{19AB3C23-6E66-4567-85A5-0D84BE86AEA0}"/>
          </ac:inkMkLst>
        </pc:inkChg>
        <pc:inkChg chg="add mod">
          <ac:chgData name="Maggie Bohm" userId="571282b2550de325" providerId="LiveId" clId="{BC1CEF96-62B4-4845-980C-633C6D42E13D}" dt="2020-03-10T03:02:31.780" v="354"/>
          <ac:inkMkLst>
            <pc:docMk/>
            <pc:sldMk cId="2573009564" sldId="256"/>
            <ac:inkMk id="222" creationId="{2D1093F0-EED8-4082-8765-26F2AA2646A1}"/>
          </ac:inkMkLst>
        </pc:inkChg>
        <pc:inkChg chg="add del">
          <ac:chgData name="Maggie Bohm" userId="571282b2550de325" providerId="LiveId" clId="{BC1CEF96-62B4-4845-980C-633C6D42E13D}" dt="2020-03-10T03:02:56.213" v="356" actId="9405"/>
          <ac:inkMkLst>
            <pc:docMk/>
            <pc:sldMk cId="2573009564" sldId="256"/>
            <ac:inkMk id="224" creationId="{33EC510A-E517-4594-BAD1-1BB240263CC0}"/>
          </ac:inkMkLst>
        </pc:inkChg>
      </pc:sldChg>
      <pc:sldChg chg="addSp delSp modSp del ord">
        <pc:chgData name="Maggie Bohm" userId="571282b2550de325" providerId="LiveId" clId="{BC1CEF96-62B4-4845-980C-633C6D42E13D}" dt="2020-04-15T19:13:21.567" v="3351" actId="47"/>
        <pc:sldMkLst>
          <pc:docMk/>
          <pc:sldMk cId="1721555194" sldId="257"/>
        </pc:sldMkLst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4" creationId="{CE4C7954-A59C-4A5D-B56E-C13A6C948906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46" creationId="{018C9784-F4FE-4491-8E16-99834604DB72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47" creationId="{3C69BB34-CD9F-4363-8FB9-2F0213EF3393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116" creationId="{DF4D9E1F-DADA-4743-814E-3674CDFAFDB6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136" creationId="{ED73FA10-9CDE-4DC5-B9CB-427F1BC2158B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k cId="1721555194" sldId="257"/>
            <ac:spMk id="187" creationId="{C37A332B-4D74-436F-81B3-B426C200AF8E}"/>
          </ac:spMkLst>
        </pc:spChg>
        <pc:grpChg chg="del mod">
          <ac:chgData name="Maggie Bohm" userId="571282b2550de325" providerId="LiveId" clId="{BC1CEF96-62B4-4845-980C-633C6D42E13D}" dt="2020-03-10T03:01:08.137" v="320"/>
          <ac:grpSpMkLst>
            <pc:docMk/>
            <pc:sldMk cId="1721555194" sldId="257"/>
            <ac:grpSpMk id="60" creationId="{466E625E-9BD6-43DE-8F0B-3346208EDE5F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1721555194" sldId="257"/>
            <ac:grpSpMk id="153" creationId="{5EC98196-A176-489A-AB0A-327CBE75FFE0}"/>
          </ac:grpSpMkLst>
        </pc:grpChg>
        <pc:inkChg chg="mod">
          <ac:chgData name="Maggie Bohm" userId="571282b2550de325" providerId="LiveId" clId="{BC1CEF96-62B4-4845-980C-633C6D42E13D}" dt="2020-04-02T15:04:03.602" v="671"/>
          <ac:inkMkLst>
            <pc:docMk/>
            <pc:sldMk cId="1721555194" sldId="257"/>
            <ac:inkMk id="5" creationId="{8DFAE657-A161-4561-895C-7E7912DA2343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3" creationId="{19E34878-8131-4677-88FA-D11731880DB3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4" creationId="{30A898A5-8281-4653-A892-784C338F6FF4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5" creationId="{D924A361-F1C5-48FD-B0BC-AF302E273A01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6" creationId="{DAE71C6C-E95C-4CF6-B673-0072BA91BE48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7" creationId="{B83D2C2D-4343-4DCE-865B-4032B746FD7C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8" creationId="{75AD2581-D01B-45E8-BC3D-F44B3DD42E7A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59" creationId="{C62AD052-7F9F-4004-8A4D-4B6887B580BB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61" creationId="{BEE65020-50CB-4D2B-B3B1-810F7BEB9B01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62" creationId="{4FB6C04C-5339-4C08-8CE5-C5F9A13A4CD9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95" creationId="{3A83B799-D312-472A-9F86-2BD623AD4EF5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109" creationId="{5F162694-08EA-4A83-9BDF-B2C58EE36E44}"/>
          </ac:inkMkLst>
        </pc:inkChg>
        <pc:inkChg chg="add mod">
          <ac:chgData name="Maggie Bohm" userId="571282b2550de325" providerId="LiveId" clId="{BC1CEF96-62B4-4845-980C-633C6D42E13D}" dt="2020-03-10T03:01:08.137" v="320"/>
          <ac:inkMkLst>
            <pc:docMk/>
            <pc:sldMk cId="1721555194" sldId="257"/>
            <ac:inkMk id="151" creationId="{8EFDFC96-BACD-49C0-8869-68102E7E5A7B}"/>
          </ac:inkMkLst>
        </pc:inkChg>
      </pc:sldChg>
      <pc:sldChg chg="addSp delSp modSp add ord modNotesTx">
        <pc:chgData name="Maggie Bohm" userId="571282b2550de325" providerId="LiveId" clId="{BC1CEF96-62B4-4845-980C-633C6D42E13D}" dt="2020-05-01T15:51:42.585" v="12492" actId="20577"/>
        <pc:sldMkLst>
          <pc:docMk/>
          <pc:sldMk cId="1908538928" sldId="258"/>
        </pc:sldMkLst>
        <pc:spChg chg="add del mod">
          <ac:chgData name="Maggie Bohm" userId="571282b2550de325" providerId="LiveId" clId="{BC1CEF96-62B4-4845-980C-633C6D42E13D}" dt="2020-04-08T13:30:34.755" v="2708" actId="478"/>
          <ac:spMkLst>
            <pc:docMk/>
            <pc:sldMk cId="1908538928" sldId="258"/>
            <ac:spMk id="2" creationId="{FECE2153-3437-411F-8059-1DB3E075E7E2}"/>
          </ac:spMkLst>
        </pc:spChg>
        <pc:spChg chg="add del mod">
          <ac:chgData name="Maggie Bohm" userId="571282b2550de325" providerId="LiveId" clId="{BC1CEF96-62B4-4845-980C-633C6D42E13D}" dt="2020-04-22T19:15:12.893" v="11564" actId="478"/>
          <ac:spMkLst>
            <pc:docMk/>
            <pc:sldMk cId="1908538928" sldId="258"/>
            <ac:spMk id="4" creationId="{87955230-BC3C-4EEE-AFC2-677021086772}"/>
          </ac:spMkLst>
        </pc:spChg>
        <pc:spChg chg="add del mod">
          <ac:chgData name="Maggie Bohm" userId="571282b2550de325" providerId="LiveId" clId="{BC1CEF96-62B4-4845-980C-633C6D42E13D}" dt="2020-04-08T13:30:57.599" v="2711" actId="478"/>
          <ac:spMkLst>
            <pc:docMk/>
            <pc:sldMk cId="1908538928" sldId="258"/>
            <ac:spMk id="5" creationId="{DB935460-5AE3-48CA-B633-7EAB3BA3C68E}"/>
          </ac:spMkLst>
        </pc:spChg>
        <pc:spChg chg="add mod">
          <ac:chgData name="Maggie Bohm" userId="571282b2550de325" providerId="LiveId" clId="{BC1CEF96-62B4-4845-980C-633C6D42E13D}" dt="2020-04-28T19:35:12.922" v="12102" actId="14100"/>
          <ac:spMkLst>
            <pc:docMk/>
            <pc:sldMk cId="1908538928" sldId="258"/>
            <ac:spMk id="6" creationId="{FB9AE3DD-E69D-403E-B6BC-A4C3320A8F17}"/>
          </ac:spMkLst>
        </pc:spChg>
        <pc:spChg chg="add del mod">
          <ac:chgData name="Maggie Bohm" userId="571282b2550de325" providerId="LiveId" clId="{BC1CEF96-62B4-4845-980C-633C6D42E13D}" dt="2020-04-09T00:56:06.662" v="2739" actId="478"/>
          <ac:spMkLst>
            <pc:docMk/>
            <pc:sldMk cId="1908538928" sldId="258"/>
            <ac:spMk id="8" creationId="{455AF319-61E2-4A0F-8EF1-8732063960CF}"/>
          </ac:spMkLst>
        </pc:spChg>
        <pc:grpChg chg="del mod">
          <ac:chgData name="Maggie Bohm" userId="571282b2550de325" providerId="LiveId" clId="{BC1CEF96-62B4-4845-980C-633C6D42E13D}" dt="2020-03-10T03:02:10.370" v="340"/>
          <ac:grpSpMkLst>
            <pc:docMk/>
            <pc:sldMk cId="1908538928" sldId="258"/>
            <ac:grpSpMk id="7" creationId="{D8F77CD1-EBFA-4E67-B803-831B101A0579}"/>
          </ac:grpSpMkLst>
        </pc:grpChg>
        <pc:grpChg chg="del mod">
          <ac:chgData name="Maggie Bohm" userId="571282b2550de325" providerId="LiveId" clId="{BC1CEF96-62B4-4845-980C-633C6D42E13D}" dt="2020-04-02T14:45:02.706" v="395" actId="478"/>
          <ac:grpSpMkLst>
            <pc:docMk/>
            <pc:sldMk cId="1908538928" sldId="258"/>
            <ac:grpSpMk id="9" creationId="{7C49DEB0-EF04-495D-8DE8-6F8A742F007A}"/>
          </ac:grpSpMkLst>
        </pc:grpChg>
        <pc:grpChg chg="del mod">
          <ac:chgData name="Maggie Bohm" userId="571282b2550de325" providerId="LiveId" clId="{BC1CEF96-62B4-4845-980C-633C6D42E13D}" dt="2020-04-13T01:01:57.989" v="2764"/>
          <ac:grpSpMkLst>
            <pc:docMk/>
            <pc:sldMk cId="1908538928" sldId="258"/>
            <ac:grpSpMk id="12" creationId="{B58370BA-4852-49F2-BDC2-6A9F1CA111FE}"/>
          </ac:grpSpMkLst>
        </pc:grpChg>
        <pc:grpChg chg="add del mod">
          <ac:chgData name="Maggie Bohm" userId="571282b2550de325" providerId="LiveId" clId="{BC1CEF96-62B4-4845-980C-633C6D42E13D}" dt="2020-04-17T20:01:56.655" v="6186" actId="165"/>
          <ac:grpSpMkLst>
            <pc:docMk/>
            <pc:sldMk cId="1908538928" sldId="258"/>
            <ac:grpSpMk id="13" creationId="{B34EA2D4-2A44-4E61-A02E-17099999E63C}"/>
          </ac:grpSpMkLst>
        </pc:grpChg>
        <pc:grpChg chg="del mod">
          <ac:chgData name="Maggie Bohm" userId="571282b2550de325" providerId="LiveId" clId="{BC1CEF96-62B4-4845-980C-633C6D42E13D}" dt="2020-04-15T18:15:59.513" v="2892" actId="478"/>
          <ac:grpSpMkLst>
            <pc:docMk/>
            <pc:sldMk cId="1908538928" sldId="258"/>
            <ac:grpSpMk id="16" creationId="{0B6A2F2B-6C41-4C0E-8553-ED2F79087083}"/>
          </ac:grpSpMkLst>
        </pc:grpChg>
        <pc:grpChg chg="del mod">
          <ac:chgData name="Maggie Bohm" userId="571282b2550de325" providerId="LiveId" clId="{BC1CEF96-62B4-4845-980C-633C6D42E13D}" dt="2020-04-13T01:02:14.332" v="2771"/>
          <ac:grpSpMkLst>
            <pc:docMk/>
            <pc:sldMk cId="1908538928" sldId="258"/>
            <ac:grpSpMk id="20" creationId="{8B0E5A70-D1AF-4F51-ADE9-7A9BD7381111}"/>
          </ac:grpSpMkLst>
        </pc:grpChg>
        <pc:grpChg chg="del mod">
          <ac:chgData name="Maggie Bohm" userId="571282b2550de325" providerId="LiveId" clId="{BC1CEF96-62B4-4845-980C-633C6D42E13D}" dt="2020-04-15T18:16:00.622" v="2893" actId="478"/>
          <ac:grpSpMkLst>
            <pc:docMk/>
            <pc:sldMk cId="1908538928" sldId="258"/>
            <ac:grpSpMk id="23" creationId="{57908636-E5B7-46DE-A8B3-1273B65FFCB4}"/>
          </ac:grpSpMkLst>
        </pc:grpChg>
        <pc:graphicFrameChg chg="add del mod modGraphic">
          <ac:chgData name="Maggie Bohm" userId="571282b2550de325" providerId="LiveId" clId="{BC1CEF96-62B4-4845-980C-633C6D42E13D}" dt="2020-04-08T13:30:39.435" v="2709" actId="478"/>
          <ac:graphicFrameMkLst>
            <pc:docMk/>
            <pc:sldMk cId="1908538928" sldId="258"/>
            <ac:graphicFrameMk id="11" creationId="{AF38617A-2453-41EB-A504-BCDCA6F1C6D7}"/>
          </ac:graphicFrameMkLst>
        </pc:graphicFrameChg>
        <pc:picChg chg="add del mod">
          <ac:chgData name="Maggie Bohm" userId="571282b2550de325" providerId="LiveId" clId="{BC1CEF96-62B4-4845-980C-633C6D42E13D}" dt="2020-04-17T20:00:45.730" v="6170" actId="478"/>
          <ac:picMkLst>
            <pc:docMk/>
            <pc:sldMk cId="1908538928" sldId="258"/>
            <ac:picMk id="3" creationId="{1B31EE7B-D114-4365-B44D-673120E2E282}"/>
          </ac:picMkLst>
        </pc:picChg>
        <pc:picChg chg="add del mod">
          <ac:chgData name="Maggie Bohm" userId="571282b2550de325" providerId="LiveId" clId="{BC1CEF96-62B4-4845-980C-633C6D42E13D}" dt="2020-04-08T13:30:42.925" v="2710" actId="478"/>
          <ac:picMkLst>
            <pc:docMk/>
            <pc:sldMk cId="1908538928" sldId="258"/>
            <ac:picMk id="3" creationId="{3FA25381-CAA1-416A-B5C0-ACE0B42BA8EE}"/>
          </ac:picMkLst>
        </pc:picChg>
        <pc:picChg chg="add del mod">
          <ac:chgData name="Maggie Bohm" userId="571282b2550de325" providerId="LiveId" clId="{BC1CEF96-62B4-4845-980C-633C6D42E13D}" dt="2020-04-16T17:30:32.048" v="5981" actId="478"/>
          <ac:picMkLst>
            <pc:docMk/>
            <pc:sldMk cId="1908538928" sldId="258"/>
            <ac:picMk id="3" creationId="{81E056D9-6F7E-47B9-A124-77E12007C153}"/>
          </ac:picMkLst>
        </pc:picChg>
        <pc:picChg chg="add del mod">
          <ac:chgData name="Maggie Bohm" userId="571282b2550de325" providerId="LiveId" clId="{BC1CEF96-62B4-4845-980C-633C6D42E13D}" dt="2020-04-15T18:16:01.681" v="2894" actId="478"/>
          <ac:picMkLst>
            <pc:docMk/>
            <pc:sldMk cId="1908538928" sldId="258"/>
            <ac:picMk id="5" creationId="{42F36EB7-9142-42CD-9CA6-085EE01B9005}"/>
          </ac:picMkLst>
        </pc:picChg>
        <pc:picChg chg="add del mod">
          <ac:chgData name="Maggie Bohm" userId="571282b2550de325" providerId="LiveId" clId="{BC1CEF96-62B4-4845-980C-633C6D42E13D}" dt="2020-04-17T20:00:46.905" v="6171" actId="478"/>
          <ac:picMkLst>
            <pc:docMk/>
            <pc:sldMk cId="1908538928" sldId="258"/>
            <ac:picMk id="5" creationId="{9ACD0BBF-E3FB-4762-8797-448D3920519C}"/>
          </ac:picMkLst>
        </pc:picChg>
        <pc:picChg chg="add del mod">
          <ac:chgData name="Maggie Bohm" userId="571282b2550de325" providerId="LiveId" clId="{BC1CEF96-62B4-4845-980C-633C6D42E13D}" dt="2020-04-16T17:30:33.801" v="5982" actId="478"/>
          <ac:picMkLst>
            <pc:docMk/>
            <pc:sldMk cId="1908538928" sldId="258"/>
            <ac:picMk id="6" creationId="{E84182D4-9C64-48CD-A859-E0D5F1FB5E15}"/>
          </ac:picMkLst>
        </pc:picChg>
        <pc:picChg chg="add mod">
          <ac:chgData name="Maggie Bohm" userId="571282b2550de325" providerId="LiveId" clId="{BC1CEF96-62B4-4845-980C-633C6D42E13D}" dt="2020-04-28T19:35:48.154" v="12103" actId="1076"/>
          <ac:picMkLst>
            <pc:docMk/>
            <pc:sldMk cId="1908538928" sldId="258"/>
            <ac:picMk id="7" creationId="{5E1F4F99-86A5-4AFE-B309-31ADB956FDC7}"/>
          </ac:picMkLst>
        </pc:picChg>
        <pc:picChg chg="add del mod">
          <ac:chgData name="Maggie Bohm" userId="571282b2550de325" providerId="LiveId" clId="{BC1CEF96-62B4-4845-980C-633C6D42E13D}" dt="2020-04-09T00:55:58.807" v="2735" actId="478"/>
          <ac:picMkLst>
            <pc:docMk/>
            <pc:sldMk cId="1908538928" sldId="258"/>
            <ac:picMk id="7" creationId="{67131A04-00D3-4F8D-B2BB-CFDF1D928BA3}"/>
          </ac:picMkLst>
        </pc:picChg>
        <pc:picChg chg="add del mod">
          <ac:chgData name="Maggie Bohm" userId="571282b2550de325" providerId="LiveId" clId="{BC1CEF96-62B4-4845-980C-633C6D42E13D}" dt="2020-04-17T20:00:44.184" v="6168" actId="478"/>
          <ac:picMkLst>
            <pc:docMk/>
            <pc:sldMk cId="1908538928" sldId="258"/>
            <ac:picMk id="8" creationId="{EC656B30-51C8-43FC-AACF-B1683CE3C819}"/>
          </ac:picMkLst>
        </pc:picChg>
        <pc:picChg chg="add del mod">
          <ac:chgData name="Maggie Bohm" userId="571282b2550de325" providerId="LiveId" clId="{BC1CEF96-62B4-4845-980C-633C6D42E13D}" dt="2020-04-09T20:03:08.890" v="2747" actId="478"/>
          <ac:picMkLst>
            <pc:docMk/>
            <pc:sldMk cId="1908538928" sldId="258"/>
            <ac:picMk id="9" creationId="{696A5999-BB5B-407D-9DF5-57FBF8914F41}"/>
          </ac:picMkLst>
        </pc:picChg>
        <pc:picChg chg="add del mod ord topLvl">
          <ac:chgData name="Maggie Bohm" userId="571282b2550de325" providerId="LiveId" clId="{BC1CEF96-62B4-4845-980C-633C6D42E13D}" dt="2020-04-28T19:32:40.313" v="12064" actId="478"/>
          <ac:picMkLst>
            <pc:docMk/>
            <pc:sldMk cId="1908538928" sldId="258"/>
            <ac:picMk id="10" creationId="{07183763-9E86-4B93-9B3D-8F6A2C2F7708}"/>
          </ac:picMkLst>
        </pc:picChg>
        <pc:picChg chg="add del mod">
          <ac:chgData name="Maggie Bohm" userId="571282b2550de325" providerId="LiveId" clId="{BC1CEF96-62B4-4845-980C-633C6D42E13D}" dt="2020-04-08T14:18:01.481" v="2716" actId="478"/>
          <ac:picMkLst>
            <pc:docMk/>
            <pc:sldMk cId="1908538928" sldId="258"/>
            <ac:picMk id="10" creationId="{EE40A4D2-B406-4F51-911E-A02269EC2C1B}"/>
          </ac:picMkLst>
        </pc:picChg>
        <pc:picChg chg="add del mod topLvl">
          <ac:chgData name="Maggie Bohm" userId="571282b2550de325" providerId="LiveId" clId="{BC1CEF96-62B4-4845-980C-633C6D42E13D}" dt="2020-04-28T19:31:59.968" v="12063" actId="478"/>
          <ac:picMkLst>
            <pc:docMk/>
            <pc:sldMk cId="1908538928" sldId="258"/>
            <ac:picMk id="12" creationId="{A7436400-26A3-4A7F-BE43-86DF056A048D}"/>
          </ac:picMkLst>
        </pc:picChg>
        <pc:inkChg chg="add del">
          <ac:chgData name="Maggie Bohm" userId="571282b2550de325" providerId="LiveId" clId="{BC1CEF96-62B4-4845-980C-633C6D42E13D}" dt="2020-04-13T01:00:03.936" v="2752" actId="9405"/>
          <ac:inkMkLst>
            <pc:docMk/>
            <pc:sldMk cId="1908538928" sldId="258"/>
            <ac:inkMk id="2" creationId="{47D9B7BC-1723-4316-A5FE-641EBA7B7610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2" creationId="{9D8CBD72-CD8E-4BDE-8D8D-0FBAAC1C7513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3" creationId="{1AD8E9ED-D70D-44E5-A79F-EF9B934F871A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4" creationId="{74B643F7-EB5B-43B4-A6A8-DBE8E001A5F9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5" creationId="{01A666F6-44A1-4605-8F45-D99241BD596E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6" creationId="{A3285ADF-034B-4909-81C2-C44496146A65}"/>
          </ac:inkMkLst>
        </pc:inkChg>
        <pc:inkChg chg="add del">
          <ac:chgData name="Maggie Bohm" userId="571282b2550de325" providerId="LiveId" clId="{BC1CEF96-62B4-4845-980C-633C6D42E13D}" dt="2020-04-13T01:01:36.967" v="2754" actId="9405"/>
          <ac:inkMkLst>
            <pc:docMk/>
            <pc:sldMk cId="1908538928" sldId="258"/>
            <ac:inkMk id="6" creationId="{FAE135AC-C443-4055-ABA4-9F480D9C79C6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7" creationId="{F891E397-6780-4C67-BB7C-95CC07D1F617}"/>
          </ac:inkMkLst>
        </pc:inkChg>
        <pc:inkChg chg="add mod">
          <ac:chgData name="Maggie Bohm" userId="571282b2550de325" providerId="LiveId" clId="{BC1CEF96-62B4-4845-980C-633C6D42E13D}" dt="2020-03-10T03:02:10.370" v="340"/>
          <ac:inkMkLst>
            <pc:docMk/>
            <pc:sldMk cId="1908538928" sldId="258"/>
            <ac:inkMk id="8" creationId="{4F324E93-FA5B-404E-A36D-31046C571EBF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8" creationId="{D0B82B98-B49D-4575-8C0B-B9A88A1606E5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9" creationId="{A5D764FD-1535-4B26-896C-87F7935DD6B3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10" creationId="{E5D3B945-30F8-4B85-BB88-A57CED8E7AA0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11" creationId="{06B65220-A7C8-4904-B419-B924D1A1662D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13" creationId="{32B39D2F-C0E4-4E3B-8453-B5B02663B9BC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14" creationId="{FC2AECCD-782A-44F6-B2AC-24AF6654696E}"/>
          </ac:inkMkLst>
        </pc:inkChg>
        <pc:inkChg chg="add mod">
          <ac:chgData name="Maggie Bohm" userId="571282b2550de325" providerId="LiveId" clId="{BC1CEF96-62B4-4845-980C-633C6D42E13D}" dt="2020-04-13T01:01:57.989" v="2764"/>
          <ac:inkMkLst>
            <pc:docMk/>
            <pc:sldMk cId="1908538928" sldId="258"/>
            <ac:inkMk id="15" creationId="{B5448007-F791-4B20-A363-7013889EB75B}"/>
          </ac:inkMkLst>
        </pc:inkChg>
        <pc:inkChg chg="add mod">
          <ac:chgData name="Maggie Bohm" userId="571282b2550de325" providerId="LiveId" clId="{BC1CEF96-62B4-4845-980C-633C6D42E13D}" dt="2020-04-13T01:02:14.332" v="2771"/>
          <ac:inkMkLst>
            <pc:docMk/>
            <pc:sldMk cId="1908538928" sldId="258"/>
            <ac:inkMk id="17" creationId="{634D4BD2-C695-49DD-81B8-019609A626E0}"/>
          </ac:inkMkLst>
        </pc:inkChg>
        <pc:inkChg chg="add mod">
          <ac:chgData name="Maggie Bohm" userId="571282b2550de325" providerId="LiveId" clId="{BC1CEF96-62B4-4845-980C-633C6D42E13D}" dt="2020-04-13T01:02:14.332" v="2771"/>
          <ac:inkMkLst>
            <pc:docMk/>
            <pc:sldMk cId="1908538928" sldId="258"/>
            <ac:inkMk id="18" creationId="{318311D5-B962-4CA4-920A-9EDC7F5CDCD5}"/>
          </ac:inkMkLst>
        </pc:inkChg>
        <pc:inkChg chg="add mod">
          <ac:chgData name="Maggie Bohm" userId="571282b2550de325" providerId="LiveId" clId="{BC1CEF96-62B4-4845-980C-633C6D42E13D}" dt="2020-04-13T01:02:14.332" v="2771"/>
          <ac:inkMkLst>
            <pc:docMk/>
            <pc:sldMk cId="1908538928" sldId="258"/>
            <ac:inkMk id="19" creationId="{96EBBFFC-CC62-4A52-8015-DA718015E45E}"/>
          </ac:inkMkLst>
        </pc:inkChg>
        <pc:inkChg chg="add mod">
          <ac:chgData name="Maggie Bohm" userId="571282b2550de325" providerId="LiveId" clId="{BC1CEF96-62B4-4845-980C-633C6D42E13D}" dt="2020-04-13T01:02:14.332" v="2771"/>
          <ac:inkMkLst>
            <pc:docMk/>
            <pc:sldMk cId="1908538928" sldId="258"/>
            <ac:inkMk id="21" creationId="{0EBC64CE-74EE-4C48-9243-5AA7B5F74618}"/>
          </ac:inkMkLst>
        </pc:inkChg>
        <pc:inkChg chg="add mod">
          <ac:chgData name="Maggie Bohm" userId="571282b2550de325" providerId="LiveId" clId="{BC1CEF96-62B4-4845-980C-633C6D42E13D}" dt="2020-04-13T01:02:14.332" v="2771"/>
          <ac:inkMkLst>
            <pc:docMk/>
            <pc:sldMk cId="1908538928" sldId="258"/>
            <ac:inkMk id="22" creationId="{4CC46670-DC5F-44B5-BFE7-B4EE4E864403}"/>
          </ac:inkMkLst>
        </pc:inkChg>
      </pc:sldChg>
      <pc:sldChg chg="addSp delSp modSp add del">
        <pc:chgData name="Maggie Bohm" userId="571282b2550de325" providerId="LiveId" clId="{BC1CEF96-62B4-4845-980C-633C6D42E13D}" dt="2020-04-15T19:13:30.212" v="3353" actId="47"/>
        <pc:sldMkLst>
          <pc:docMk/>
          <pc:sldMk cId="3498319346" sldId="259"/>
        </pc:sldMkLst>
        <pc:grpChg chg="del mod">
          <ac:chgData name="Maggie Bohm" userId="571282b2550de325" providerId="LiveId" clId="{BC1CEF96-62B4-4845-980C-633C6D42E13D}" dt="2020-03-10T02:53:08.400" v="32"/>
          <ac:grpSpMkLst>
            <pc:docMk/>
            <pc:sldMk cId="3498319346" sldId="259"/>
            <ac:grpSpMk id="19" creationId="{CAFF16CF-6030-4FB7-993C-482491556716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20" creationId="{D1F45916-1AA5-4342-B2A0-4EDC6487B816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27" creationId="{C7522CAD-ABB3-4C2A-A92C-A4B0574B4A64}"/>
          </ac:grpSpMkLst>
        </pc:grpChg>
        <pc:grpChg chg="del mod">
          <ac:chgData name="Maggie Bohm" userId="571282b2550de325" providerId="LiveId" clId="{BC1CEF96-62B4-4845-980C-633C6D42E13D}" dt="2020-03-10T02:53:21.198" v="43"/>
          <ac:grpSpMkLst>
            <pc:docMk/>
            <pc:sldMk cId="3498319346" sldId="259"/>
            <ac:grpSpMk id="31" creationId="{5A755988-79F7-4631-AAF5-63A74F76ACC0}"/>
          </ac:grpSpMkLst>
        </pc:grpChg>
        <pc:grpChg chg="del mod">
          <ac:chgData name="Maggie Bohm" userId="571282b2550de325" providerId="LiveId" clId="{BC1CEF96-62B4-4845-980C-633C6D42E13D}" dt="2020-03-10T02:53:23.133" v="46"/>
          <ac:grpSpMkLst>
            <pc:docMk/>
            <pc:sldMk cId="3498319346" sldId="259"/>
            <ac:grpSpMk id="38" creationId="{35A9A7FB-1B49-45BB-8F0B-51777B7257D5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41" creationId="{D4A797F2-0C6E-4852-812E-AA672722A44B}"/>
          </ac:grpSpMkLst>
        </pc:grpChg>
        <pc:grpChg chg="del mod">
          <ac:chgData name="Maggie Bohm" userId="571282b2550de325" providerId="LiveId" clId="{BC1CEF96-62B4-4845-980C-633C6D42E13D}" dt="2020-03-10T02:53:36.113" v="64"/>
          <ac:grpSpMkLst>
            <pc:docMk/>
            <pc:sldMk cId="3498319346" sldId="259"/>
            <ac:grpSpMk id="48" creationId="{55DCBAE3-05BC-4258-BCB3-AC5852797303}"/>
          </ac:grpSpMkLst>
        </pc:grpChg>
        <pc:grpChg chg="del mod">
          <ac:chgData name="Maggie Bohm" userId="571282b2550de325" providerId="LiveId" clId="{BC1CEF96-62B4-4845-980C-633C6D42E13D}" dt="2020-03-10T02:53:44.141" v="76"/>
          <ac:grpSpMkLst>
            <pc:docMk/>
            <pc:sldMk cId="3498319346" sldId="259"/>
            <ac:grpSpMk id="49" creationId="{E5D61118-AE10-44B1-B3ED-751B5CD48B7A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60" creationId="{7D2F6A72-B694-478D-BA58-E00F3D72BD36}"/>
          </ac:grpSpMkLst>
        </pc:grpChg>
        <pc:grpChg chg="del mod">
          <ac:chgData name="Maggie Bohm" userId="571282b2550de325" providerId="LiveId" clId="{BC1CEF96-62B4-4845-980C-633C6D42E13D}" dt="2020-03-10T02:53:44.141" v="76"/>
          <ac:grpSpMkLst>
            <pc:docMk/>
            <pc:sldMk cId="3498319346" sldId="259"/>
            <ac:grpSpMk id="72" creationId="{A340C9CB-6796-4326-9818-874786C43665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73" creationId="{7EBD1E6B-A548-493B-AB5D-38A2A6A27582}"/>
          </ac:grpSpMkLst>
        </pc:grpChg>
        <pc:grpChg chg="del mod">
          <ac:chgData name="Maggie Bohm" userId="571282b2550de325" providerId="LiveId" clId="{BC1CEF96-62B4-4845-980C-633C6D42E13D}" dt="2020-04-13T01:03:05.016" v="2785"/>
          <ac:grpSpMkLst>
            <pc:docMk/>
            <pc:sldMk cId="3498319346" sldId="259"/>
            <ac:grpSpMk id="73" creationId="{CCF8DB9E-E766-4350-84A2-1CFD37C8D0B6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76" creationId="{93F71859-3B0C-4917-A8C7-DAE7AEC42A66}"/>
          </ac:grpSpMkLst>
        </pc:grpChg>
        <pc:grpChg chg="mod">
          <ac:chgData name="Maggie Bohm" userId="571282b2550de325" providerId="LiveId" clId="{BC1CEF96-62B4-4845-980C-633C6D42E13D}" dt="2020-04-13T01:03:05.016" v="2785"/>
          <ac:grpSpMkLst>
            <pc:docMk/>
            <pc:sldMk cId="3498319346" sldId="259"/>
            <ac:grpSpMk id="95" creationId="{62DEF552-CF39-4014-A9F7-AFB14AC93CCF}"/>
          </ac:grpSpMkLst>
        </pc:grpChg>
        <pc:grpChg chg="del mod">
          <ac:chgData name="Maggie Bohm" userId="571282b2550de325" providerId="LiveId" clId="{BC1CEF96-62B4-4845-980C-633C6D42E13D}" dt="2020-03-10T02:54:02.134" v="106"/>
          <ac:grpSpMkLst>
            <pc:docMk/>
            <pc:sldMk cId="3498319346" sldId="259"/>
            <ac:grpSpMk id="95" creationId="{A39FA963-61FE-45B9-AA12-D36C3A54FB80}"/>
          </ac:grpSpMkLst>
        </pc:grpChg>
        <pc:grpChg chg="del mod">
          <ac:chgData name="Maggie Bohm" userId="571282b2550de325" providerId="LiveId" clId="{BC1CEF96-62B4-4845-980C-633C6D42E13D}" dt="2020-03-10T02:54:08.451" v="114"/>
          <ac:grpSpMkLst>
            <pc:docMk/>
            <pc:sldMk cId="3498319346" sldId="259"/>
            <ac:grpSpMk id="103" creationId="{F84D394F-AEB4-44D5-AA3F-9D93A2C56E44}"/>
          </ac:grpSpMkLst>
        </pc:grpChg>
        <pc:grpChg chg="del mod">
          <ac:chgData name="Maggie Bohm" userId="571282b2550de325" providerId="LiveId" clId="{BC1CEF96-62B4-4845-980C-633C6D42E13D}" dt="2020-03-10T02:54:11.464" v="118"/>
          <ac:grpSpMkLst>
            <pc:docMk/>
            <pc:sldMk cId="3498319346" sldId="259"/>
            <ac:grpSpMk id="111" creationId="{A21509C3-D82B-4EB7-A8EA-7EF78B25AB2B}"/>
          </ac:grpSpMkLst>
        </pc:grpChg>
        <pc:grpChg chg="del mod">
          <ac:chgData name="Maggie Bohm" userId="571282b2550de325" providerId="LiveId" clId="{BC1CEF96-62B4-4845-980C-633C6D42E13D}" dt="2020-03-10T02:54:16.942" v="126"/>
          <ac:grpSpMkLst>
            <pc:docMk/>
            <pc:sldMk cId="3498319346" sldId="259"/>
            <ac:grpSpMk id="115" creationId="{25375FDC-7228-4C66-8487-C82505F16914}"/>
          </ac:grpSpMkLst>
        </pc:grpChg>
        <pc:grpChg chg="del mod">
          <ac:chgData name="Maggie Bohm" userId="571282b2550de325" providerId="LiveId" clId="{BC1CEF96-62B4-4845-980C-633C6D42E13D}" dt="2020-03-10T02:55:00.509" v="171"/>
          <ac:grpSpMkLst>
            <pc:docMk/>
            <pc:sldMk cId="3498319346" sldId="259"/>
            <ac:grpSpMk id="123" creationId="{1E6998B5-75AD-4A62-B9D8-0F5368F45AD4}"/>
          </ac:grpSpMkLst>
        </pc:grpChg>
        <pc:grpChg chg="mod">
          <ac:chgData name="Maggie Bohm" userId="571282b2550de325" providerId="LiveId" clId="{BC1CEF96-62B4-4845-980C-633C6D42E13D}" dt="2020-04-13T01:03:10.185" v="2791"/>
          <ac:grpSpMkLst>
            <pc:docMk/>
            <pc:sldMk cId="3498319346" sldId="259"/>
            <ac:grpSpMk id="128" creationId="{3BAC373E-73A9-409C-8965-304EBEF5EC38}"/>
          </ac:grpSpMkLst>
        </pc:grpChg>
        <pc:grpChg chg="mod">
          <ac:chgData name="Maggie Bohm" userId="571282b2550de325" providerId="LiveId" clId="{BC1CEF96-62B4-4845-980C-633C6D42E13D}" dt="2020-03-10T02:54:31.882" v="134"/>
          <ac:grpSpMkLst>
            <pc:docMk/>
            <pc:sldMk cId="3498319346" sldId="259"/>
            <ac:grpSpMk id="129" creationId="{83022092-38CD-4134-99B1-883480535EEF}"/>
          </ac:grpSpMkLst>
        </pc:grpChg>
        <pc:grpChg chg="del mod">
          <ac:chgData name="Maggie Bohm" userId="571282b2550de325" providerId="LiveId" clId="{BC1CEF96-62B4-4845-980C-633C6D42E13D}" dt="2020-03-10T02:54:39.824" v="145"/>
          <ac:grpSpMkLst>
            <pc:docMk/>
            <pc:sldMk cId="3498319346" sldId="259"/>
            <ac:grpSpMk id="133" creationId="{24A086B3-8FA7-4084-A830-58638B6D3751}"/>
          </ac:grpSpMkLst>
        </pc:grpChg>
        <pc:grpChg chg="del mod">
          <ac:chgData name="Maggie Bohm" userId="571282b2550de325" providerId="LiveId" clId="{BC1CEF96-62B4-4845-980C-633C6D42E13D}" dt="2020-04-13T01:03:18.087" v="2803"/>
          <ac:grpSpMkLst>
            <pc:docMk/>
            <pc:sldMk cId="3498319346" sldId="259"/>
            <ac:grpSpMk id="139" creationId="{01FC0712-4F17-4843-A8D9-EFC5404C4996}"/>
          </ac:grpSpMkLst>
        </pc:grpChg>
        <pc:grpChg chg="del mod">
          <ac:chgData name="Maggie Bohm" userId="571282b2550de325" providerId="LiveId" clId="{BC1CEF96-62B4-4845-980C-633C6D42E13D}" dt="2020-03-10T02:54:46.907" v="156"/>
          <ac:grpSpMkLst>
            <pc:docMk/>
            <pc:sldMk cId="3498319346" sldId="259"/>
            <ac:grpSpMk id="139" creationId="{1F7CD8C7-38DC-4316-9F78-F3CEE07AE3BF}"/>
          </ac:grpSpMkLst>
        </pc:grpChg>
        <pc:grpChg chg="del mod">
          <ac:chgData name="Maggie Bohm" userId="571282b2550de325" providerId="LiveId" clId="{BC1CEF96-62B4-4845-980C-633C6D42E13D}" dt="2020-03-10T02:55:00.509" v="171"/>
          <ac:grpSpMkLst>
            <pc:docMk/>
            <pc:sldMk cId="3498319346" sldId="259"/>
            <ac:grpSpMk id="150" creationId="{38C2F051-2613-4AD6-8165-F4EC1654F36C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3498319346" sldId="259"/>
            <ac:grpSpMk id="165" creationId="{770E6B76-E7FA-4195-A71D-F61F47858C98}"/>
          </ac:grpSpMkLst>
        </pc:grpChg>
        <pc:grpChg chg="del mod">
          <ac:chgData name="Maggie Bohm" userId="571282b2550de325" providerId="LiveId" clId="{BC1CEF96-62B4-4845-980C-633C6D42E13D}" dt="2020-04-13T01:03:21.307" v="2808"/>
          <ac:grpSpMkLst>
            <pc:docMk/>
            <pc:sldMk cId="3498319346" sldId="259"/>
            <ac:grpSpMk id="173" creationId="{8F99DB8B-593B-49FB-A238-AD0C0CABD523}"/>
          </ac:grpSpMkLst>
        </pc:grpChg>
        <pc:grpChg chg="del mod">
          <ac:chgData name="Maggie Bohm" userId="571282b2550de325" providerId="LiveId" clId="{BC1CEF96-62B4-4845-980C-633C6D42E13D}" dt="2020-04-13T01:03:30.105" v="2820"/>
          <ac:grpSpMkLst>
            <pc:docMk/>
            <pc:sldMk cId="3498319346" sldId="259"/>
            <ac:grpSpMk id="178" creationId="{FACA07C0-E688-4A2A-8043-FDAAB15D99ED}"/>
          </ac:grpSpMkLst>
        </pc:grpChg>
        <pc:grpChg chg="mod">
          <ac:chgData name="Maggie Bohm" userId="571282b2550de325" providerId="LiveId" clId="{BC1CEF96-62B4-4845-980C-633C6D42E13D}" dt="2020-04-13T01:03:30.105" v="2820"/>
          <ac:grpSpMkLst>
            <pc:docMk/>
            <pc:sldMk cId="3498319346" sldId="259"/>
            <ac:grpSpMk id="190" creationId="{F0C43093-7794-44D2-B83A-74D62FEEB4BF}"/>
          </ac:grpSpMkLst>
        </pc:grp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" creationId="{A29B176B-EB29-4E7F-9306-59266574E9E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" creationId="{6C2EADCA-9278-4E27-A7D3-BE517CCE170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" creationId="{1B0B8028-0C03-4A83-B05E-738A42CD848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" creationId="{6EDFF2E1-CA38-4DC4-8717-4622D66940A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" creationId="{A4384CA9-6427-4576-B5B6-4F3DDFA45CE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" creationId="{C0A49C09-FBF4-4E23-B5C1-3E6E88F327D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" creationId="{3276C551-9A10-40C1-972A-8DA5B87DD91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" creationId="{1F86272F-974F-42A2-AE2E-0D51E1DFD11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" creationId="{FC6F5004-B70B-4733-BE70-24AC32E9D18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" creationId="{8C745CD5-6A04-43C6-83CC-3DDD3AD1A2D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" creationId="{AE291763-C427-460E-AB58-AF821418049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" creationId="{C1F820F0-EEE7-4265-8C03-BA3D2CE9AC7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" creationId="{B060771F-9938-48FD-8DB8-C085CCBB479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" creationId="{4A8F8E4C-222D-49D1-A61F-1A8DA40BA76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" creationId="{9BCA926D-7BDB-4F1B-8F6C-972A66B6CEC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7" creationId="{86FAAB31-C14D-4D64-B060-45365E19D0D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8" creationId="{99E9F9B6-CEA4-43B7-B51F-EDAC8FA3A95B}"/>
          </ac:inkMkLst>
        </pc:inkChg>
        <pc:inkChg chg="add del">
          <ac:chgData name="Maggie Bohm" userId="571282b2550de325" providerId="LiveId" clId="{BC1CEF96-62B4-4845-980C-633C6D42E13D}" dt="2020-04-13T01:02:43.062" v="2773" actId="9405"/>
          <ac:inkMkLst>
            <pc:docMk/>
            <pc:sldMk cId="3498319346" sldId="259"/>
            <ac:inkMk id="19" creationId="{1C86F0B7-DF5F-40FC-968F-D533232411AB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20" creationId="{E53EF741-B053-48D5-A8F2-C3FDDC37DB6D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1" creationId="{FE15FB29-6296-426B-9BC5-B60A19CF96F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2" creationId="{7C04557B-7668-4F04-95BE-0AD0121388C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3" creationId="{02AA0DEE-5110-40C7-929A-819F050C346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4" creationId="{F150509E-F414-448B-86A7-BB51F74DDAE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5" creationId="{33F177D8-0C58-4DBE-A666-B723C621359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6" creationId="{022C50FB-BB85-44C8-86BE-0B6294F6BF20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27" creationId="{9B573701-7AC2-4D23-AD87-3C748E6DB6E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8" creationId="{6A7DD324-D2BD-49FF-8A35-5246634FA86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29" creationId="{EDBBE37A-1194-4F27-A6D4-AEF6EA59A23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0" creationId="{F338028B-B4D9-496E-8E7E-B128086A6C05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31" creationId="{A8F0D136-88CD-4869-B315-0B39AF4A7D8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2" creationId="{3AA7F140-36E5-4F5A-B680-BEFC88EBD92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3" creationId="{4FC4FE2C-7F0B-4400-948E-76C6C791EF7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4" creationId="{014F4551-546C-45F9-837E-F68F1BC0518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5" creationId="{B77B6215-F6B9-4520-9922-0A9185D2D74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6" creationId="{70A6D850-1CBF-489E-B105-CF16A85610E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7" creationId="{2D1C2618-3B88-46B7-931E-789BF30B37E8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38" creationId="{7964EAFA-6024-4675-AD98-66F971E95ECD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39" creationId="{41A6EB68-4B2F-40C1-8E84-884C414CA6A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0" creationId="{7CB8D79A-17CD-4957-B1B3-83E7B270E897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41" creationId="{76E6ED5E-B796-42CB-9C5C-CF189F7C3D8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2" creationId="{5BEDF353-957B-4FB5-8DB1-9C6F77AF9700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3" creationId="{5B59CEDA-229D-4439-8773-EEDCD15419A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4" creationId="{48B7B4E5-6143-4B6F-8F9C-C203FB5BE32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5" creationId="{BA400DD3-ACF2-4C1E-929D-0CE788B69BA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6" creationId="{BE6F06DB-BB0C-44BD-A372-EC6DB34CA2E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47" creationId="{CCA31C92-60BF-46F5-A2ED-857176E01F8C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48" creationId="{8BF31527-25E9-40C1-86A6-D3E40F394E1E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49" creationId="{7EF1B35E-3AA6-4506-8797-FDE372E3143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0" creationId="{9E25FEE6-98AE-40EF-8681-3FBC516AB56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1" creationId="{E8130901-7F5F-44A1-832A-E2C93B7965A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2" creationId="{59FA46A4-34B5-414B-B424-2491DF85ADF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3" creationId="{E7F72EA5-B391-480C-B5DB-D2B9BC0ED14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4" creationId="{B98247AB-43FC-49CA-85D5-BED770821BB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5" creationId="{C44D6B5D-DB06-4320-A1CC-DD0E422F531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6" creationId="{F541CE4F-6AFB-453F-91D0-9FB4E7CAE93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7" creationId="{1FF34AE0-36EB-4882-8ABB-08C0350465E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8" creationId="{F38E529C-9C11-4298-9156-449F7D95E9A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59" creationId="{EA8C7D16-E2D9-45A4-8ECC-4745B6C1A838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60" creationId="{69F9EFF4-E17C-4B75-9E86-B74977EEB7E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1" creationId="{E867AFEC-910E-43B1-9B4A-D38E9ACA6C7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2" creationId="{E8309AD4-CE7A-4F11-8CFF-482F834DBBA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3" creationId="{6BAFCC05-46A6-4194-A1D6-2FF3A31B328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4" creationId="{1E2C951E-695D-455B-A3A4-F2C99ED9FBF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5" creationId="{1BF7716F-569D-4629-A12F-3ACB3780046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6" creationId="{A1F62603-95EA-4830-81AE-9C14465D82F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7" creationId="{BD1CA945-AD62-4471-9136-FC6C21FED4E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8" creationId="{7529915F-C799-4E88-A9A9-5638C17C2D8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69" creationId="{293AF643-C132-4B3E-9AD1-16CC8D4D25C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0" creationId="{0985EC36-7929-4083-9012-A2F976E0F67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1" creationId="{DFA43C47-8DF0-4881-A37C-E7D5A8992D1C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72" creationId="{C30E6C1E-7BA0-4313-82BB-8EA678E8E1E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4" creationId="{0DCFB2F8-FEAD-494E-880D-AEEBE9510DE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5" creationId="{7594D9F3-53CC-4DEC-91DC-58F7C6295B2B}"/>
          </ac:inkMkLst>
        </pc:inkChg>
        <pc:inkChg chg="add mod">
          <ac:chgData name="Maggie Bohm" userId="571282b2550de325" providerId="LiveId" clId="{BC1CEF96-62B4-4845-980C-633C6D42E13D}" dt="2020-04-13T01:03:05.016" v="2785"/>
          <ac:inkMkLst>
            <pc:docMk/>
            <pc:sldMk cId="3498319346" sldId="259"/>
            <ac:inkMk id="76" creationId="{A5C1AE69-B30E-4672-AF76-4247FB05B60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7" creationId="{8395A3A1-A900-4DA8-A061-C6A4F3AEEAA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8" creationId="{3F9E9F7C-D7D2-49C0-8641-82767B2138C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79" creationId="{F2B28B70-ADF0-4213-9EAA-D2BEC8EFAC4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0" creationId="{345055C4-CCF7-4218-AF32-E7370B2FBE5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1" creationId="{DB1B096A-F54D-4083-967B-73784A52F2B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2" creationId="{99A90AF9-1B37-486E-A1FB-B537F23687C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3" creationId="{837A68E5-67F6-4CDB-BFA1-8D0F19D41AD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4" creationId="{DE87FEAF-C16D-4415-AB5A-DB1E93DED48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5" creationId="{241864D5-FB8B-47AF-94B8-E5FDA97B600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6" creationId="{BA94F184-4615-4BD3-BF1B-14509D02AA2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7" creationId="{A9A44C14-43AB-4E12-8754-AC7C44CE6B2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8" creationId="{A2E6DAE3-6191-46F8-A5ED-3C1D0049188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89" creationId="{8BBE0145-DDA4-46B8-A3A3-5DE511D5266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0" creationId="{804BD159-02A0-43E0-BA11-C1BE64CC749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1" creationId="{8623E18E-B011-454A-A304-7C7E5B3E94A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2" creationId="{16B6939A-1002-461F-8368-B3B4E0CB339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3" creationId="{34F297D6-6496-4027-BE50-DDA39ED51FF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4" creationId="{017ACED0-8218-4DBD-83EA-6620F2CD42C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6" creationId="{B77C7C9E-730F-423A-9C5E-7BD14BF2877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7" creationId="{0DDCFC38-7A5B-418E-9782-E7272F5411B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8" creationId="{ADAA9420-C9EE-49CD-883E-90389BCBBAB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99" creationId="{9B3CA835-C6A4-45B5-8B46-5E0BAC653DB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0" creationId="{61C2A34D-6F02-4000-A00C-B65E45D1A62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1" creationId="{87DD25F4-7955-4D80-88C8-4AD94DE4666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2" creationId="{F4CBF9CD-367B-499D-B50A-9D5DE4382634}"/>
          </ac:inkMkLst>
        </pc:inkChg>
        <pc:inkChg chg="add">
          <ac:chgData name="Maggie Bohm" userId="571282b2550de325" providerId="LiveId" clId="{BC1CEF96-62B4-4845-980C-633C6D42E13D}" dt="2020-04-13T01:03:05.748" v="2786" actId="9405"/>
          <ac:inkMkLst>
            <pc:docMk/>
            <pc:sldMk cId="3498319346" sldId="259"/>
            <ac:inkMk id="103" creationId="{1254A324-A5E2-4C8D-87A9-C984CA83B3F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4" creationId="{D03D74E3-7AE1-4820-A351-14C4550C81C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5" creationId="{6D112A7A-2552-41B1-B345-64D102D7D94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6" creationId="{E02D1042-902A-42DE-A0C9-5816978F8BD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7" creationId="{8E6B0DD7-C362-4A0B-8C6D-A4511EDC9D5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8" creationId="{AC71F11D-F8A7-4E76-8A98-742A276E94B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09" creationId="{EE8F3C7B-BBD1-4140-BF88-962BA6CA143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0" creationId="{845A8659-518B-4AB0-894B-0644BF70C7EF}"/>
          </ac:inkMkLst>
        </pc:inkChg>
        <pc:inkChg chg="add mod">
          <ac:chgData name="Maggie Bohm" userId="571282b2550de325" providerId="LiveId" clId="{BC1CEF96-62B4-4845-980C-633C6D42E13D}" dt="2020-04-13T01:03:10.185" v="2791"/>
          <ac:inkMkLst>
            <pc:docMk/>
            <pc:sldMk cId="3498319346" sldId="259"/>
            <ac:inkMk id="111" creationId="{DF6758B2-DA32-4126-9642-C4D628B0569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2" creationId="{3B5E41E3-BA34-42AD-8363-78D13DE8374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3" creationId="{5D65A713-C876-48E3-A21E-348886C3E6E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4" creationId="{111E4ADE-83E9-4E92-A166-A64D68862A22}"/>
          </ac:inkMkLst>
        </pc:inkChg>
        <pc:inkChg chg="add mod">
          <ac:chgData name="Maggie Bohm" userId="571282b2550de325" providerId="LiveId" clId="{BC1CEF96-62B4-4845-980C-633C6D42E13D}" dt="2020-04-13T01:03:10.185" v="2791"/>
          <ac:inkMkLst>
            <pc:docMk/>
            <pc:sldMk cId="3498319346" sldId="259"/>
            <ac:inkMk id="115" creationId="{78324987-E2BD-4AEB-8351-ABD5EC21848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6" creationId="{CFE2B427-8CE5-4192-BCB4-64EB9378013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7" creationId="{B0A62C0E-402C-4258-B38F-4A0DF9538C1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8" creationId="{7CD98C25-2E7C-4B9F-84E6-E5B90CD6F3B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19" creationId="{6BAB8F88-385F-4FB1-A512-C0C04CD0EF9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0" creationId="{E8E98FB1-2918-408E-874F-EC3F829F3E5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1" creationId="{934091E7-D160-43C5-A894-F103D4EE140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2" creationId="{EB81BE81-6472-438A-8656-9750897EB784}"/>
          </ac:inkMkLst>
        </pc:inkChg>
        <pc:inkChg chg="add mod">
          <ac:chgData name="Maggie Bohm" userId="571282b2550de325" providerId="LiveId" clId="{BC1CEF96-62B4-4845-980C-633C6D42E13D}" dt="2020-04-13T01:03:10.185" v="2791"/>
          <ac:inkMkLst>
            <pc:docMk/>
            <pc:sldMk cId="3498319346" sldId="259"/>
            <ac:inkMk id="123" creationId="{FC1098AC-DF62-475E-BDA6-5F0E58493A2E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4" creationId="{92F7153E-D962-4F07-BD2C-2F7AA13305D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5" creationId="{E0FA651D-F242-4DC4-9979-12E0BE0E06F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26" creationId="{78AC6E53-5E0A-4867-B2CD-B5AFA8229C11}"/>
          </ac:inkMkLst>
        </pc:inkChg>
        <pc:inkChg chg="add del mod">
          <ac:chgData name="Maggie Bohm" userId="571282b2550de325" providerId="LiveId" clId="{BC1CEF96-62B4-4845-980C-633C6D42E13D}" dt="2020-03-10T02:54:32.245" v="135" actId="9405"/>
          <ac:inkMkLst>
            <pc:docMk/>
            <pc:sldMk cId="3498319346" sldId="259"/>
            <ac:inkMk id="127" creationId="{5E31741B-7A1A-48E7-9FF4-A76621F2EFC0}"/>
          </ac:inkMkLst>
        </pc:inkChg>
        <pc:inkChg chg="add mod">
          <ac:chgData name="Maggie Bohm" userId="571282b2550de325" providerId="LiveId" clId="{BC1CEF96-62B4-4845-980C-633C6D42E13D}" dt="2020-04-13T01:03:10.185" v="2791"/>
          <ac:inkMkLst>
            <pc:docMk/>
            <pc:sldMk cId="3498319346" sldId="259"/>
            <ac:inkMk id="127" creationId="{B57A2FFD-6643-4E9F-BF6A-23ED65EFDC22}"/>
          </ac:inkMkLst>
        </pc:inkChg>
        <pc:inkChg chg="add del mod">
          <ac:chgData name="Maggie Bohm" userId="571282b2550de325" providerId="LiveId" clId="{BC1CEF96-62B4-4845-980C-633C6D42E13D}" dt="2020-03-10T02:54:31.882" v="134"/>
          <ac:inkMkLst>
            <pc:docMk/>
            <pc:sldMk cId="3498319346" sldId="259"/>
            <ac:inkMk id="128" creationId="{F282DD8F-6010-4563-8BF6-4B0E8EF7F4E5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29" creationId="{7F997CAE-181D-4B11-BA25-33CA84955C6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0" creationId="{688D07C4-021D-4B58-A580-3D762A3F247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1" creationId="{F886F7E1-0315-4E58-AF71-0C23A2095E6F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2" creationId="{BECD9243-2AED-42C6-9F87-CCA3C2C9675E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33" creationId="{BE210169-47CC-43D0-A564-D15582FFD780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4" creationId="{BB7954EC-D0C7-4113-85D7-4A98446B81D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5" creationId="{8D27695E-5EF5-4C1B-92B5-F6A23D390A7C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6" creationId="{B65CA722-113B-4977-899F-9D0A53D6D69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7" creationId="{C8FCC32B-56FD-41AC-BE1D-9A9D5EE6C59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38" creationId="{C76DECCD-1B27-403B-AC86-9D74CAB1FD8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0" creationId="{4CD69CB2-8B6A-4688-AE48-5EA83947DC9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1" creationId="{F2DD02DC-A6DF-44E0-90BE-31661CFF5C32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2" creationId="{A3811D52-02D0-43F3-A96D-867BEBF9E5B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3" creationId="{6350DECA-FD9D-405B-9665-47DFB9EA40A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4" creationId="{B0B3FC9D-7F0A-4947-B5BF-2CED9D0E06F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5" creationId="{47798560-7198-4781-99F5-605042FEAEB3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6" creationId="{7118FE15-542E-474E-93E1-591922C37159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7" creationId="{3F59A8EB-0543-451B-8FD8-853ADED70CE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8" creationId="{508A526F-5B58-4683-B838-39C7A67EB42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49" creationId="{AE69FE96-3A5D-4FD6-9BED-34D0808DD48F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50" creationId="{92A6B420-04E5-473C-AB40-E7CC61182A3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1" creationId="{5222AE56-AFF5-4167-B3F4-06B86D30922D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2" creationId="{68BD74A1-0741-4BE6-82D8-D6BDF2F9BB7A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3" creationId="{294B73AF-CC1B-4AE5-9DB6-9383F0BE8D11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4" creationId="{D0E2FE92-62E5-4EA8-B070-9ACA9ECCE236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5" creationId="{46D17AB0-02FB-4602-9B2F-B17545232C57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6" creationId="{BA433F30-AFF2-4DE7-ACEE-D3A681609CB4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7" creationId="{09760C09-F077-4DF2-8314-74384EF0CFD8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8" creationId="{A8B5F05D-EEF2-41B4-9973-8EB05B559240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59" creationId="{AA15DE79-4B4A-47BA-916D-84802C1477A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0" creationId="{238649B7-E1F7-4FFE-9CF1-608326E039EB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1" creationId="{97EA3787-785D-4F79-BED6-E03BD5253C20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2" creationId="{90085B15-6046-4C7C-AD4D-9C8846AA62E0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3" creationId="{2CBA0994-4B63-4F28-8CC5-9E5399F822E5}"/>
          </ac:inkMkLst>
        </pc:inkChg>
        <pc:inkChg chg="add mod">
          <ac:chgData name="Maggie Bohm" userId="571282b2550de325" providerId="LiveId" clId="{BC1CEF96-62B4-4845-980C-633C6D42E13D}" dt="2020-03-10T02:55:00.509" v="171"/>
          <ac:inkMkLst>
            <pc:docMk/>
            <pc:sldMk cId="3498319346" sldId="259"/>
            <ac:inkMk id="164" creationId="{77E4A4EC-8C38-493C-B68D-404345854D9C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66" creationId="{0F45DB33-63E6-410F-AE7A-60DB70541140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67" creationId="{DDFE56ED-E771-46D3-952C-177F732309E4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68" creationId="{27F5374D-9DE6-423C-9C14-27063FFCBFC3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69" creationId="{998AB6C2-9295-4F47-9D58-A291AA12F07C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0" creationId="{9E20E6CA-0FB6-463E-97EF-7D8233D8640B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1" creationId="{B30BC1B3-3FEA-4649-A539-A956FB4F16B8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2" creationId="{66AE0D0B-33C5-46B2-9B2F-915CF9AEA5F6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4" creationId="{A1BBE831-F492-4044-A291-4C94C47B5F7A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5" creationId="{531DE61F-0535-4019-A0CA-8857410C42AE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6" creationId="{EAF72752-22EB-4F69-8296-2B5CF63B8B03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7" creationId="{462638D0-8B0D-4619-8E66-C6D145853606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79" creationId="{42536AA7-DCFF-449B-8395-226C78DBE5A0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0" creationId="{2A103D7E-D084-4495-BCF6-E8C3910A1EC5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1" creationId="{39809B1E-96E0-46FB-B660-8497DED76823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2" creationId="{EACB1159-010C-4FF7-AC03-5CDB76B92FBE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3" creationId="{BB0567F3-09BC-448F-B9CB-5ADE48F95F38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4" creationId="{FD3D0358-724E-4040-B419-A57AA87BE24E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5" creationId="{C5FFAF9F-3613-4B35-AF60-10233473D78A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6" creationId="{909EDFEF-9D9A-4C44-97EC-B110577F753A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7" creationId="{AE3C6D73-F814-4E28-9E67-EC34AF6F5A43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8" creationId="{736961EE-5C06-4CB4-A930-DBC970BB225A}"/>
          </ac:inkMkLst>
        </pc:inkChg>
        <pc:inkChg chg="add mod">
          <ac:chgData name="Maggie Bohm" userId="571282b2550de325" providerId="LiveId" clId="{BC1CEF96-62B4-4845-980C-633C6D42E13D}" dt="2020-04-13T01:03:30.105" v="2820"/>
          <ac:inkMkLst>
            <pc:docMk/>
            <pc:sldMk cId="3498319346" sldId="259"/>
            <ac:inkMk id="189" creationId="{9872368D-76DF-4F9A-91FB-4A1E89716248}"/>
          </ac:inkMkLst>
        </pc:inkChg>
        <pc:inkChg chg="add del">
          <ac:chgData name="Maggie Bohm" userId="571282b2550de325" providerId="LiveId" clId="{BC1CEF96-62B4-4845-980C-633C6D42E13D}" dt="2020-04-13T01:04:32.312" v="2851" actId="478"/>
          <ac:inkMkLst>
            <pc:docMk/>
            <pc:sldMk cId="3498319346" sldId="259"/>
            <ac:inkMk id="191" creationId="{F60D20DF-1D81-437A-B6A7-3D10AAED3B70}"/>
          </ac:inkMkLst>
        </pc:inkChg>
      </pc:sldChg>
      <pc:sldChg chg="addSp delSp modSp add del setBg">
        <pc:chgData name="Maggie Bohm" userId="571282b2550de325" providerId="LiveId" clId="{BC1CEF96-62B4-4845-980C-633C6D42E13D}" dt="2020-04-15T19:13:28.691" v="3352" actId="47"/>
        <pc:sldMkLst>
          <pc:docMk/>
          <pc:sldMk cId="648636852" sldId="260"/>
        </pc:sldMkLst>
        <pc:spChg chg="add mod">
          <ac:chgData name="Maggie Bohm" userId="571282b2550de325" providerId="LiveId" clId="{BC1CEF96-62B4-4845-980C-633C6D42E13D}" dt="2020-04-02T15:04:03.602" v="671"/>
          <ac:spMkLst>
            <pc:docMk/>
            <pc:sldMk cId="648636852" sldId="260"/>
            <ac:spMk id="2" creationId="{E03AFE43-F914-42D5-9219-83EADA64D921}"/>
          </ac:spMkLst>
        </pc:spChg>
        <pc:spChg chg="add mod">
          <ac:chgData name="Maggie Bohm" userId="571282b2550de325" providerId="LiveId" clId="{BC1CEF96-62B4-4845-980C-633C6D42E13D}" dt="2020-04-02T15:04:03.602" v="671"/>
          <ac:spMkLst>
            <pc:docMk/>
            <pc:sldMk cId="648636852" sldId="260"/>
            <ac:spMk id="3" creationId="{44BC0B54-6AD4-4E0C-9497-25987B1F5A21}"/>
          </ac:spMkLst>
        </pc:spChg>
        <pc:spChg chg="add mod">
          <ac:chgData name="Maggie Bohm" userId="571282b2550de325" providerId="LiveId" clId="{BC1CEF96-62B4-4845-980C-633C6D42E13D}" dt="2020-04-02T15:04:03.602" v="671"/>
          <ac:spMkLst>
            <pc:docMk/>
            <pc:sldMk cId="648636852" sldId="260"/>
            <ac:spMk id="4" creationId="{DC538BA7-931B-49E2-8D5B-70E663911DCC}"/>
          </ac:spMkLst>
        </pc:spChg>
        <pc:spChg chg="add mod">
          <ac:chgData name="Maggie Bohm" userId="571282b2550de325" providerId="LiveId" clId="{BC1CEF96-62B4-4845-980C-633C6D42E13D}" dt="2020-04-02T15:04:03.602" v="671"/>
          <ac:spMkLst>
            <pc:docMk/>
            <pc:sldMk cId="648636852" sldId="260"/>
            <ac:spMk id="5" creationId="{5C92703C-7157-4994-BDAC-B1692F7D0335}"/>
          </ac:spMkLst>
        </pc:spChg>
        <pc:spChg chg="add del mod">
          <ac:chgData name="Maggie Bohm" userId="571282b2550de325" providerId="LiveId" clId="{BC1CEF96-62B4-4845-980C-633C6D42E13D}" dt="2020-03-10T03:00:03.877" v="280" actId="478"/>
          <ac:spMkLst>
            <pc:docMk/>
            <pc:sldMk cId="648636852" sldId="260"/>
            <ac:spMk id="55" creationId="{23C9031C-9E63-4EEA-A4EB-E17D2FB8CDB0}"/>
          </ac:spMkLst>
        </pc:spChg>
        <pc:grpChg chg="del mod">
          <ac:chgData name="Maggie Bohm" userId="571282b2550de325" providerId="LiveId" clId="{BC1CEF96-62B4-4845-980C-633C6D42E13D}" dt="2020-03-10T02:58:48.402" v="226"/>
          <ac:grpSpMkLst>
            <pc:docMk/>
            <pc:sldMk cId="648636852" sldId="260"/>
            <ac:grpSpMk id="10" creationId="{0D570A33-F88A-41BF-B42C-A43296A27532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19" creationId="{5D84BC74-52B8-4090-8509-41634144B32E}"/>
          </ac:grpSpMkLst>
        </pc:grpChg>
        <pc:grpChg chg="del mod">
          <ac:chgData name="Maggie Bohm" userId="571282b2550de325" providerId="LiveId" clId="{BC1CEF96-62B4-4845-980C-633C6D42E13D}" dt="2020-03-10T02:58:57.808" v="238"/>
          <ac:grpSpMkLst>
            <pc:docMk/>
            <pc:sldMk cId="648636852" sldId="260"/>
            <ac:grpSpMk id="22" creationId="{DE77749C-9864-45C3-87F2-A0E402A72627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31" creationId="{4EF90312-CB10-42C6-A1B0-A6363085BA0D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45" creationId="{42A2BB67-D2F1-426E-B8FE-E53C72EE753C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53" creationId="{ED3CF1EA-D14D-452C-BB62-0B464EEE6764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54" creationId="{46F027E5-5F5C-41E6-B998-9C4206617B81}"/>
          </ac:grpSpMkLst>
        </pc:grpChg>
        <pc:grpChg chg="add del mod">
          <ac:chgData name="Maggie Bohm" userId="571282b2550de325" providerId="LiveId" clId="{BC1CEF96-62B4-4845-980C-633C6D42E13D}" dt="2020-04-13T01:03:54.604" v="2835"/>
          <ac:grpSpMkLst>
            <pc:docMk/>
            <pc:sldMk cId="648636852" sldId="260"/>
            <ac:grpSpMk id="58" creationId="{65D7841E-04C9-45E8-A1C5-9EE3682062D3}"/>
          </ac:grpSpMkLst>
        </pc:grpChg>
        <pc:grpChg chg="mod">
          <ac:chgData name="Maggie Bohm" userId="571282b2550de325" providerId="LiveId" clId="{BC1CEF96-62B4-4845-980C-633C6D42E13D}" dt="2020-04-13T01:03:53.616" v="2832"/>
          <ac:grpSpMkLst>
            <pc:docMk/>
            <pc:sldMk cId="648636852" sldId="260"/>
            <ac:grpSpMk id="61" creationId="{3C21196F-69C6-4C6C-A276-3BBB8FF231F6}"/>
          </ac:grpSpMkLst>
        </pc:grpChg>
        <pc:grpChg chg="del mod">
          <ac:chgData name="Maggie Bohm" userId="571282b2550de325" providerId="LiveId" clId="{BC1CEF96-62B4-4845-980C-633C6D42E13D}" dt="2020-03-10T03:00:02.332" v="279" actId="478"/>
          <ac:grpSpMkLst>
            <pc:docMk/>
            <pc:sldMk cId="648636852" sldId="260"/>
            <ac:grpSpMk id="66" creationId="{9BE5F0F6-F167-4101-8A80-42EF892452AA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69" creationId="{6AE674CD-2432-4AAC-A50A-4ECCDF23C133}"/>
          </ac:grpSpMkLst>
        </pc:grpChg>
        <pc:grpChg chg="del mod">
          <ac:chgData name="Maggie Bohm" userId="571282b2550de325" providerId="LiveId" clId="{BC1CEF96-62B4-4845-980C-633C6D42E13D}" dt="2020-04-13T01:04:10.089" v="2849"/>
          <ac:grpSpMkLst>
            <pc:docMk/>
            <pc:sldMk cId="648636852" sldId="260"/>
            <ac:grpSpMk id="73" creationId="{5B05B68A-4862-4B85-A99C-1DE2E7C151A1}"/>
          </ac:grpSpMkLst>
        </pc:grpChg>
        <pc:grpChg chg="del mod">
          <ac:chgData name="Maggie Bohm" userId="571282b2550de325" providerId="LiveId" clId="{BC1CEF96-62B4-4845-980C-633C6D42E13D}" dt="2020-03-10T03:00:47.225" v="306"/>
          <ac:grpSpMkLst>
            <pc:docMk/>
            <pc:sldMk cId="648636852" sldId="260"/>
            <ac:grpSpMk id="73" creationId="{D7AA8C0D-6ADC-4F0C-A90F-B83A2839B040}"/>
          </ac:grpSpMkLst>
        </pc:grpChg>
        <pc:grpChg chg="del mod">
          <ac:chgData name="Maggie Bohm" userId="571282b2550de325" providerId="LiveId" clId="{BC1CEF96-62B4-4845-980C-633C6D42E13D}" dt="2020-03-10T03:00:47.225" v="306"/>
          <ac:grpSpMkLst>
            <pc:docMk/>
            <pc:sldMk cId="648636852" sldId="260"/>
            <ac:grpSpMk id="80" creationId="{73A13209-EB85-4659-AE8C-74388769E997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648636852" sldId="260"/>
            <ac:grpSpMk id="89" creationId="{E214772E-545F-4545-A5FA-3E27D37F87C0}"/>
          </ac:grpSpMkLst>
        </pc:grpChg>
        <pc:grpChg chg="mod">
          <ac:chgData name="Maggie Bohm" userId="571282b2550de325" providerId="LiveId" clId="{BC1CEF96-62B4-4845-980C-633C6D42E13D}" dt="2020-04-13T01:04:10.089" v="2849"/>
          <ac:grpSpMkLst>
            <pc:docMk/>
            <pc:sldMk cId="648636852" sldId="260"/>
            <ac:grpSpMk id="96" creationId="{5C288F30-6CC4-4B10-AC68-D410E0E109A5}"/>
          </ac:grpSpMkLst>
        </pc:grpChg>
        <pc:inkChg chg="add del">
          <ac:chgData name="Maggie Bohm" userId="571282b2550de325" providerId="LiveId" clId="{BC1CEF96-62B4-4845-980C-633C6D42E13D}" dt="2020-03-10T02:56:44.822" v="188" actId="9405"/>
          <ac:inkMkLst>
            <pc:docMk/>
            <pc:sldMk cId="648636852" sldId="260"/>
            <ac:inkMk id="6" creationId="{372CBB78-4C3B-43EF-904F-8ADF490A9FB9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" creationId="{D816A76D-7E08-436F-BDEB-A304DB9427F8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7" creationId="{58704499-F449-4262-95B2-5F6EA3C51BDC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8" creationId="{D7C9790C-94D3-4441-BD90-8326D78CF37E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9" creationId="{4B1C2C73-B92B-4874-9F50-A204994D6C4C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10" creationId="{93A1FC66-D955-40DE-87EA-A49B373327EC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1" creationId="{1034A287-7EE2-4B8B-AFBC-63A83B42A1B5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2" creationId="{71AB0115-711F-41BD-843A-67ABE807326E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3" creationId="{46AECF84-13F5-4CB7-B8AB-03ABCE68D369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4" creationId="{22590BE9-5E96-4762-B91B-F97D555AC3A3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5" creationId="{F19A1EFC-6016-48CA-871C-016F0591F326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6" creationId="{D2E01CD0-79D3-418A-ADC7-B7950D4EAB08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7" creationId="{1F0D1C41-C8A9-4FF4-BAE4-0EDE467BB514}"/>
          </ac:inkMkLst>
        </pc:inkChg>
        <pc:inkChg chg="add mod">
          <ac:chgData name="Maggie Bohm" userId="571282b2550de325" providerId="LiveId" clId="{BC1CEF96-62B4-4845-980C-633C6D42E13D}" dt="2020-03-10T02:58:48.402" v="226"/>
          <ac:inkMkLst>
            <pc:docMk/>
            <pc:sldMk cId="648636852" sldId="260"/>
            <ac:inkMk id="18" creationId="{39191FAB-CE9A-433C-A580-4B985B810F31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0" creationId="{51089999-C631-4832-AE36-E2E68D05E379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1" creationId="{7FFB6E9B-7B68-4D3F-B133-CA6BBB22E7C8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22" creationId="{FBDE71EF-9384-4B51-A4C4-0F268DAECB91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3" creationId="{C12E0BBB-E87D-48AB-8004-93B39C5C7089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4" creationId="{78CB0649-5778-4A27-81ED-404DE6B6E628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5" creationId="{EE582550-D163-4108-9869-1D5016D973F6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6" creationId="{004BB612-ED6C-4914-818B-DF76E0AC2E3C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7" creationId="{B66A3D73-951E-4A0A-B426-DEB6DC2EAB73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8" creationId="{F00F521D-6A55-4F64-88ED-B7CE635C6B1F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29" creationId="{26963655-F016-44C0-8757-D4E19ADC7F03}"/>
          </ac:inkMkLst>
        </pc:inkChg>
        <pc:inkChg chg="add mod">
          <ac:chgData name="Maggie Bohm" userId="571282b2550de325" providerId="LiveId" clId="{BC1CEF96-62B4-4845-980C-633C6D42E13D}" dt="2020-03-10T02:58:57.808" v="238"/>
          <ac:inkMkLst>
            <pc:docMk/>
            <pc:sldMk cId="648636852" sldId="260"/>
            <ac:inkMk id="30" creationId="{80199283-1EA8-4117-97A8-0573AC408489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2" creationId="{523E3CCE-5B6F-4096-826C-A68D0B851D5E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3" creationId="{2FAF0D96-4C48-419B-937F-3E93EE45870F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4" creationId="{A2D6995B-32A1-4ECA-9041-71B6B2BB044E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5" creationId="{4F7133F7-28AF-4BC8-8384-DC80F6A9FFB0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6" creationId="{35643CEC-8767-4586-9323-111911F56BEE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7" creationId="{5E8F07F0-0022-4F10-B242-9D61DF900EDD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8" creationId="{969B49E4-5AFD-4727-9721-329F22B81B39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39" creationId="{5A7C3A45-718A-42F8-ABB5-E8BA7AA8FE52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40" creationId="{64B06777-55C0-48F0-B335-0BF249B7A4D2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41" creationId="{B6FFD104-CA1A-4B10-9007-A14762D56E09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42" creationId="{70714E1E-F6C9-4D44-B991-EAC98A9E22DA}"/>
          </ac:inkMkLst>
        </pc:inkChg>
        <pc:inkChg chg="add mod">
          <ac:chgData name="Maggie Bohm" userId="571282b2550de325" providerId="LiveId" clId="{BC1CEF96-62B4-4845-980C-633C6D42E13D}" dt="2020-03-10T02:59:07.729" v="252"/>
          <ac:inkMkLst>
            <pc:docMk/>
            <pc:sldMk cId="648636852" sldId="260"/>
            <ac:inkMk id="43" creationId="{72C3A4A7-68D9-45B4-AB05-13D884F8167A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44" creationId="{CAE67941-097D-482F-867C-746E9119C05B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46" creationId="{821CC3C3-7EC6-4312-AE45-F21406833049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47" creationId="{1A4C0025-1967-4540-A1C7-0963876CCC4C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48" creationId="{3B6CD742-5D3A-4643-BA09-F0C43EBC45A7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49" creationId="{F49E1122-BA5C-4D53-9E7B-D846B776CE17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50" creationId="{31150ECF-0592-4A73-8C98-FB137F7549BE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51" creationId="{879FC50B-92A2-457F-8CB2-E6CCEE49457C}"/>
          </ac:inkMkLst>
        </pc:inkChg>
        <pc:inkChg chg="add mod">
          <ac:chgData name="Maggie Bohm" userId="571282b2550de325" providerId="LiveId" clId="{BC1CEF96-62B4-4845-980C-633C6D42E13D}" dt="2020-03-10T02:59:10.767" v="260"/>
          <ac:inkMkLst>
            <pc:docMk/>
            <pc:sldMk cId="648636852" sldId="260"/>
            <ac:inkMk id="52" creationId="{B0F0679B-E67F-4137-9517-636BAAB633F5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55" creationId="{3E6BEAFB-9424-4A64-88AE-4CAFDC587BC5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56" creationId="{070B8D16-E9F5-4D8F-A357-3F1DC0A928F9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56" creationId="{716DF1C5-0783-43E4-BDE1-26632C93A4D5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57" creationId="{C5774653-E05D-4E77-8EB7-91A1D4999A19}"/>
          </ac:inkMkLst>
        </pc:inkChg>
        <pc:inkChg chg="add del mod">
          <ac:chgData name="Maggie Bohm" userId="571282b2550de325" providerId="LiveId" clId="{BC1CEF96-62B4-4845-980C-633C6D42E13D}" dt="2020-04-13T01:03:54.604" v="2835"/>
          <ac:inkMkLst>
            <pc:docMk/>
            <pc:sldMk cId="648636852" sldId="260"/>
            <ac:inkMk id="57" creationId="{F7CF0A87-FE74-42CC-A08E-ACD3078147FB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58" creationId="{D716B7A7-CCD5-4B08-A4CD-8E450DF3BF62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59" creationId="{553EC5A7-222D-4D7F-B426-E54A90526E7F}"/>
          </ac:inkMkLst>
        </pc:inkChg>
        <pc:inkChg chg="add del mod">
          <ac:chgData name="Maggie Bohm" userId="571282b2550de325" providerId="LiveId" clId="{BC1CEF96-62B4-4845-980C-633C6D42E13D}" dt="2020-04-13T01:03:54.154" v="2833" actId="9405"/>
          <ac:inkMkLst>
            <pc:docMk/>
            <pc:sldMk cId="648636852" sldId="260"/>
            <ac:inkMk id="59" creationId="{C1174E2D-AD0C-4761-AF7D-835CF5112C1B}"/>
          </ac:inkMkLst>
        </pc:inkChg>
        <pc:inkChg chg="add del mod">
          <ac:chgData name="Maggie Bohm" userId="571282b2550de325" providerId="LiveId" clId="{BC1CEF96-62B4-4845-980C-633C6D42E13D}" dt="2020-04-13T01:03:53.616" v="2832"/>
          <ac:inkMkLst>
            <pc:docMk/>
            <pc:sldMk cId="648636852" sldId="260"/>
            <ac:inkMk id="60" creationId="{1ACDED70-B7C7-400C-88CE-2E9CCFEBDD81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0" creationId="{EE4CD2E0-B01F-48E6-AF2E-9381ABFAE035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1" creationId="{5732B9E7-A525-417E-BE93-A9D9F52CCBF6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2" creationId="{53DD8AE6-B558-4990-B58D-A41027325339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2" creationId="{B3B67664-F914-4F26-A5FD-49493200E0B5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3" creationId="{0395C393-C7D7-4F46-93BA-63AC7B6E9A7F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3" creationId="{7698F19F-6F28-47D5-8763-0C3E603C249C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4" creationId="{A095CED9-EC14-4512-AE98-742450D69D6D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4" creationId="{FB333FCA-FEDE-4A6C-9A5F-1D19C4FFA101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5" creationId="{4ED3D1CF-6AA2-4988-A437-42CD8EC2CD60}"/>
          </ac:inkMkLst>
        </pc:inkChg>
        <pc:inkChg chg="add mod">
          <ac:chgData name="Maggie Bohm" userId="571282b2550de325" providerId="LiveId" clId="{BC1CEF96-62B4-4845-980C-633C6D42E13D}" dt="2020-03-10T02:59:57.351" v="278"/>
          <ac:inkMkLst>
            <pc:docMk/>
            <pc:sldMk cId="648636852" sldId="260"/>
            <ac:inkMk id="65" creationId="{D9BCF22B-E1DF-46DF-9B0C-D56FC0E5A045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66" creationId="{D870168A-496F-4CF0-9538-C23601A193EE}"/>
          </ac:inkMkLst>
        </pc:inkChg>
        <pc:inkChg chg="add mod">
          <ac:chgData name="Maggie Bohm" userId="571282b2550de325" providerId="LiveId" clId="{BC1CEF96-62B4-4845-980C-633C6D42E13D}" dt="2020-03-10T03:00:22.217" v="286"/>
          <ac:inkMkLst>
            <pc:docMk/>
            <pc:sldMk cId="648636852" sldId="260"/>
            <ac:inkMk id="67" creationId="{34D6E032-CCA6-477E-80EE-B1408CF2945F}"/>
          </ac:inkMkLst>
        </pc:inkChg>
        <pc:inkChg chg="add mod">
          <ac:chgData name="Maggie Bohm" userId="571282b2550de325" providerId="LiveId" clId="{BC1CEF96-62B4-4845-980C-633C6D42E13D}" dt="2020-03-10T03:00:22.217" v="286"/>
          <ac:inkMkLst>
            <pc:docMk/>
            <pc:sldMk cId="648636852" sldId="260"/>
            <ac:inkMk id="68" creationId="{E46DC73D-6375-495F-8EEC-AC6F1AB15B2A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0" creationId="{0C771A69-AB75-4EAE-8108-324C6722D3D2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1" creationId="{077AD23F-0C68-41C1-9686-CB9934C17EBC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2" creationId="{77B36F3E-93E1-49D9-9C6E-1CD5F5634E27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4" creationId="{14274D9D-E52C-4650-8DBC-1CD308C1D9CB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5" creationId="{88C9E17D-B092-4EBB-A9A6-95CDC004B86C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6" creationId="{9C0AD60A-8FE6-4223-9334-4BDE2B063199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7" creationId="{310549EB-852A-4B5D-968E-D96C7C613024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8" creationId="{0B84CA5C-B697-400A-9A37-76F719A87934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79" creationId="{CDBA3161-91CC-4BDC-BC35-6ED4FB215A82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80" creationId="{3870D995-C294-4EBE-B72D-60716679097C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1" creationId="{94A3DEAC-9DA2-4D78-973E-27E70955C81F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2" creationId="{EC5576FD-0AD8-4C86-B34B-56D3E2F63DD5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3" creationId="{48F9C776-11D3-4B21-9B58-217AC814CD2D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4" creationId="{81787CAD-DDE1-47B3-8EA8-ED85453C3621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5" creationId="{69F506E8-FF3E-4167-B090-0AAFEDB2EEA6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6" creationId="{B4826B53-C030-4933-817F-3E567ED1ECD3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7" creationId="{C939FBE5-2FAF-4FB1-B8EA-5CB51C0F89FE}"/>
          </ac:inkMkLst>
        </pc:inkChg>
        <pc:inkChg chg="add mod">
          <ac:chgData name="Maggie Bohm" userId="571282b2550de325" providerId="LiveId" clId="{BC1CEF96-62B4-4845-980C-633C6D42E13D}" dt="2020-03-10T03:00:47.225" v="306"/>
          <ac:inkMkLst>
            <pc:docMk/>
            <pc:sldMk cId="648636852" sldId="260"/>
            <ac:inkMk id="88" creationId="{66ACDA57-65D5-4D1C-821E-8DF9B5AE33F0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0" creationId="{42440907-22EF-43DE-B0BF-1BCC292B7F10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1" creationId="{49464C9C-8B5C-459F-B502-419CB4472836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2" creationId="{6AF14A15-5567-42F1-8272-D3E29DE2CC6C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3" creationId="{58EAA286-BC4C-486B-B2DD-5896292CCDA6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4" creationId="{B3D0F4AC-8614-46B8-97AA-013EEEAC15FF}"/>
          </ac:inkMkLst>
        </pc:inkChg>
        <pc:inkChg chg="add mod">
          <ac:chgData name="Maggie Bohm" userId="571282b2550de325" providerId="LiveId" clId="{BC1CEF96-62B4-4845-980C-633C6D42E13D}" dt="2020-04-13T01:04:10.089" v="2849"/>
          <ac:inkMkLst>
            <pc:docMk/>
            <pc:sldMk cId="648636852" sldId="260"/>
            <ac:inkMk id="95" creationId="{A7A095E7-064C-4F42-B6B8-7F680B9B7AA1}"/>
          </ac:inkMkLst>
        </pc:inkChg>
      </pc:sldChg>
      <pc:sldChg chg="addSp delSp modSp add del ord">
        <pc:chgData name="Maggie Bohm" userId="571282b2550de325" providerId="LiveId" clId="{BC1CEF96-62B4-4845-980C-633C6D42E13D}" dt="2020-04-20T21:49:20.992" v="6523" actId="47"/>
        <pc:sldMkLst>
          <pc:docMk/>
          <pc:sldMk cId="2676126470" sldId="261"/>
        </pc:sldMkLst>
        <pc:grpChg chg="del mod">
          <ac:chgData name="Maggie Bohm" userId="571282b2550de325" providerId="LiveId" clId="{BC1CEF96-62B4-4845-980C-633C6D42E13D}" dt="2020-03-10T03:01:39.905" v="332"/>
          <ac:grpSpMkLst>
            <pc:docMk/>
            <pc:sldMk cId="2676126470" sldId="261"/>
            <ac:grpSpMk id="9" creationId="{C3D22009-BB26-47FD-AC34-FCBE52FDF565}"/>
          </ac:grpSpMkLst>
        </pc:grpChg>
        <pc:grpChg chg="add del mod">
          <ac:chgData name="Maggie Bohm" userId="571282b2550de325" providerId="LiveId" clId="{BC1CEF96-62B4-4845-980C-633C6D42E13D}" dt="2020-03-10T03:02:06.018" v="338"/>
          <ac:grpSpMkLst>
            <pc:docMk/>
            <pc:sldMk cId="2676126470" sldId="261"/>
            <ac:grpSpMk id="11" creationId="{8AC266AB-F7C0-431F-A8CD-1D8A78AA9FDD}"/>
          </ac:grpSpMkLst>
        </pc:grpChg>
        <pc:grpChg chg="mod">
          <ac:chgData name="Maggie Bohm" userId="571282b2550de325" providerId="LiveId" clId="{BC1CEF96-62B4-4845-980C-633C6D42E13D}" dt="2020-03-10T03:02:03.001" v="336"/>
          <ac:grpSpMkLst>
            <pc:docMk/>
            <pc:sldMk cId="2676126470" sldId="261"/>
            <ac:grpSpMk id="13" creationId="{B5B27CB5-98A6-448A-8FBF-E21CC26B5D6B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2676126470" sldId="261"/>
            <ac:grpSpMk id="15" creationId="{707866C8-361E-486B-96FB-7773DA0447F5}"/>
          </ac:grpSpMkLst>
        </pc:grpChg>
        <pc:inkChg chg="add del">
          <ac:chgData name="Maggie Bohm" userId="571282b2550de325" providerId="LiveId" clId="{BC1CEF96-62B4-4845-980C-633C6D42E13D}" dt="2020-03-10T03:01:28.952" v="323" actId="9405"/>
          <ac:inkMkLst>
            <pc:docMk/>
            <pc:sldMk cId="2676126470" sldId="261"/>
            <ac:inkMk id="2" creationId="{4C379BE0-33BF-4704-8705-5B09F4365753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3" creationId="{28DEFAC2-A421-41B5-AD3A-142CA5847DCD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4" creationId="{383F263E-D03C-46DC-A89A-6B3D4054FC3A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5" creationId="{21036EBE-6FA2-4B20-B098-1CE39FDA5DFD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6" creationId="{D8DC89B5-9DD7-48E4-998A-CA06D9448EBC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7" creationId="{66A70B50-1D5B-49CB-9DCB-5B1DEC5A7C6E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8" creationId="{C8576952-000A-4AAB-AF60-563BE05BF4C3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10" creationId="{D43E1AA4-7C4E-41C8-AA88-2B32F3D28927}"/>
          </ac:inkMkLst>
        </pc:inkChg>
        <pc:inkChg chg="add del mod">
          <ac:chgData name="Maggie Bohm" userId="571282b2550de325" providerId="LiveId" clId="{BC1CEF96-62B4-4845-980C-633C6D42E13D}" dt="2020-03-10T03:02:03.001" v="336"/>
          <ac:inkMkLst>
            <pc:docMk/>
            <pc:sldMk cId="2676126470" sldId="261"/>
            <ac:inkMk id="12" creationId="{7F8C16A5-0870-4F1D-ACED-23EF9E79E8BB}"/>
          </ac:inkMkLst>
        </pc:inkChg>
        <pc:inkChg chg="add mod">
          <ac:chgData name="Maggie Bohm" userId="571282b2550de325" providerId="LiveId" clId="{BC1CEF96-62B4-4845-980C-633C6D42E13D}" dt="2020-03-10T03:02:06.018" v="338"/>
          <ac:inkMkLst>
            <pc:docMk/>
            <pc:sldMk cId="2676126470" sldId="261"/>
            <ac:inkMk id="14" creationId="{BC0A6D15-6363-44F2-A157-73011CD1260A}"/>
          </ac:inkMkLst>
        </pc:inkChg>
      </pc:sldChg>
      <pc:sldChg chg="addSp delSp modSp add del ord">
        <pc:chgData name="Maggie Bohm" userId="571282b2550de325" providerId="LiveId" clId="{BC1CEF96-62B4-4845-980C-633C6D42E13D}" dt="2020-04-08T13:29:12.964" v="2702" actId="47"/>
        <pc:sldMkLst>
          <pc:docMk/>
          <pc:sldMk cId="449994019" sldId="262"/>
        </pc:sldMkLst>
        <pc:grpChg chg="del mod">
          <ac:chgData name="Maggie Bohm" userId="571282b2550de325" providerId="LiveId" clId="{BC1CEF96-62B4-4845-980C-633C6D42E13D}" dt="2020-03-10T03:03:46.366" v="381"/>
          <ac:grpSpMkLst>
            <pc:docMk/>
            <pc:sldMk cId="449994019" sldId="262"/>
            <ac:grpSpMk id="11" creationId="{B4CFFA64-8EF6-42AE-A2F2-FBC50E0251D0}"/>
          </ac:grpSpMkLst>
        </pc:grpChg>
        <pc:grpChg chg="del mod">
          <ac:chgData name="Maggie Bohm" userId="571282b2550de325" providerId="LiveId" clId="{BC1CEF96-62B4-4845-980C-633C6D42E13D}" dt="2020-03-10T03:03:51.416" v="385"/>
          <ac:grpSpMkLst>
            <pc:docMk/>
            <pc:sldMk cId="449994019" sldId="262"/>
            <ac:grpSpMk id="21" creationId="{453D6A85-EB70-42D6-B40B-A2B3C110B9B0}"/>
          </ac:grpSpMkLst>
        </pc:grpChg>
        <pc:grpChg chg="del mod">
          <ac:chgData name="Maggie Bohm" userId="571282b2550de325" providerId="LiveId" clId="{BC1CEF96-62B4-4845-980C-633C6D42E13D}" dt="2020-03-10T03:03:51.416" v="385"/>
          <ac:grpSpMkLst>
            <pc:docMk/>
            <pc:sldMk cId="449994019" sldId="262"/>
            <ac:grpSpMk id="22" creationId="{C68E4BC5-6A98-405E-90D2-6F915E166992}"/>
          </ac:grpSpMkLst>
        </pc:grpChg>
        <pc:grpChg chg="del mod">
          <ac:chgData name="Maggie Bohm" userId="571282b2550de325" providerId="LiveId" clId="{BC1CEF96-62B4-4845-980C-633C6D42E13D}" dt="2020-03-10T03:03:59.074" v="389"/>
          <ac:grpSpMkLst>
            <pc:docMk/>
            <pc:sldMk cId="449994019" sldId="262"/>
            <ac:grpSpMk id="26" creationId="{2A5B8BA0-8FEF-4ED3-B1BE-5803DB5C3D83}"/>
          </ac:grpSpMkLst>
        </pc:grpChg>
        <pc:grpChg chg="del mod">
          <ac:chgData name="Maggie Bohm" userId="571282b2550de325" providerId="LiveId" clId="{BC1CEF96-62B4-4845-980C-633C6D42E13D}" dt="2020-03-10T03:04:02.338" v="392"/>
          <ac:grpSpMkLst>
            <pc:docMk/>
            <pc:sldMk cId="449994019" sldId="262"/>
            <ac:grpSpMk id="30" creationId="{4642A5D1-7438-44E4-A133-F425369B11EC}"/>
          </ac:grpSpMkLst>
        </pc:grpChg>
        <pc:grpChg chg="del mod">
          <ac:chgData name="Maggie Bohm" userId="571282b2550de325" providerId="LiveId" clId="{BC1CEF96-62B4-4845-980C-633C6D42E13D}" dt="2020-03-10T03:04:03.434" v="394"/>
          <ac:grpSpMkLst>
            <pc:docMk/>
            <pc:sldMk cId="449994019" sldId="262"/>
            <ac:grpSpMk id="33" creationId="{75F1554C-2E85-47EB-89E8-F3DFE36DCAB3}"/>
          </ac:grpSpMkLst>
        </pc:grpChg>
        <pc:grpChg chg="mod">
          <ac:chgData name="Maggie Bohm" userId="571282b2550de325" providerId="LiveId" clId="{BC1CEF96-62B4-4845-980C-633C6D42E13D}" dt="2020-04-02T15:04:03.602" v="671"/>
          <ac:grpSpMkLst>
            <pc:docMk/>
            <pc:sldMk cId="449994019" sldId="262"/>
            <ac:grpSpMk id="35" creationId="{C991976C-C616-4849-8788-CDF2FE89CFD4}"/>
          </ac:grpSpMkLst>
        </pc:grp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" creationId="{B7314065-1B5A-4FA0-9EB5-135C5A5F39F4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3" creationId="{DB456C27-297F-4717-8383-DABCEF7F6305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4" creationId="{D845CF2B-84E5-4968-8F75-3E500FD856D5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5" creationId="{90C034FB-1BAE-4F2A-9C41-ABD4C609D79C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6" creationId="{555C06F9-195C-4934-B111-6591D1066C79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7" creationId="{B9C0EA7A-B560-4E44-867A-EE3C16D193DC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8" creationId="{E639068F-5FCD-41B8-A8A6-D2EAFFFEB962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9" creationId="{1C7C3036-4EE5-4557-83FF-D2A3D82A1D80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0" creationId="{CA7174AC-E970-4730-8669-C5F21475B4FE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2" creationId="{10BDAF32-78F1-4BD0-B4B4-6418EDA1239D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3" creationId="{A916104B-658D-49F8-B3FB-F0052A77F497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4" creationId="{F7CE4EF6-DF2A-4DBD-A853-40606E785907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5" creationId="{E6D03944-E75E-4CC6-BF50-685F78756CD4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6" creationId="{FE799CF5-F5CB-4EDC-8720-1430F2DC068F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7" creationId="{83BD7BCF-090E-40D3-AEA5-4B5751E7EFBE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8" creationId="{2105EE45-7021-425B-88F0-BE8C5BD18CB8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19" creationId="{C3C2BDFC-4F0C-4A8F-8049-79481C5111BF}"/>
          </ac:inkMkLst>
        </pc:inkChg>
        <pc:inkChg chg="add mod">
          <ac:chgData name="Maggie Bohm" userId="571282b2550de325" providerId="LiveId" clId="{BC1CEF96-62B4-4845-980C-633C6D42E13D}" dt="2020-04-02T15:04:03.602" v="671"/>
          <ac:inkMkLst>
            <pc:docMk/>
            <pc:sldMk cId="449994019" sldId="262"/>
            <ac:inkMk id="20" creationId="{2D0D472C-8743-48D0-B215-52E8FCD93C82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3" creationId="{4666DC07-70C4-414B-9256-DA0B8A1378DA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4" creationId="{72AE9642-241D-4869-A9D8-52B80F9EFF8F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5" creationId="{1B3913F7-61CA-47BD-BAD5-3E21CA3CAABC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7" creationId="{E81994BC-2524-4076-9537-DEDC7EA90316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8" creationId="{CC1ECC35-DF0D-4DBD-9C64-426B31DBD734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29" creationId="{F09CA244-C07B-42D5-8BDA-E287F43E5475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31" creationId="{A42904D1-1D7D-4793-A51C-BBC92A0F4489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32" creationId="{4504A5D8-F62B-4967-984E-25EB8B6D423B}"/>
          </ac:inkMkLst>
        </pc:inkChg>
        <pc:inkChg chg="add mod">
          <ac:chgData name="Maggie Bohm" userId="571282b2550de325" providerId="LiveId" clId="{BC1CEF96-62B4-4845-980C-633C6D42E13D}" dt="2020-03-10T03:04:03.434" v="394"/>
          <ac:inkMkLst>
            <pc:docMk/>
            <pc:sldMk cId="449994019" sldId="262"/>
            <ac:inkMk id="34" creationId="{3C632EC3-476F-48B0-B7A7-7AFA2085DA8F}"/>
          </ac:inkMkLst>
        </pc:inkChg>
      </pc:sldChg>
      <pc:sldChg chg="addSp delSp modSp add ord modNotesTx">
        <pc:chgData name="Maggie Bohm" userId="571282b2550de325" providerId="LiveId" clId="{BC1CEF96-62B4-4845-980C-633C6D42E13D}" dt="2020-04-28T19:40:13.061" v="12129" actId="20577"/>
        <pc:sldMkLst>
          <pc:docMk/>
          <pc:sldMk cId="3894494027" sldId="263"/>
        </pc:sldMkLst>
        <pc:spChg chg="add mod">
          <ac:chgData name="Maggie Bohm" userId="571282b2550de325" providerId="LiveId" clId="{BC1CEF96-62B4-4845-980C-633C6D42E13D}" dt="2020-04-28T19:40:13.061" v="12129" actId="20577"/>
          <ac:spMkLst>
            <pc:docMk/>
            <pc:sldMk cId="3894494027" sldId="263"/>
            <ac:spMk id="12" creationId="{36756FAC-57A3-430B-BE4E-3789ADEBBAA5}"/>
          </ac:spMkLst>
        </pc:spChg>
        <pc:spChg chg="add mod">
          <ac:chgData name="Maggie Bohm" userId="571282b2550de325" providerId="LiveId" clId="{BC1CEF96-62B4-4845-980C-633C6D42E13D}" dt="2020-04-16T15:54:27.015" v="5784" actId="208"/>
          <ac:spMkLst>
            <pc:docMk/>
            <pc:sldMk cId="3894494027" sldId="263"/>
            <ac:spMk id="13" creationId="{A2E889BE-CD57-4BA7-A0FB-B0F0B54EB368}"/>
          </ac:spMkLst>
        </pc:spChg>
        <pc:spChg chg="add mod">
          <ac:chgData name="Maggie Bohm" userId="571282b2550de325" providerId="LiveId" clId="{BC1CEF96-62B4-4845-980C-633C6D42E13D}" dt="2020-04-16T15:54:33.262" v="5785" actId="2085"/>
          <ac:spMkLst>
            <pc:docMk/>
            <pc:sldMk cId="3894494027" sldId="263"/>
            <ac:spMk id="14" creationId="{A2DCE005-5BDC-4207-B664-DF6142A5E3C7}"/>
          </ac:spMkLst>
        </pc:spChg>
        <pc:spChg chg="mod topLvl">
          <ac:chgData name="Maggie Bohm" userId="571282b2550de325" providerId="LiveId" clId="{BC1CEF96-62B4-4845-980C-633C6D42E13D}" dt="2020-04-24T18:26:38.279" v="12010" actId="207"/>
          <ac:spMkLst>
            <pc:docMk/>
            <pc:sldMk cId="3894494027" sldId="263"/>
            <ac:spMk id="18" creationId="{E994ED7A-8ACF-44C7-8D66-CC9B0CF7ABF8}"/>
          </ac:spMkLst>
        </pc:spChg>
        <pc:spChg chg="mod topLvl">
          <ac:chgData name="Maggie Bohm" userId="571282b2550de325" providerId="LiveId" clId="{BC1CEF96-62B4-4845-980C-633C6D42E13D}" dt="2020-04-16T17:39:54.784" v="6081" actId="338"/>
          <ac:spMkLst>
            <pc:docMk/>
            <pc:sldMk cId="3894494027" sldId="263"/>
            <ac:spMk id="19" creationId="{9A4ED855-2FBC-4635-AA57-C18CEECE4C40}"/>
          </ac:spMkLst>
        </pc:spChg>
        <pc:spChg chg="mod topLvl">
          <ac:chgData name="Maggie Bohm" userId="571282b2550de325" providerId="LiveId" clId="{BC1CEF96-62B4-4845-980C-633C6D42E13D}" dt="2020-04-16T17:39:54.784" v="6081" actId="338"/>
          <ac:spMkLst>
            <pc:docMk/>
            <pc:sldMk cId="3894494027" sldId="263"/>
            <ac:spMk id="21" creationId="{85DAC53C-02DA-45BA-AFE0-A280739F927F}"/>
          </ac:spMkLst>
        </pc:spChg>
        <pc:spChg chg="mod topLvl">
          <ac:chgData name="Maggie Bohm" userId="571282b2550de325" providerId="LiveId" clId="{BC1CEF96-62B4-4845-980C-633C6D42E13D}" dt="2020-04-16T17:39:54.784" v="6081" actId="338"/>
          <ac:spMkLst>
            <pc:docMk/>
            <pc:sldMk cId="3894494027" sldId="263"/>
            <ac:spMk id="22" creationId="{DF76C90F-6868-4449-BD95-1B976C333AB7}"/>
          </ac:spMkLst>
        </pc:spChg>
        <pc:spChg chg="add mod">
          <ac:chgData name="Maggie Bohm" userId="571282b2550de325" providerId="LiveId" clId="{BC1CEF96-62B4-4845-980C-633C6D42E13D}" dt="2020-04-16T17:40:27.160" v="6082" actId="164"/>
          <ac:spMkLst>
            <pc:docMk/>
            <pc:sldMk cId="3894494027" sldId="263"/>
            <ac:spMk id="23" creationId="{E36B34CE-6910-40E3-B469-6AD2708B24FC}"/>
          </ac:spMkLst>
        </pc:spChg>
        <pc:spChg chg="add mod">
          <ac:chgData name="Maggie Bohm" userId="571282b2550de325" providerId="LiveId" clId="{BC1CEF96-62B4-4845-980C-633C6D42E13D}" dt="2020-04-16T17:40:27.160" v="6082" actId="164"/>
          <ac:spMkLst>
            <pc:docMk/>
            <pc:sldMk cId="3894494027" sldId="263"/>
            <ac:spMk id="25" creationId="{6F76B961-7BD8-4E4B-B3BB-1405C5D1E34A}"/>
          </ac:spMkLst>
        </pc:spChg>
        <pc:grpChg chg="add mod">
          <ac:chgData name="Maggie Bohm" userId="571282b2550de325" providerId="LiveId" clId="{BC1CEF96-62B4-4845-980C-633C6D42E13D}" dt="2020-04-16T17:40:27.160" v="6082" actId="164"/>
          <ac:grpSpMkLst>
            <pc:docMk/>
            <pc:sldMk cId="3894494027" sldId="263"/>
            <ac:grpSpMk id="2" creationId="{EA51486A-89B4-43EE-863A-9B799D438EBA}"/>
          </ac:grpSpMkLst>
        </pc:grpChg>
        <pc:grpChg chg="add mod">
          <ac:chgData name="Maggie Bohm" userId="571282b2550de325" providerId="LiveId" clId="{BC1CEF96-62B4-4845-980C-633C6D42E13D}" dt="2020-04-22T19:15:51.726" v="11568" actId="1076"/>
          <ac:grpSpMkLst>
            <pc:docMk/>
            <pc:sldMk cId="3894494027" sldId="263"/>
            <ac:grpSpMk id="4" creationId="{F8247A46-F018-40D1-8964-ACA1ACD94DC5}"/>
          </ac:grpSpMkLst>
        </pc:grpChg>
        <pc:grpChg chg="del mod">
          <ac:chgData name="Maggie Bohm" userId="571282b2550de325" providerId="LiveId" clId="{BC1CEF96-62B4-4845-980C-633C6D42E13D}" dt="2020-04-13T01:07:16.965" v="2881"/>
          <ac:grpSpMkLst>
            <pc:docMk/>
            <pc:sldMk cId="3894494027" sldId="263"/>
            <ac:grpSpMk id="6" creationId="{32D4B238-E0F2-4370-A27F-E634ED6FFFFD}"/>
          </ac:grpSpMkLst>
        </pc:grpChg>
        <pc:grpChg chg="add del mod">
          <ac:chgData name="Maggie Bohm" userId="571282b2550de325" providerId="LiveId" clId="{BC1CEF96-62B4-4845-980C-633C6D42E13D}" dt="2020-04-16T15:54:56.956" v="5816" actId="478"/>
          <ac:grpSpMkLst>
            <pc:docMk/>
            <pc:sldMk cId="3894494027" sldId="263"/>
            <ac:grpSpMk id="8" creationId="{63254F0D-220C-4035-928F-05BB49FA0F36}"/>
          </ac:grpSpMkLst>
        </pc:grpChg>
        <pc:grpChg chg="add del mod">
          <ac:chgData name="Maggie Bohm" userId="571282b2550de325" providerId="LiveId" clId="{BC1CEF96-62B4-4845-980C-633C6D42E13D}" dt="2020-04-16T17:39:15.734" v="6078" actId="478"/>
          <ac:grpSpMkLst>
            <pc:docMk/>
            <pc:sldMk cId="3894494027" sldId="263"/>
            <ac:grpSpMk id="15" creationId="{0A56C6E4-2428-40AD-9396-3FC085B9ECC4}"/>
          </ac:grpSpMkLst>
        </pc:grpChg>
        <pc:grpChg chg="del mod">
          <ac:chgData name="Maggie Bohm" userId="571282b2550de325" providerId="LiveId" clId="{BC1CEF96-62B4-4845-980C-633C6D42E13D}" dt="2020-04-13T01:07:59.914" v="2885"/>
          <ac:grpSpMkLst>
            <pc:docMk/>
            <pc:sldMk cId="3894494027" sldId="263"/>
            <ac:grpSpMk id="16" creationId="{1A39C4A4-AAB6-4A06-AF5B-E34AFE466E82}"/>
          </ac:grpSpMkLst>
        </pc:grpChg>
        <pc:grpChg chg="add del mod">
          <ac:chgData name="Maggie Bohm" userId="571282b2550de325" providerId="LiveId" clId="{BC1CEF96-62B4-4845-980C-633C6D42E13D}" dt="2020-04-16T17:34:38.117" v="6005" actId="165"/>
          <ac:grpSpMkLst>
            <pc:docMk/>
            <pc:sldMk cId="3894494027" sldId="263"/>
            <ac:grpSpMk id="17" creationId="{2FCB73C3-22B1-4EB2-BF83-5CCD26A0F053}"/>
          </ac:grpSpMkLst>
        </pc:grpChg>
        <pc:grpChg chg="del mod">
          <ac:chgData name="Maggie Bohm" userId="571282b2550de325" providerId="LiveId" clId="{BC1CEF96-62B4-4845-980C-633C6D42E13D}" dt="2020-04-13T01:08:02.164" v="2889"/>
          <ac:grpSpMkLst>
            <pc:docMk/>
            <pc:sldMk cId="3894494027" sldId="263"/>
            <ac:grpSpMk id="20" creationId="{B9FE3C10-C83C-44E3-9656-03BFB032527D}"/>
          </ac:grpSpMkLst>
        </pc:grpChg>
        <pc:grpChg chg="del mod">
          <ac:chgData name="Maggie Bohm" userId="571282b2550de325" providerId="LiveId" clId="{BC1CEF96-62B4-4845-980C-633C6D42E13D}" dt="2020-04-16T15:54:59.044" v="5817" actId="478"/>
          <ac:grpSpMkLst>
            <pc:docMk/>
            <pc:sldMk cId="3894494027" sldId="263"/>
            <ac:grpSpMk id="24" creationId="{48A820B5-B729-471D-A061-538F1B140122}"/>
          </ac:grpSpMkLst>
        </pc:grpChg>
        <pc:grpChg chg="del mod">
          <ac:chgData name="Maggie Bohm" userId="571282b2550de325" providerId="LiveId" clId="{BC1CEF96-62B4-4845-980C-633C6D42E13D}" dt="2020-04-13T01:08:05.337" v="2891"/>
          <ac:grpSpMkLst>
            <pc:docMk/>
            <pc:sldMk cId="3894494027" sldId="263"/>
            <ac:grpSpMk id="24" creationId="{61426B5A-23A1-47EB-AFB2-2800DABF30F3}"/>
          </ac:grpSpMkLst>
        </pc:grpChg>
        <pc:grpChg chg="del mod">
          <ac:chgData name="Maggie Bohm" userId="571282b2550de325" providerId="LiveId" clId="{BC1CEF96-62B4-4845-980C-633C6D42E13D}" dt="2020-04-15T18:55:25.272" v="3263" actId="478"/>
          <ac:grpSpMkLst>
            <pc:docMk/>
            <pc:sldMk cId="3894494027" sldId="263"/>
            <ac:grpSpMk id="26" creationId="{97A2F383-EF57-400B-8DE4-A1AAE5C27D46}"/>
          </ac:grpSpMkLst>
        </pc:grpChg>
        <pc:graphicFrameChg chg="add mod modGraphic">
          <ac:chgData name="Maggie Bohm" userId="571282b2550de325" providerId="LiveId" clId="{BC1CEF96-62B4-4845-980C-633C6D42E13D}" dt="2020-04-24T18:26:30.335" v="12009" actId="207"/>
          <ac:graphicFrameMkLst>
            <pc:docMk/>
            <pc:sldMk cId="3894494027" sldId="263"/>
            <ac:graphicFrameMk id="11" creationId="{FD436EA3-0A30-4BD3-9ABA-4986E4C3B182}"/>
          </ac:graphicFrameMkLst>
        </pc:graphicFrameChg>
        <pc:picChg chg="add mod">
          <ac:chgData name="Maggie Bohm" userId="571282b2550de325" providerId="LiveId" clId="{BC1CEF96-62B4-4845-980C-633C6D42E13D}" dt="2020-04-02T18:40:23.264" v="800" actId="164"/>
          <ac:picMkLst>
            <pc:docMk/>
            <pc:sldMk cId="3894494027" sldId="263"/>
            <ac:picMk id="3" creationId="{EAD4970D-F647-490B-9ADD-1301CF67AD61}"/>
          </ac:picMkLst>
        </pc:picChg>
        <pc:picChg chg="add mod modCrop">
          <ac:chgData name="Maggie Bohm" userId="571282b2550de325" providerId="LiveId" clId="{BC1CEF96-62B4-4845-980C-633C6D42E13D}" dt="2020-04-02T18:40:23.264" v="800" actId="164"/>
          <ac:picMkLst>
            <pc:docMk/>
            <pc:sldMk cId="3894494027" sldId="263"/>
            <ac:picMk id="5" creationId="{3E855056-82CA-4DFE-9FA6-6745ED73A969}"/>
          </ac:picMkLst>
        </pc:picChg>
        <pc:picChg chg="add mod modCrop">
          <ac:chgData name="Maggie Bohm" userId="571282b2550de325" providerId="LiveId" clId="{BC1CEF96-62B4-4845-980C-633C6D42E13D}" dt="2020-04-02T18:40:23.264" v="800" actId="164"/>
          <ac:picMkLst>
            <pc:docMk/>
            <pc:sldMk cId="3894494027" sldId="263"/>
            <ac:picMk id="7" creationId="{869BB802-EF63-45BC-B39C-52E1D240AD47}"/>
          </ac:picMkLst>
        </pc:picChg>
        <pc:inkChg chg="add del mod">
          <ac:chgData name="Maggie Bohm" userId="571282b2550de325" providerId="LiveId" clId="{BC1CEF96-62B4-4845-980C-633C6D42E13D}" dt="2020-04-15T18:55:22.720" v="3260" actId="478"/>
          <ac:inkMkLst>
            <pc:docMk/>
            <pc:sldMk cId="3894494027" sldId="263"/>
            <ac:inkMk id="2" creationId="{3779B42A-49C7-40B5-B159-D0E6963F0B2E}"/>
          </ac:inkMkLst>
        </pc:inkChg>
        <pc:inkChg chg="add del mod">
          <ac:chgData name="Maggie Bohm" userId="571282b2550de325" providerId="LiveId" clId="{BC1CEF96-62B4-4845-980C-633C6D42E13D}" dt="2020-04-15T18:55:23.795" v="3261" actId="478"/>
          <ac:inkMkLst>
            <pc:docMk/>
            <pc:sldMk cId="3894494027" sldId="263"/>
            <ac:inkMk id="4" creationId="{CB283B0F-F90E-4752-A83F-922484FD2F74}"/>
          </ac:inkMkLst>
        </pc:inkChg>
        <pc:inkChg chg="add del">
          <ac:chgData name="Maggie Bohm" userId="571282b2550de325" providerId="LiveId" clId="{BC1CEF96-62B4-4845-980C-633C6D42E13D}" dt="2020-04-15T19:03:24.216" v="3336" actId="9405"/>
          <ac:inkMkLst>
            <pc:docMk/>
            <pc:sldMk cId="3894494027" sldId="263"/>
            <ac:inkMk id="6" creationId="{903CE8F9-EEFA-4E7D-AD02-64B7093F4ADC}"/>
          </ac:inkMkLst>
        </pc:inkChg>
        <pc:inkChg chg="add del">
          <ac:chgData name="Maggie Bohm" userId="571282b2550de325" providerId="LiveId" clId="{BC1CEF96-62B4-4845-980C-633C6D42E13D}" dt="2020-04-15T18:55:24.591" v="3262" actId="478"/>
          <ac:inkMkLst>
            <pc:docMk/>
            <pc:sldMk cId="3894494027" sldId="263"/>
            <ac:inkMk id="9" creationId="{AFBD5D41-1E4A-43E5-A3D9-0283E7B3B58E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10" creationId="{6EDD41BA-305C-4846-BEE4-673C800C08FA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12" creationId="{7C82E421-2A3F-47D6-9BFD-B2D3056B5D59}"/>
          </ac:inkMkLst>
        </pc:inkChg>
        <pc:inkChg chg="add mod">
          <ac:chgData name="Maggie Bohm" userId="571282b2550de325" providerId="LiveId" clId="{BC1CEF96-62B4-4845-980C-633C6D42E13D}" dt="2020-04-15T19:03:28.802" v="3339"/>
          <ac:inkMkLst>
            <pc:docMk/>
            <pc:sldMk cId="3894494027" sldId="263"/>
            <ac:inkMk id="16" creationId="{81DB7CA3-E04A-455E-AE7A-94DA4E20CCB2}"/>
          </ac:inkMkLst>
        </pc:inkChg>
        <pc:inkChg chg="add del mod">
          <ac:chgData name="Maggie Bohm" userId="571282b2550de325" providerId="LiveId" clId="{BC1CEF96-62B4-4845-980C-633C6D42E13D}" dt="2020-04-15T18:55:26.522" v="3264" actId="478"/>
          <ac:inkMkLst>
            <pc:docMk/>
            <pc:sldMk cId="3894494027" sldId="263"/>
            <ac:inkMk id="17" creationId="{60D1C4CD-630B-49C8-98DB-D253BC58EAEB}"/>
          </ac:inkMkLst>
        </pc:inkChg>
        <pc:inkChg chg="add del mod">
          <ac:chgData name="Maggie Bohm" userId="571282b2550de325" providerId="LiveId" clId="{BC1CEF96-62B4-4845-980C-633C6D42E13D}" dt="2020-04-15T18:55:28.835" v="3265" actId="478"/>
          <ac:inkMkLst>
            <pc:docMk/>
            <pc:sldMk cId="3894494027" sldId="263"/>
            <ac:inkMk id="18" creationId="{F1882E69-3AB8-4ABC-8806-D7B2C28489D9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19" creationId="{F26521EF-A958-4D22-8DCC-C74D60476304}"/>
          </ac:inkMkLst>
        </pc:inkChg>
        <pc:inkChg chg="add mod">
          <ac:chgData name="Maggie Bohm" userId="571282b2550de325" providerId="LiveId" clId="{BC1CEF96-62B4-4845-980C-633C6D42E13D}" dt="2020-04-15T19:03:28.802" v="3339"/>
          <ac:inkMkLst>
            <pc:docMk/>
            <pc:sldMk cId="3894494027" sldId="263"/>
            <ac:inkMk id="20" creationId="{7355F692-9BE4-4978-823E-92BD7A7AC87A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21" creationId="{12E6C693-6B83-4438-9A49-5290F30C80F8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22" creationId="{AF417286-91FF-4EAD-8167-5FEFFFC00749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23" creationId="{42629C3C-D0A2-4641-8308-B384BC0A7DD0}"/>
          </ac:inkMkLst>
        </pc:inkChg>
        <pc:inkChg chg="add mod">
          <ac:chgData name="Maggie Bohm" userId="571282b2550de325" providerId="LiveId" clId="{BC1CEF96-62B4-4845-980C-633C6D42E13D}" dt="2020-04-13T01:08:05.337" v="2891"/>
          <ac:inkMkLst>
            <pc:docMk/>
            <pc:sldMk cId="3894494027" sldId="263"/>
            <ac:inkMk id="25" creationId="{F47A4B9A-0939-4165-ABFB-233A2EF99237}"/>
          </ac:inkMkLst>
        </pc:inkChg>
        <pc:inkChg chg="add">
          <ac:chgData name="Maggie Bohm" userId="571282b2550de325" providerId="LiveId" clId="{BC1CEF96-62B4-4845-980C-633C6D42E13D}" dt="2020-04-15T19:03:30.624" v="3340" actId="9405"/>
          <ac:inkMkLst>
            <pc:docMk/>
            <pc:sldMk cId="3894494027" sldId="263"/>
            <ac:inkMk id="27" creationId="{A9BC53B8-3960-40B8-B834-227094E973B0}"/>
          </ac:inkMkLst>
        </pc:inkChg>
      </pc:sldChg>
      <pc:sldChg chg="addSp delSp modSp add del mod setBg">
        <pc:chgData name="Maggie Bohm" userId="571282b2550de325" providerId="LiveId" clId="{BC1CEF96-62B4-4845-980C-633C6D42E13D}" dt="2020-04-09T00:57:45.369" v="2746" actId="2696"/>
        <pc:sldMkLst>
          <pc:docMk/>
          <pc:sldMk cId="312225321" sldId="264"/>
        </pc:sldMkLst>
        <pc:picChg chg="add del mod">
          <ac:chgData name="Maggie Bohm" userId="571282b2550de325" providerId="LiveId" clId="{BC1CEF96-62B4-4845-980C-633C6D42E13D}" dt="2020-04-09T00:57:06.897" v="2742" actId="21"/>
          <ac:picMkLst>
            <pc:docMk/>
            <pc:sldMk cId="312225321" sldId="264"/>
            <ac:picMk id="3" creationId="{35AE7933-B3F9-42C5-9B75-6AEB8A9190C1}"/>
          </ac:picMkLst>
        </pc:picChg>
      </pc:sldChg>
      <pc:sldChg chg="addSp delSp modSp add del ord modNotesTx">
        <pc:chgData name="Maggie Bohm" userId="571282b2550de325" providerId="LiveId" clId="{BC1CEF96-62B4-4845-980C-633C6D42E13D}" dt="2020-04-16T17:33:38.740" v="6002" actId="2696"/>
        <pc:sldMkLst>
          <pc:docMk/>
          <pc:sldMk cId="3875784713" sldId="265"/>
        </pc:sldMkLst>
        <pc:spChg chg="add del mod">
          <ac:chgData name="Maggie Bohm" userId="571282b2550de325" providerId="LiveId" clId="{BC1CEF96-62B4-4845-980C-633C6D42E13D}" dt="2020-04-06T20:17:56.859" v="2262" actId="478"/>
          <ac:spMkLst>
            <pc:docMk/>
            <pc:sldMk cId="3875784713" sldId="265"/>
            <ac:spMk id="12" creationId="{78328876-A3FE-4763-8930-A4CADF4E2E81}"/>
          </ac:spMkLst>
        </pc:spChg>
        <pc:spChg chg="mod topLvl">
          <ac:chgData name="Maggie Bohm" userId="571282b2550de325" providerId="LiveId" clId="{BC1CEF96-62B4-4845-980C-633C6D42E13D}" dt="2020-04-08T13:04:58.950" v="2521" actId="164"/>
          <ac:spMkLst>
            <pc:docMk/>
            <pc:sldMk cId="3875784713" sldId="265"/>
            <ac:spMk id="14" creationId="{FE4379AF-6295-4730-9EFE-B76BE3B1344C}"/>
          </ac:spMkLst>
        </pc:spChg>
        <pc:spChg chg="del topLvl">
          <ac:chgData name="Maggie Bohm" userId="571282b2550de325" providerId="LiveId" clId="{BC1CEF96-62B4-4845-980C-633C6D42E13D}" dt="2020-04-06T20:18:32.777" v="2266" actId="478"/>
          <ac:spMkLst>
            <pc:docMk/>
            <pc:sldMk cId="3875784713" sldId="265"/>
            <ac:spMk id="15" creationId="{265D732C-7DD5-43F2-A85D-A689DCCCE4CA}"/>
          </ac:spMkLst>
        </pc:spChg>
        <pc:spChg chg="add mod">
          <ac:chgData name="Maggie Bohm" userId="571282b2550de325" providerId="LiveId" clId="{BC1CEF96-62B4-4845-980C-633C6D42E13D}" dt="2020-04-08T13:04:58.950" v="2521" actId="164"/>
          <ac:spMkLst>
            <pc:docMk/>
            <pc:sldMk cId="3875784713" sldId="265"/>
            <ac:spMk id="16" creationId="{406BF2A2-C7D4-428E-B006-BA38CC1B43E6}"/>
          </ac:spMkLst>
        </pc:spChg>
        <pc:spChg chg="add mod">
          <ac:chgData name="Maggie Bohm" userId="571282b2550de325" providerId="LiveId" clId="{BC1CEF96-62B4-4845-980C-633C6D42E13D}" dt="2020-04-08T13:04:58.950" v="2521" actId="164"/>
          <ac:spMkLst>
            <pc:docMk/>
            <pc:sldMk cId="3875784713" sldId="265"/>
            <ac:spMk id="17" creationId="{C0E41CA6-956E-48B9-B0F5-D9EF586B3E3E}"/>
          </ac:spMkLst>
        </pc:spChg>
        <pc:spChg chg="add mod">
          <ac:chgData name="Maggie Bohm" userId="571282b2550de325" providerId="LiveId" clId="{BC1CEF96-62B4-4845-980C-633C6D42E13D}" dt="2020-04-08T13:04:58.950" v="2521" actId="164"/>
          <ac:spMkLst>
            <pc:docMk/>
            <pc:sldMk cId="3875784713" sldId="265"/>
            <ac:spMk id="18" creationId="{4A94494A-8186-4150-A6CE-CE1D092A33CA}"/>
          </ac:spMkLst>
        </pc:spChg>
        <pc:grpChg chg="add del mod">
          <ac:chgData name="Maggie Bohm" userId="571282b2550de325" providerId="LiveId" clId="{BC1CEF96-62B4-4845-980C-633C6D42E13D}" dt="2020-04-15T19:02:09.752" v="3323" actId="478"/>
          <ac:grpSpMkLst>
            <pc:docMk/>
            <pc:sldMk cId="3875784713" sldId="265"/>
            <ac:grpSpMk id="2" creationId="{58A0D816-07C7-4FA1-93F6-78961905CFAB}"/>
          </ac:grpSpMkLst>
        </pc:grpChg>
        <pc:grpChg chg="add del mod">
          <ac:chgData name="Maggie Bohm" userId="571282b2550de325" providerId="LiveId" clId="{BC1CEF96-62B4-4845-980C-633C6D42E13D}" dt="2020-04-08T13:28:39.434" v="2699"/>
          <ac:grpSpMkLst>
            <pc:docMk/>
            <pc:sldMk cId="3875784713" sldId="265"/>
            <ac:grpSpMk id="6" creationId="{E8F7D321-9AD0-418A-B423-E4C22E9DF57D}"/>
          </ac:grpSpMkLst>
        </pc:grpChg>
        <pc:grpChg chg="del mod">
          <ac:chgData name="Maggie Bohm" userId="571282b2550de325" providerId="LiveId" clId="{BC1CEF96-62B4-4845-980C-633C6D42E13D}" dt="2020-04-06T19:07:07.965" v="1513" actId="478"/>
          <ac:grpSpMkLst>
            <pc:docMk/>
            <pc:sldMk cId="3875784713" sldId="265"/>
            <ac:grpSpMk id="9" creationId="{3BA97434-8446-4412-83A7-87C64BBEF4E4}"/>
          </ac:grpSpMkLst>
        </pc:grpChg>
        <pc:grpChg chg="add del mod">
          <ac:chgData name="Maggie Bohm" userId="571282b2550de325" providerId="LiveId" clId="{BC1CEF96-62B4-4845-980C-633C6D42E13D}" dt="2020-04-08T13:28:39.434" v="2699"/>
          <ac:grpSpMkLst>
            <pc:docMk/>
            <pc:sldMk cId="3875784713" sldId="265"/>
            <ac:grpSpMk id="11" creationId="{CF70C204-FE5E-4614-8782-EE0A23355F71}"/>
          </ac:grpSpMkLst>
        </pc:grpChg>
        <pc:grpChg chg="add del mod">
          <ac:chgData name="Maggie Bohm" userId="571282b2550de325" providerId="LiveId" clId="{BC1CEF96-62B4-4845-980C-633C6D42E13D}" dt="2020-04-06T20:18:32.777" v="2266" actId="478"/>
          <ac:grpSpMkLst>
            <pc:docMk/>
            <pc:sldMk cId="3875784713" sldId="265"/>
            <ac:grpSpMk id="13" creationId="{270A6D69-C9F2-4314-BD5B-CAB2F45107E3}"/>
          </ac:grpSpMkLst>
        </pc:grpChg>
        <pc:grpChg chg="mod">
          <ac:chgData name="Maggie Bohm" userId="571282b2550de325" providerId="LiveId" clId="{BC1CEF96-62B4-4845-980C-633C6D42E13D}" dt="2020-04-08T13:28:29.975" v="2695"/>
          <ac:grpSpMkLst>
            <pc:docMk/>
            <pc:sldMk cId="3875784713" sldId="265"/>
            <ac:grpSpMk id="19" creationId="{40FB4A80-A5E9-41D8-84DD-54A68DD9FE62}"/>
          </ac:grpSpMkLst>
        </pc:grpChg>
        <pc:grpChg chg="add mod">
          <ac:chgData name="Maggie Bohm" userId="571282b2550de325" providerId="LiveId" clId="{BC1CEF96-62B4-4845-980C-633C6D42E13D}" dt="2020-04-15T19:02:14.695" v="3325" actId="1076"/>
          <ac:grpSpMkLst>
            <pc:docMk/>
            <pc:sldMk cId="3875784713" sldId="265"/>
            <ac:grpSpMk id="19" creationId="{A55105A6-CBFE-4E1B-808E-B04E27FFE412}"/>
          </ac:grpSpMkLst>
        </pc:grpChg>
        <pc:grpChg chg="del mod">
          <ac:chgData name="Maggie Bohm" userId="571282b2550de325" providerId="LiveId" clId="{BC1CEF96-62B4-4845-980C-633C6D42E13D}" dt="2020-04-08T13:28:39.434" v="2699"/>
          <ac:grpSpMkLst>
            <pc:docMk/>
            <pc:sldMk cId="3875784713" sldId="265"/>
            <ac:grpSpMk id="22" creationId="{1621883E-7F17-42B7-9F89-4009480B1B18}"/>
          </ac:grpSpMkLst>
        </pc:grpChg>
        <pc:grpChg chg="mod">
          <ac:chgData name="Maggie Bohm" userId="571282b2550de325" providerId="LiveId" clId="{BC1CEF96-62B4-4845-980C-633C6D42E13D}" dt="2020-04-15T19:02:48.502" v="3332" actId="1076"/>
          <ac:grpSpMkLst>
            <pc:docMk/>
            <pc:sldMk cId="3875784713" sldId="265"/>
            <ac:grpSpMk id="23" creationId="{969A1D05-6D27-4235-9DC8-3B28FEDB44F4}"/>
          </ac:grpSpMkLst>
        </pc:grpChg>
        <pc:graphicFrameChg chg="add mod modGraphic">
          <ac:chgData name="Maggie Bohm" userId="571282b2550de325" providerId="LiveId" clId="{BC1CEF96-62B4-4845-980C-633C6D42E13D}" dt="2020-04-15T20:50:16.889" v="3354" actId="14734"/>
          <ac:graphicFrameMkLst>
            <pc:docMk/>
            <pc:sldMk cId="3875784713" sldId="265"/>
            <ac:graphicFrameMk id="10" creationId="{E6492096-29A4-40BF-A4B9-25F489E2F5A0}"/>
          </ac:graphicFrameMkLst>
        </pc:graphicFrame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2" creationId="{057B6423-CE93-4FCD-A7FB-187F22DD0042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3" creationId="{563B25DE-BBAF-4033-A244-AC9415DE5FA8}"/>
          </ac:inkMkLst>
        </pc:inkChg>
        <pc:inkChg chg="add del">
          <ac:chgData name="Maggie Bohm" userId="571282b2550de325" providerId="LiveId" clId="{BC1CEF96-62B4-4845-980C-633C6D42E13D}" dt="2020-04-08T13:28:00.964" v="2682" actId="9405"/>
          <ac:inkMkLst>
            <pc:docMk/>
            <pc:sldMk cId="3875784713" sldId="265"/>
            <ac:inkMk id="3" creationId="{9887E9EE-27F4-4D8F-8487-F3B7FBA9B849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4" creationId="{5F3657B6-01D1-4EC8-9A3C-06A2208DE236}"/>
          </ac:inkMkLst>
        </pc:inkChg>
        <pc:inkChg chg="add mod">
          <ac:chgData name="Maggie Bohm" userId="571282b2550de325" providerId="LiveId" clId="{BC1CEF96-62B4-4845-980C-633C6D42E13D}" dt="2020-04-08T13:28:39.434" v="2699"/>
          <ac:inkMkLst>
            <pc:docMk/>
            <pc:sldMk cId="3875784713" sldId="265"/>
            <ac:inkMk id="4" creationId="{F75F2828-8644-437D-99DF-E5E43EC842C4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5" creationId="{3617E254-2C23-4A37-BA21-BBD6F174D946}"/>
          </ac:inkMkLst>
        </pc:inkChg>
        <pc:inkChg chg="add mod">
          <ac:chgData name="Maggie Bohm" userId="571282b2550de325" providerId="LiveId" clId="{BC1CEF96-62B4-4845-980C-633C6D42E13D}" dt="2020-04-08T13:28:39.434" v="2699"/>
          <ac:inkMkLst>
            <pc:docMk/>
            <pc:sldMk cId="3875784713" sldId="265"/>
            <ac:inkMk id="5" creationId="{44E156FD-1897-4A7F-BDE1-E7CAF1DBDEDF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6" creationId="{DE092D26-7BE1-484A-B240-08CDBC04AF88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7" creationId="{1AAA2326-BD37-4F7C-8996-FE3669F4B5CE}"/>
          </ac:inkMkLst>
        </pc:inkChg>
        <pc:inkChg chg="add mod">
          <ac:chgData name="Maggie Bohm" userId="571282b2550de325" providerId="LiveId" clId="{BC1CEF96-62B4-4845-980C-633C6D42E13D}" dt="2020-04-15T19:02:45.773" v="3331" actId="1076"/>
          <ac:inkMkLst>
            <pc:docMk/>
            <pc:sldMk cId="3875784713" sldId="265"/>
            <ac:inkMk id="7" creationId="{B26041F3-3C7C-4CC7-A9A6-B1136B0F3764}"/>
          </ac:inkMkLst>
        </pc:inkChg>
        <pc:inkChg chg="add mod">
          <ac:chgData name="Maggie Bohm" userId="571282b2550de325" providerId="LiveId" clId="{BC1CEF96-62B4-4845-980C-633C6D42E13D}" dt="2020-04-08T13:28:39.434" v="2699"/>
          <ac:inkMkLst>
            <pc:docMk/>
            <pc:sldMk cId="3875784713" sldId="265"/>
            <ac:inkMk id="8" creationId="{6686639A-7E6A-409B-9C2C-C974BB6411FB}"/>
          </ac:inkMkLst>
        </pc:inkChg>
        <pc:inkChg chg="add mod">
          <ac:chgData name="Maggie Bohm" userId="571282b2550de325" providerId="LiveId" clId="{BC1CEF96-62B4-4845-980C-633C6D42E13D}" dt="2020-04-06T19:02:42.765" v="1390"/>
          <ac:inkMkLst>
            <pc:docMk/>
            <pc:sldMk cId="3875784713" sldId="265"/>
            <ac:inkMk id="8" creationId="{EF542EAB-B416-4F37-B3ED-EAAD9029F091}"/>
          </ac:inkMkLst>
        </pc:inkChg>
        <pc:inkChg chg="add mod">
          <ac:chgData name="Maggie Bohm" userId="571282b2550de325" providerId="LiveId" clId="{BC1CEF96-62B4-4845-980C-633C6D42E13D}" dt="2020-04-15T19:02:54.935" v="3334" actId="1076"/>
          <ac:inkMkLst>
            <pc:docMk/>
            <pc:sldMk cId="3875784713" sldId="265"/>
            <ac:inkMk id="9" creationId="{461A7457-E249-4AEE-8643-11430B6F3F44}"/>
          </ac:inkMkLst>
        </pc:inkChg>
        <pc:inkChg chg="add mod">
          <ac:chgData name="Maggie Bohm" userId="571282b2550de325" providerId="LiveId" clId="{BC1CEF96-62B4-4845-980C-633C6D42E13D}" dt="2020-04-15T19:02:50.882" v="3333" actId="1076"/>
          <ac:inkMkLst>
            <pc:docMk/>
            <pc:sldMk cId="3875784713" sldId="265"/>
            <ac:inkMk id="12" creationId="{6496A5DC-28AB-4B68-A116-2EB9E845473F}"/>
          </ac:inkMkLst>
        </pc:inkChg>
        <pc:inkChg chg="add del mod">
          <ac:chgData name="Maggie Bohm" userId="571282b2550de325" providerId="LiveId" clId="{BC1CEF96-62B4-4845-980C-633C6D42E13D}" dt="2020-04-08T13:28:30.585" v="2696" actId="9405"/>
          <ac:inkMkLst>
            <pc:docMk/>
            <pc:sldMk cId="3875784713" sldId="265"/>
            <ac:inkMk id="13" creationId="{1643E011-BB50-49E3-B2D3-4BDFAABD6249}"/>
          </ac:inkMkLst>
        </pc:inkChg>
        <pc:inkChg chg="add del mod">
          <ac:chgData name="Maggie Bohm" userId="571282b2550de325" providerId="LiveId" clId="{BC1CEF96-62B4-4845-980C-633C6D42E13D}" dt="2020-04-08T13:28:29.975" v="2695"/>
          <ac:inkMkLst>
            <pc:docMk/>
            <pc:sldMk cId="3875784713" sldId="265"/>
            <ac:inkMk id="15" creationId="{23CE79CE-BD00-4FE5-A260-BC62F6B190D8}"/>
          </ac:inkMkLst>
        </pc:inkChg>
        <pc:inkChg chg="add mod">
          <ac:chgData name="Maggie Bohm" userId="571282b2550de325" providerId="LiveId" clId="{BC1CEF96-62B4-4845-980C-633C6D42E13D}" dt="2020-04-08T13:28:39.434" v="2699"/>
          <ac:inkMkLst>
            <pc:docMk/>
            <pc:sldMk cId="3875784713" sldId="265"/>
            <ac:inkMk id="20" creationId="{77D938F7-6C1B-411E-9F1B-E2DF86D57129}"/>
          </ac:inkMkLst>
        </pc:inkChg>
        <pc:inkChg chg="add mod">
          <ac:chgData name="Maggie Bohm" userId="571282b2550de325" providerId="LiveId" clId="{BC1CEF96-62B4-4845-980C-633C6D42E13D}" dt="2020-04-15T19:02:44.580" v="3330" actId="1076"/>
          <ac:inkMkLst>
            <pc:docMk/>
            <pc:sldMk cId="3875784713" sldId="265"/>
            <ac:inkMk id="21" creationId="{5A201CA0-7344-40FD-B1FE-97BE50EC7685}"/>
          </ac:inkMkLst>
        </pc:inkChg>
      </pc:sldChg>
      <pc:sldChg chg="addSp modSp add del ord modNotesTx">
        <pc:chgData name="Maggie Bohm" userId="571282b2550de325" providerId="LiveId" clId="{BC1CEF96-62B4-4845-980C-633C6D42E13D}" dt="2020-04-15T21:14:52.946" v="3721" actId="2696"/>
        <pc:sldMkLst>
          <pc:docMk/>
          <pc:sldMk cId="2623566126" sldId="266"/>
        </pc:sldMkLst>
        <pc:spChg chg="mod">
          <ac:chgData name="Maggie Bohm" userId="571282b2550de325" providerId="LiveId" clId="{BC1CEF96-62B4-4845-980C-633C6D42E13D}" dt="2020-04-08T13:04:46.287" v="2520" actId="164"/>
          <ac:spMkLst>
            <pc:docMk/>
            <pc:sldMk cId="2623566126" sldId="266"/>
            <ac:spMk id="14" creationId="{FE4379AF-6295-4730-9EFE-B76BE3B1344C}"/>
          </ac:spMkLst>
        </pc:spChg>
        <pc:spChg chg="mod">
          <ac:chgData name="Maggie Bohm" userId="571282b2550de325" providerId="LiveId" clId="{BC1CEF96-62B4-4845-980C-633C6D42E13D}" dt="2020-04-15T19:01:59.253" v="3322" actId="1076"/>
          <ac:spMkLst>
            <pc:docMk/>
            <pc:sldMk cId="2623566126" sldId="266"/>
            <ac:spMk id="16" creationId="{406BF2A2-C7D4-428E-B006-BA38CC1B43E6}"/>
          </ac:spMkLst>
        </pc:spChg>
        <pc:spChg chg="mod">
          <ac:chgData name="Maggie Bohm" userId="571282b2550de325" providerId="LiveId" clId="{BC1CEF96-62B4-4845-980C-633C6D42E13D}" dt="2020-04-15T19:01:10.775" v="3313" actId="255"/>
          <ac:spMkLst>
            <pc:docMk/>
            <pc:sldMk cId="2623566126" sldId="266"/>
            <ac:spMk id="17" creationId="{C0E41CA6-956E-48B9-B0F5-D9EF586B3E3E}"/>
          </ac:spMkLst>
        </pc:spChg>
        <pc:spChg chg="mod">
          <ac:chgData name="Maggie Bohm" userId="571282b2550de325" providerId="LiveId" clId="{BC1CEF96-62B4-4845-980C-633C6D42E13D}" dt="2020-04-15T19:01:48.550" v="3321" actId="1076"/>
          <ac:spMkLst>
            <pc:docMk/>
            <pc:sldMk cId="2623566126" sldId="266"/>
            <ac:spMk id="18" creationId="{4A94494A-8186-4150-A6CE-CE1D092A33CA}"/>
          </ac:spMkLst>
        </pc:spChg>
        <pc:grpChg chg="add mod">
          <ac:chgData name="Maggie Bohm" userId="571282b2550de325" providerId="LiveId" clId="{BC1CEF96-62B4-4845-980C-633C6D42E13D}" dt="2020-04-15T19:01:34.366" v="3319" actId="14100"/>
          <ac:grpSpMkLst>
            <pc:docMk/>
            <pc:sldMk cId="2623566126" sldId="266"/>
            <ac:grpSpMk id="2" creationId="{9897DEB0-CB50-4C1F-A4A2-384EF3F9B020}"/>
          </ac:grpSpMkLst>
        </pc:grpChg>
        <pc:graphicFrameChg chg="mod modGraphic">
          <ac:chgData name="Maggie Bohm" userId="571282b2550de325" providerId="LiveId" clId="{BC1CEF96-62B4-4845-980C-633C6D42E13D}" dt="2020-04-15T18:25:18.647" v="2942" actId="14734"/>
          <ac:graphicFrameMkLst>
            <pc:docMk/>
            <pc:sldMk cId="2623566126" sldId="266"/>
            <ac:graphicFrameMk id="10" creationId="{E6492096-29A4-40BF-A4B9-25F489E2F5A0}"/>
          </ac:graphicFrameMkLst>
        </pc:graphicFrameChg>
      </pc:sldChg>
      <pc:sldChg chg="addSp delSp modSp new del ord setBg modNotesTx">
        <pc:chgData name="Maggie Bohm" userId="571282b2550de325" providerId="LiveId" clId="{BC1CEF96-62B4-4845-980C-633C6D42E13D}" dt="2020-04-28T19:37:08.367" v="12106" actId="2696"/>
        <pc:sldMkLst>
          <pc:docMk/>
          <pc:sldMk cId="897885061" sldId="267"/>
        </pc:sldMkLst>
        <pc:spChg chg="del mod">
          <ac:chgData name="Maggie Bohm" userId="571282b2550de325" providerId="LiveId" clId="{BC1CEF96-62B4-4845-980C-633C6D42E13D}" dt="2020-04-16T15:42:49.941" v="5574" actId="478"/>
          <ac:spMkLst>
            <pc:docMk/>
            <pc:sldMk cId="897885061" sldId="267"/>
            <ac:spMk id="5" creationId="{30158155-6E9D-473B-A42D-7A6BA5D08CC8}"/>
          </ac:spMkLst>
        </pc:spChg>
        <pc:spChg chg="mod">
          <ac:chgData name="Maggie Bohm" userId="571282b2550de325" providerId="LiveId" clId="{BC1CEF96-62B4-4845-980C-633C6D42E13D}" dt="2020-04-15T19:00:37.475" v="3309" actId="1076"/>
          <ac:spMkLst>
            <pc:docMk/>
            <pc:sldMk cId="897885061" sldId="267"/>
            <ac:spMk id="6" creationId="{81CE2122-4592-404E-BFA3-FACA8F80708D}"/>
          </ac:spMkLst>
        </pc:spChg>
        <pc:spChg chg="mod">
          <ac:chgData name="Maggie Bohm" userId="571282b2550de325" providerId="LiveId" clId="{BC1CEF96-62B4-4845-980C-633C6D42E13D}" dt="2020-04-15T18:59:53.526" v="3303" actId="14100"/>
          <ac:spMkLst>
            <pc:docMk/>
            <pc:sldMk cId="897885061" sldId="267"/>
            <ac:spMk id="7" creationId="{9ADB2ED9-8609-4E1E-970E-5455D5E4603B}"/>
          </ac:spMkLst>
        </pc:spChg>
        <pc:spChg chg="mod">
          <ac:chgData name="Maggie Bohm" userId="571282b2550de325" providerId="LiveId" clId="{BC1CEF96-62B4-4845-980C-633C6D42E13D}" dt="2020-04-15T19:00:16.371" v="3307" actId="1076"/>
          <ac:spMkLst>
            <pc:docMk/>
            <pc:sldMk cId="897885061" sldId="267"/>
            <ac:spMk id="8" creationId="{F74C1D82-1889-45AF-9CC2-D7A903EC5D39}"/>
          </ac:spMkLst>
        </pc:spChg>
        <pc:spChg chg="add mod">
          <ac:chgData name="Maggie Bohm" userId="571282b2550de325" providerId="LiveId" clId="{BC1CEF96-62B4-4845-980C-633C6D42E13D}" dt="2020-04-23T16:53:17.875" v="11869" actId="20577"/>
          <ac:spMkLst>
            <pc:docMk/>
            <pc:sldMk cId="897885061" sldId="267"/>
            <ac:spMk id="8" creationId="{FBEA9C6F-FF32-463B-B30B-F8269CB9590C}"/>
          </ac:spMkLst>
        </pc:spChg>
        <pc:spChg chg="mod">
          <ac:chgData name="Maggie Bohm" userId="571282b2550de325" providerId="LiveId" clId="{BC1CEF96-62B4-4845-980C-633C6D42E13D}" dt="2020-04-16T19:21:42.049" v="6140" actId="207"/>
          <ac:spMkLst>
            <pc:docMk/>
            <pc:sldMk cId="897885061" sldId="267"/>
            <ac:spMk id="10" creationId="{C746DB45-9823-4E63-9915-11C071892906}"/>
          </ac:spMkLst>
        </pc:spChg>
        <pc:spChg chg="mod">
          <ac:chgData name="Maggie Bohm" userId="571282b2550de325" providerId="LiveId" clId="{BC1CEF96-62B4-4845-980C-633C6D42E13D}" dt="2020-04-16T17:45:29.027" v="6096" actId="207"/>
          <ac:spMkLst>
            <pc:docMk/>
            <pc:sldMk cId="897885061" sldId="267"/>
            <ac:spMk id="11" creationId="{AD37C728-8C6A-4007-9292-4F7B4735BFC0}"/>
          </ac:spMkLst>
        </pc:spChg>
        <pc:spChg chg="mod">
          <ac:chgData name="Maggie Bohm" userId="571282b2550de325" providerId="LiveId" clId="{BC1CEF96-62B4-4845-980C-633C6D42E13D}" dt="2020-04-19T20:35:02.083" v="6506" actId="14100"/>
          <ac:spMkLst>
            <pc:docMk/>
            <pc:sldMk cId="897885061" sldId="267"/>
            <ac:spMk id="12" creationId="{766795A9-68DB-4CA8-ADB1-E54D28AA2E6E}"/>
          </ac:spMkLst>
        </pc:spChg>
        <pc:spChg chg="mod">
          <ac:chgData name="Maggie Bohm" userId="571282b2550de325" providerId="LiveId" clId="{BC1CEF96-62B4-4845-980C-633C6D42E13D}" dt="2020-04-19T20:34:51.592" v="6505" actId="14100"/>
          <ac:spMkLst>
            <pc:docMk/>
            <pc:sldMk cId="897885061" sldId="267"/>
            <ac:spMk id="13" creationId="{1EB16A2E-C6AC-4844-83AE-EF2376750219}"/>
          </ac:spMkLst>
        </pc:spChg>
        <pc:grpChg chg="add del mod">
          <ac:chgData name="Maggie Bohm" userId="571282b2550de325" providerId="LiveId" clId="{BC1CEF96-62B4-4845-980C-633C6D42E13D}" dt="2020-04-16T17:49:22.002" v="6119" actId="478"/>
          <ac:grpSpMkLst>
            <pc:docMk/>
            <pc:sldMk cId="897885061" sldId="267"/>
            <ac:grpSpMk id="4" creationId="{2A129ADD-A937-42CD-A82E-628743EBA874}"/>
          </ac:grpSpMkLst>
        </pc:grpChg>
        <pc:grpChg chg="add mod">
          <ac:chgData name="Maggie Bohm" userId="571282b2550de325" providerId="LiveId" clId="{BC1CEF96-62B4-4845-980C-633C6D42E13D}" dt="2020-04-22T19:15:23.985" v="11566" actId="1076"/>
          <ac:grpSpMkLst>
            <pc:docMk/>
            <pc:sldMk cId="897885061" sldId="267"/>
            <ac:grpSpMk id="9" creationId="{C2A1E847-06FA-4A83-B59A-9315EB2A3CBB}"/>
          </ac:grpSpMkLst>
        </pc:grpChg>
        <pc:graphicFrameChg chg="add mod modGraphic">
          <ac:chgData name="Maggie Bohm" userId="571282b2550de325" providerId="LiveId" clId="{BC1CEF96-62B4-4845-980C-633C6D42E13D}" dt="2020-04-28T19:36:24.366" v="12105" actId="14734"/>
          <ac:graphicFrameMkLst>
            <pc:docMk/>
            <pc:sldMk cId="897885061" sldId="267"/>
            <ac:graphicFrameMk id="2" creationId="{8C5EDBC5-AAB5-4496-B103-489985D1F9BB}"/>
          </ac:graphicFrameMkLst>
        </pc:graphicFrameChg>
      </pc:sldChg>
      <pc:sldChg chg="addSp delSp modSp add del">
        <pc:chgData name="Maggie Bohm" userId="571282b2550de325" providerId="LiveId" clId="{BC1CEF96-62B4-4845-980C-633C6D42E13D}" dt="2020-04-13T01:05:42.276" v="2874" actId="2696"/>
        <pc:sldMkLst>
          <pc:docMk/>
          <pc:sldMk cId="3208455270" sldId="267"/>
        </pc:sldMkLst>
        <pc:spChg chg="add del">
          <ac:chgData name="Maggie Bohm" userId="571282b2550de325" providerId="LiveId" clId="{BC1CEF96-62B4-4845-980C-633C6D42E13D}" dt="2020-04-08T13:30:09.131" v="2705"/>
          <ac:spMkLst>
            <pc:docMk/>
            <pc:sldMk cId="3208455270" sldId="267"/>
            <ac:spMk id="2" creationId="{96B6DD78-2957-435F-B724-0F7904FBD620}"/>
          </ac:spMkLst>
        </pc:spChg>
        <pc:graphicFrameChg chg="add mod">
          <ac:chgData name="Maggie Bohm" userId="571282b2550de325" providerId="LiveId" clId="{BC1CEF96-62B4-4845-980C-633C6D42E13D}" dt="2020-04-08T13:30:24.447" v="2707" actId="1076"/>
          <ac:graphicFrameMkLst>
            <pc:docMk/>
            <pc:sldMk cId="3208455270" sldId="267"/>
            <ac:graphicFrameMk id="3" creationId="{D157FFCA-3496-4ED4-918A-95E0316AA3B9}"/>
          </ac:graphicFrameMkLst>
        </pc:graphicFrameChg>
      </pc:sldChg>
      <pc:sldChg chg="addSp delSp modSp add del modNotesTx">
        <pc:chgData name="Maggie Bohm" userId="571282b2550de325" providerId="LiveId" clId="{BC1CEF96-62B4-4845-980C-633C6D42E13D}" dt="2020-04-28T19:27:05.254" v="12048" actId="2696"/>
        <pc:sldMkLst>
          <pc:docMk/>
          <pc:sldMk cId="178237714" sldId="268"/>
        </pc:sldMkLst>
        <pc:spChg chg="add mod">
          <ac:chgData name="Maggie Bohm" userId="571282b2550de325" providerId="LiveId" clId="{BC1CEF96-62B4-4845-980C-633C6D42E13D}" dt="2020-04-23T16:47:36.571" v="11721" actId="20577"/>
          <ac:spMkLst>
            <pc:docMk/>
            <pc:sldMk cId="178237714" sldId="268"/>
            <ac:spMk id="2" creationId="{12D46FF8-EC0A-4EB3-AF69-1E7EBD5246FD}"/>
          </ac:spMkLst>
        </pc:spChg>
        <pc:spChg chg="add mod topLvl">
          <ac:chgData name="Maggie Bohm" userId="571282b2550de325" providerId="LiveId" clId="{BC1CEF96-62B4-4845-980C-633C6D42E13D}" dt="2020-04-16T17:46:27.656" v="6104" actId="207"/>
          <ac:spMkLst>
            <pc:docMk/>
            <pc:sldMk cId="178237714" sldId="268"/>
            <ac:spMk id="6" creationId="{6C1BF602-7F95-4DE0-909D-17CF6F996F05}"/>
          </ac:spMkLst>
        </pc:spChg>
        <pc:spChg chg="add mod topLvl">
          <ac:chgData name="Maggie Bohm" userId="571282b2550de325" providerId="LiveId" clId="{BC1CEF96-62B4-4845-980C-633C6D42E13D}" dt="2020-04-16T17:45:50.536" v="6099" actId="207"/>
          <ac:spMkLst>
            <pc:docMk/>
            <pc:sldMk cId="178237714" sldId="268"/>
            <ac:spMk id="11" creationId="{E7A7B443-5E2C-478C-91CC-4BA0358D997B}"/>
          </ac:spMkLst>
        </pc:spChg>
        <pc:spChg chg="mod">
          <ac:chgData name="Maggie Bohm" userId="571282b2550de325" providerId="LiveId" clId="{BC1CEF96-62B4-4845-980C-633C6D42E13D}" dt="2020-04-24T18:30:27.802" v="12041" actId="207"/>
          <ac:spMkLst>
            <pc:docMk/>
            <pc:sldMk cId="178237714" sldId="268"/>
            <ac:spMk id="14" creationId="{9947D070-28E8-445F-A97C-51CCF5087EAF}"/>
          </ac:spMkLst>
        </pc:spChg>
        <pc:spChg chg="add mod topLvl">
          <ac:chgData name="Maggie Bohm" userId="571282b2550de325" providerId="LiveId" clId="{BC1CEF96-62B4-4845-980C-633C6D42E13D}" dt="2020-04-16T17:46:53.080" v="6108" actId="207"/>
          <ac:spMkLst>
            <pc:docMk/>
            <pc:sldMk cId="178237714" sldId="268"/>
            <ac:spMk id="27" creationId="{8B04CAB2-5065-473A-A6E8-D9E6B48DFD30}"/>
          </ac:spMkLst>
        </pc:spChg>
        <pc:spChg chg="add mod topLvl">
          <ac:chgData name="Maggie Bohm" userId="571282b2550de325" providerId="LiveId" clId="{BC1CEF96-62B4-4845-980C-633C6D42E13D}" dt="2020-04-16T17:45:56.033" v="6100" actId="207"/>
          <ac:spMkLst>
            <pc:docMk/>
            <pc:sldMk cId="178237714" sldId="268"/>
            <ac:spMk id="28" creationId="{4176A301-EA9E-4130-80B3-0AC586B7A516}"/>
          </ac:spMkLst>
        </pc:spChg>
        <pc:grpChg chg="add mod">
          <ac:chgData name="Maggie Bohm" userId="571282b2550de325" providerId="LiveId" clId="{BC1CEF96-62B4-4845-980C-633C6D42E13D}" dt="2020-04-22T19:16:22.505" v="11570" actId="1076"/>
          <ac:grpSpMkLst>
            <pc:docMk/>
            <pc:sldMk cId="178237714" sldId="268"/>
            <ac:grpSpMk id="9" creationId="{5A295B86-0065-4F4D-A6E2-4D529B5DA105}"/>
          </ac:grpSpMkLst>
        </pc:grpChg>
        <pc:grpChg chg="add del mod">
          <ac:chgData name="Maggie Bohm" userId="571282b2550de325" providerId="LiveId" clId="{BC1CEF96-62B4-4845-980C-633C6D42E13D}" dt="2020-04-16T15:31:17.306" v="5233" actId="165"/>
          <ac:grpSpMkLst>
            <pc:docMk/>
            <pc:sldMk cId="178237714" sldId="268"/>
            <ac:grpSpMk id="14" creationId="{D15C448C-7432-4B83-A783-ED67B8F7B45C}"/>
          </ac:grpSpMkLst>
        </pc:grpChg>
        <pc:grpChg chg="add del mod">
          <ac:chgData name="Maggie Bohm" userId="571282b2550de325" providerId="LiveId" clId="{BC1CEF96-62B4-4845-980C-633C6D42E13D}" dt="2020-04-16T15:30:14.428" v="5224" actId="165"/>
          <ac:grpSpMkLst>
            <pc:docMk/>
            <pc:sldMk cId="178237714" sldId="268"/>
            <ac:grpSpMk id="15" creationId="{10AB4D87-71AC-4FB9-A860-B713341BDB53}"/>
          </ac:grpSpMkLst>
        </pc:grpChg>
        <pc:grpChg chg="add del mod">
          <ac:chgData name="Maggie Bohm" userId="571282b2550de325" providerId="LiveId" clId="{BC1CEF96-62B4-4845-980C-633C6D42E13D}" dt="2020-04-19T20:36:31.333" v="6512" actId="478"/>
          <ac:grpSpMkLst>
            <pc:docMk/>
            <pc:sldMk cId="178237714" sldId="268"/>
            <ac:grpSpMk id="16" creationId="{8EF07CA8-0967-4C3A-98F3-07568AF11326}"/>
          </ac:grpSpMkLst>
        </pc:grpChg>
        <pc:grpChg chg="del mod">
          <ac:chgData name="Maggie Bohm" userId="571282b2550de325" providerId="LiveId" clId="{BC1CEF96-62B4-4845-980C-633C6D42E13D}" dt="2020-04-16T15:26:54.255" v="5202" actId="478"/>
          <ac:grpSpMkLst>
            <pc:docMk/>
            <pc:sldMk cId="178237714" sldId="268"/>
            <ac:grpSpMk id="19" creationId="{A55105A6-CBFE-4E1B-808E-B04E27FFE412}"/>
          </ac:grpSpMkLst>
        </pc:grpChg>
        <pc:grpChg chg="del">
          <ac:chgData name="Maggie Bohm" userId="571282b2550de325" providerId="LiveId" clId="{BC1CEF96-62B4-4845-980C-633C6D42E13D}" dt="2020-04-16T17:43:15.106" v="6089" actId="478"/>
          <ac:grpSpMkLst>
            <pc:docMk/>
            <pc:sldMk cId="178237714" sldId="268"/>
            <ac:grpSpMk id="23" creationId="{969A1D05-6D27-4235-9DC8-3B28FEDB44F4}"/>
          </ac:grpSpMkLst>
        </pc:grpChg>
        <pc:graphicFrameChg chg="add del mod modGraphic">
          <ac:chgData name="Maggie Bohm" userId="571282b2550de325" providerId="LiveId" clId="{BC1CEF96-62B4-4845-980C-633C6D42E13D}" dt="2020-04-24T18:30:22.308" v="12040" actId="207"/>
          <ac:graphicFrameMkLst>
            <pc:docMk/>
            <pc:sldMk cId="178237714" sldId="268"/>
            <ac:graphicFrameMk id="10" creationId="{E6492096-29A4-40BF-A4B9-25F489E2F5A0}"/>
          </ac:graphicFrameMkLst>
        </pc:graphicFrameChg>
        <pc:inkChg chg="del">
          <ac:chgData name="Maggie Bohm" userId="571282b2550de325" providerId="LiveId" clId="{BC1CEF96-62B4-4845-980C-633C6D42E13D}" dt="2020-04-16T17:43:01.842" v="6086" actId="478"/>
          <ac:inkMkLst>
            <pc:docMk/>
            <pc:sldMk cId="178237714" sldId="268"/>
            <ac:inkMk id="7" creationId="{B26041F3-3C7C-4CC7-A9A6-B1136B0F3764}"/>
          </ac:inkMkLst>
        </pc:inkChg>
        <pc:inkChg chg="del">
          <ac:chgData name="Maggie Bohm" userId="571282b2550de325" providerId="LiveId" clId="{BC1CEF96-62B4-4845-980C-633C6D42E13D}" dt="2020-04-16T17:43:03.845" v="6087" actId="478"/>
          <ac:inkMkLst>
            <pc:docMk/>
            <pc:sldMk cId="178237714" sldId="268"/>
            <ac:inkMk id="9" creationId="{461A7457-E249-4AEE-8643-11430B6F3F44}"/>
          </ac:inkMkLst>
        </pc:inkChg>
        <pc:inkChg chg="del">
          <ac:chgData name="Maggie Bohm" userId="571282b2550de325" providerId="LiveId" clId="{BC1CEF96-62B4-4845-980C-633C6D42E13D}" dt="2020-04-16T17:43:07.242" v="6088" actId="478"/>
          <ac:inkMkLst>
            <pc:docMk/>
            <pc:sldMk cId="178237714" sldId="268"/>
            <ac:inkMk id="12" creationId="{6496A5DC-28AB-4B68-A116-2EB9E845473F}"/>
          </ac:inkMkLst>
        </pc:inkChg>
        <pc:inkChg chg="add del">
          <ac:chgData name="Maggie Bohm" userId="571282b2550de325" providerId="LiveId" clId="{BC1CEF96-62B4-4845-980C-633C6D42E13D}" dt="2020-04-16T15:28:24.259" v="5212" actId="9405"/>
          <ac:inkMkLst>
            <pc:docMk/>
            <pc:sldMk cId="178237714" sldId="268"/>
            <ac:inkMk id="13" creationId="{BFCD3B13-16EB-4984-BFC2-39382B4B59C6}"/>
          </ac:inkMkLst>
        </pc:inkChg>
        <pc:inkChg chg="del">
          <ac:chgData name="Maggie Bohm" userId="571282b2550de325" providerId="LiveId" clId="{BC1CEF96-62B4-4845-980C-633C6D42E13D}" dt="2020-04-16T17:43:07.242" v="6088" actId="478"/>
          <ac:inkMkLst>
            <pc:docMk/>
            <pc:sldMk cId="178237714" sldId="268"/>
            <ac:inkMk id="21" creationId="{5A201CA0-7344-40FD-B1FE-97BE50EC7685}"/>
          </ac:inkMkLst>
        </pc:inkChg>
      </pc:sldChg>
      <pc:sldChg chg="addSp modSp new del">
        <pc:chgData name="Maggie Bohm" userId="571282b2550de325" providerId="LiveId" clId="{BC1CEF96-62B4-4845-980C-633C6D42E13D}" dt="2020-04-20T21:49:09.758" v="6522" actId="47"/>
        <pc:sldMkLst>
          <pc:docMk/>
          <pc:sldMk cId="562929890" sldId="269"/>
        </pc:sldMkLst>
        <pc:picChg chg="add mod">
          <ac:chgData name="Maggie Bohm" userId="571282b2550de325" providerId="LiveId" clId="{BC1CEF96-62B4-4845-980C-633C6D42E13D}" dt="2020-04-17T17:00:14.766" v="6161" actId="1076"/>
          <ac:picMkLst>
            <pc:docMk/>
            <pc:sldMk cId="562929890" sldId="269"/>
            <ac:picMk id="3" creationId="{6BBEDF09-4928-4651-ADEF-43BF084CD42B}"/>
          </ac:picMkLst>
        </pc:picChg>
        <pc:picChg chg="add mod">
          <ac:chgData name="Maggie Bohm" userId="571282b2550de325" providerId="LiveId" clId="{BC1CEF96-62B4-4845-980C-633C6D42E13D}" dt="2020-04-17T17:00:31.644" v="6167" actId="1076"/>
          <ac:picMkLst>
            <pc:docMk/>
            <pc:sldMk cId="562929890" sldId="269"/>
            <ac:picMk id="4" creationId="{C5CD3FA7-AAD8-4505-AC34-01F6BCE9A33C}"/>
          </ac:picMkLst>
        </pc:picChg>
        <pc:picChg chg="add mod">
          <ac:chgData name="Maggie Bohm" userId="571282b2550de325" providerId="LiveId" clId="{BC1CEF96-62B4-4845-980C-633C6D42E13D}" dt="2020-04-16T17:32:06.709" v="5999" actId="1076"/>
          <ac:picMkLst>
            <pc:docMk/>
            <pc:sldMk cId="562929890" sldId="269"/>
            <ac:picMk id="5" creationId="{1FA43E3F-0E79-46F7-807B-5D393A6B2D61}"/>
          </ac:picMkLst>
        </pc:picChg>
      </pc:sldChg>
      <pc:sldChg chg="addSp delSp modSp add del modNotesTx">
        <pc:chgData name="Maggie Bohm" userId="571282b2550de325" providerId="LiveId" clId="{BC1CEF96-62B4-4845-980C-633C6D42E13D}" dt="2020-04-28T19:27:00.642" v="12047" actId="2696"/>
        <pc:sldMkLst>
          <pc:docMk/>
          <pc:sldMk cId="553591006" sldId="270"/>
        </pc:sldMkLst>
        <pc:spChg chg="mod">
          <ac:chgData name="Maggie Bohm" userId="571282b2550de325" providerId="LiveId" clId="{BC1CEF96-62B4-4845-980C-633C6D42E13D}" dt="2020-04-24T18:29:58.507" v="12037" actId="207"/>
          <ac:spMkLst>
            <pc:docMk/>
            <pc:sldMk cId="553591006" sldId="270"/>
            <ac:spMk id="6" creationId="{6C1BF602-7F95-4DE0-909D-17CF6F996F05}"/>
          </ac:spMkLst>
        </pc:spChg>
        <pc:spChg chg="add del">
          <ac:chgData name="Maggie Bohm" userId="571282b2550de325" providerId="LiveId" clId="{BC1CEF96-62B4-4845-980C-633C6D42E13D}" dt="2020-04-23T16:47:46.101" v="11722" actId="478"/>
          <ac:spMkLst>
            <pc:docMk/>
            <pc:sldMk cId="553591006" sldId="270"/>
            <ac:spMk id="9" creationId="{49A688E9-39AD-4987-BD1F-3CD385D017E5}"/>
          </ac:spMkLst>
        </pc:spChg>
        <pc:spChg chg="add">
          <ac:chgData name="Maggie Bohm" userId="571282b2550de325" providerId="LiveId" clId="{BC1CEF96-62B4-4845-980C-633C6D42E13D}" dt="2020-04-23T16:47:47.027" v="11723"/>
          <ac:spMkLst>
            <pc:docMk/>
            <pc:sldMk cId="553591006" sldId="270"/>
            <ac:spMk id="12" creationId="{79E15C7C-323B-4DC1-BDDF-10576E04691F}"/>
          </ac:spMkLst>
        </pc:spChg>
        <pc:spChg chg="mod">
          <ac:chgData name="Maggie Bohm" userId="571282b2550de325" providerId="LiveId" clId="{BC1CEF96-62B4-4845-980C-633C6D42E13D}" dt="2020-04-19T20:36:11.338" v="6510" actId="14100"/>
          <ac:spMkLst>
            <pc:docMk/>
            <pc:sldMk cId="553591006" sldId="270"/>
            <ac:spMk id="28" creationId="{4176A301-EA9E-4130-80B3-0AC586B7A516}"/>
          </ac:spMkLst>
        </pc:spChg>
        <pc:grpChg chg="mod">
          <ac:chgData name="Maggie Bohm" userId="571282b2550de325" providerId="LiveId" clId="{BC1CEF96-62B4-4845-980C-633C6D42E13D}" dt="2020-04-22T19:14:10.120" v="11558" actId="1076"/>
          <ac:grpSpMkLst>
            <pc:docMk/>
            <pc:sldMk cId="553591006" sldId="270"/>
            <ac:grpSpMk id="16" creationId="{8EF07CA8-0967-4C3A-98F3-07568AF11326}"/>
          </ac:grpSpMkLst>
        </pc:grpChg>
        <pc:graphicFrameChg chg="mod modGraphic">
          <ac:chgData name="Maggie Bohm" userId="571282b2550de325" providerId="LiveId" clId="{BC1CEF96-62B4-4845-980C-633C6D42E13D}" dt="2020-04-24T18:29:52.874" v="12036" actId="207"/>
          <ac:graphicFrameMkLst>
            <pc:docMk/>
            <pc:sldMk cId="553591006" sldId="270"/>
            <ac:graphicFrameMk id="10" creationId="{E6492096-29A4-40BF-A4B9-25F489E2F5A0}"/>
          </ac:graphicFrameMkLst>
        </pc:graphicFrameChg>
      </pc:sldChg>
      <pc:sldChg chg="addSp delSp modSp add del modNotesTx">
        <pc:chgData name="Maggie Bohm" userId="571282b2550de325" providerId="LiveId" clId="{BC1CEF96-62B4-4845-980C-633C6D42E13D}" dt="2020-04-28T19:39:26.998" v="12107" actId="2696"/>
        <pc:sldMkLst>
          <pc:docMk/>
          <pc:sldMk cId="1769309019" sldId="271"/>
        </pc:sldMkLst>
        <pc:spChg chg="add del">
          <ac:chgData name="Maggie Bohm" userId="571282b2550de325" providerId="LiveId" clId="{BC1CEF96-62B4-4845-980C-633C6D42E13D}" dt="2020-04-23T16:47:52.832" v="11724" actId="478"/>
          <ac:spMkLst>
            <pc:docMk/>
            <pc:sldMk cId="1769309019" sldId="271"/>
            <ac:spMk id="11" creationId="{56EC66F1-6849-45E6-B569-1E657AFAD2C5}"/>
          </ac:spMkLst>
        </pc:spChg>
        <pc:spChg chg="mod">
          <ac:chgData name="Maggie Bohm" userId="571282b2550de325" providerId="LiveId" clId="{BC1CEF96-62B4-4845-980C-633C6D42E13D}" dt="2020-04-24T21:24:35.736" v="12046" actId="207"/>
          <ac:spMkLst>
            <pc:docMk/>
            <pc:sldMk cId="1769309019" sldId="271"/>
            <ac:spMk id="14" creationId="{D50492A6-6E9B-49A6-B58B-1AA66E7CAABB}"/>
          </ac:spMkLst>
        </pc:spChg>
        <pc:spChg chg="add">
          <ac:chgData name="Maggie Bohm" userId="571282b2550de325" providerId="LiveId" clId="{BC1CEF96-62B4-4845-980C-633C6D42E13D}" dt="2020-04-23T16:47:53.345" v="11725"/>
          <ac:spMkLst>
            <pc:docMk/>
            <pc:sldMk cId="1769309019" sldId="271"/>
            <ac:spMk id="16" creationId="{8AC68DC8-8793-4818-BCE3-84AC95112E79}"/>
          </ac:spMkLst>
        </pc:spChg>
        <pc:grpChg chg="add mod">
          <ac:chgData name="Maggie Bohm" userId="571282b2550de325" providerId="LiveId" clId="{BC1CEF96-62B4-4845-980C-633C6D42E13D}" dt="2020-04-22T19:14:33.128" v="11560" actId="1076"/>
          <ac:grpSpMkLst>
            <pc:docMk/>
            <pc:sldMk cId="1769309019" sldId="271"/>
            <ac:grpSpMk id="9" creationId="{84A65345-1AAF-46D0-A297-E45790D8DA7A}"/>
          </ac:grpSpMkLst>
        </pc:grpChg>
        <pc:grpChg chg="del">
          <ac:chgData name="Maggie Bohm" userId="571282b2550de325" providerId="LiveId" clId="{BC1CEF96-62B4-4845-980C-633C6D42E13D}" dt="2020-04-19T20:37:08.238" v="6518" actId="478"/>
          <ac:grpSpMkLst>
            <pc:docMk/>
            <pc:sldMk cId="1769309019" sldId="271"/>
            <ac:grpSpMk id="16" creationId="{8EF07CA8-0967-4C3A-98F3-07568AF11326}"/>
          </ac:grpSpMkLst>
        </pc:grpChg>
        <pc:graphicFrameChg chg="mod modGraphic">
          <ac:chgData name="Maggie Bohm" userId="571282b2550de325" providerId="LiveId" clId="{BC1CEF96-62B4-4845-980C-633C6D42E13D}" dt="2020-04-24T21:24:26.203" v="12045" actId="207"/>
          <ac:graphicFrameMkLst>
            <pc:docMk/>
            <pc:sldMk cId="1769309019" sldId="271"/>
            <ac:graphicFrameMk id="10" creationId="{E6492096-29A4-40BF-A4B9-25F489E2F5A0}"/>
          </ac:graphicFrameMkLst>
        </pc:graphicFrameChg>
      </pc:sldChg>
      <pc:sldChg chg="modSp add modNotesTx">
        <pc:chgData name="Maggie Bohm" userId="571282b2550de325" providerId="LiveId" clId="{BC1CEF96-62B4-4845-980C-633C6D42E13D}" dt="2020-05-01T15:48:52.282" v="12323" actId="20577"/>
        <pc:sldMkLst>
          <pc:docMk/>
          <pc:sldMk cId="1653660894" sldId="272"/>
        </pc:sldMkLst>
        <pc:spChg chg="mod">
          <ac:chgData name="Maggie Bohm" userId="571282b2550de325" providerId="LiveId" clId="{BC1CEF96-62B4-4845-980C-633C6D42E13D}" dt="2020-04-28T19:40:06.323" v="12120" actId="20577"/>
          <ac:spMkLst>
            <pc:docMk/>
            <pc:sldMk cId="1653660894" sldId="272"/>
            <ac:spMk id="16" creationId="{8AC68DC8-8793-4818-BCE3-84AC95112E79}"/>
          </ac:spMkLst>
        </pc:spChg>
        <pc:grpChg chg="mod">
          <ac:chgData name="Maggie Bohm" userId="571282b2550de325" providerId="LiveId" clId="{BC1CEF96-62B4-4845-980C-633C6D42E13D}" dt="2020-04-28T19:29:37.333" v="12052" actId="1076"/>
          <ac:grpSpMkLst>
            <pc:docMk/>
            <pc:sldMk cId="1653660894" sldId="272"/>
            <ac:grpSpMk id="9" creationId="{84A65345-1AAF-46D0-A297-E45790D8DA7A}"/>
          </ac:grpSpMkLst>
        </pc:grpChg>
        <pc:graphicFrameChg chg="modGraphic">
          <ac:chgData name="Maggie Bohm" userId="571282b2550de325" providerId="LiveId" clId="{BC1CEF96-62B4-4845-980C-633C6D42E13D}" dt="2020-04-28T19:27:42.322" v="12051" actId="2165"/>
          <ac:graphicFrameMkLst>
            <pc:docMk/>
            <pc:sldMk cId="1653660894" sldId="272"/>
            <ac:graphicFrameMk id="10" creationId="{E6492096-29A4-40BF-A4B9-25F489E2F5A0}"/>
          </ac:graphicFrameMkLst>
        </pc:graphicFrameChg>
      </pc:sldChg>
      <pc:sldChg chg="delSp modSp add ord modNotesTx">
        <pc:chgData name="Maggie Bohm" userId="571282b2550de325" providerId="LiveId" clId="{BC1CEF96-62B4-4845-980C-633C6D42E13D}" dt="2020-05-01T15:51:01.255" v="12470" actId="20577"/>
        <pc:sldMkLst>
          <pc:docMk/>
          <pc:sldMk cId="2000785667" sldId="273"/>
        </pc:sldMkLst>
        <pc:spChg chg="mod">
          <ac:chgData name="Maggie Bohm" userId="571282b2550de325" providerId="LiveId" clId="{BC1CEF96-62B4-4845-980C-633C6D42E13D}" dt="2020-04-28T19:34:42.601" v="12082" actId="20577"/>
          <ac:spMkLst>
            <pc:docMk/>
            <pc:sldMk cId="2000785667" sldId="273"/>
            <ac:spMk id="6" creationId="{FB9AE3DD-E69D-403E-B6BC-A4C3320A8F17}"/>
          </ac:spMkLst>
        </pc:spChg>
        <pc:picChg chg="del">
          <ac:chgData name="Maggie Bohm" userId="571282b2550de325" providerId="LiveId" clId="{BC1CEF96-62B4-4845-980C-633C6D42E13D}" dt="2020-04-28T19:29:57.281" v="12054" actId="478"/>
          <ac:picMkLst>
            <pc:docMk/>
            <pc:sldMk cId="2000785667" sldId="273"/>
            <ac:picMk id="7" creationId="{5E1F4F99-86A5-4AFE-B309-31ADB956FDC7}"/>
          </ac:picMkLst>
        </pc:picChg>
        <pc:picChg chg="del">
          <ac:chgData name="Maggie Bohm" userId="571282b2550de325" providerId="LiveId" clId="{BC1CEF96-62B4-4845-980C-633C6D42E13D}" dt="2020-04-28T19:29:59.240" v="12055" actId="478"/>
          <ac:picMkLst>
            <pc:docMk/>
            <pc:sldMk cId="2000785667" sldId="273"/>
            <ac:picMk id="10" creationId="{07183763-9E86-4B93-9B3D-8F6A2C2F7708}"/>
          </ac:picMkLst>
        </pc:picChg>
        <pc:picChg chg="mod modCrop">
          <ac:chgData name="Maggie Bohm" userId="571282b2550de325" providerId="LiveId" clId="{BC1CEF96-62B4-4845-980C-633C6D42E13D}" dt="2020-04-28T19:30:44.588" v="12060" actId="1076"/>
          <ac:picMkLst>
            <pc:docMk/>
            <pc:sldMk cId="2000785667" sldId="273"/>
            <ac:picMk id="12" creationId="{A7436400-26A3-4A7F-BE43-86DF056A048D}"/>
          </ac:picMkLst>
        </pc:picChg>
      </pc:sldChg>
      <pc:sldChg chg="modSp mod ord">
        <pc:chgData name="Maggie Bohm" userId="571282b2550de325" providerId="LiveId" clId="{BC1CEF96-62B4-4845-980C-633C6D42E13D}" dt="2020-05-08T18:16:33.242" v="12495" actId="14100"/>
        <pc:sldMkLst>
          <pc:docMk/>
          <pc:sldMk cId="1268900807" sldId="274"/>
        </pc:sldMkLst>
        <pc:grpChg chg="mod">
          <ac:chgData name="Maggie Bohm" userId="571282b2550de325" providerId="LiveId" clId="{BC1CEF96-62B4-4845-980C-633C6D42E13D}" dt="2020-05-08T18:16:33.242" v="12495" actId="14100"/>
          <ac:grpSpMkLst>
            <pc:docMk/>
            <pc:sldMk cId="1268900807" sldId="274"/>
            <ac:grpSpMk id="9" creationId="{84A65345-1AAF-46D0-A297-E45790D8DA7A}"/>
          </ac:grpSpMkLst>
        </pc:grpChg>
      </pc:sldChg>
      <pc:sldMasterChg chg="modSp modSldLayout">
        <pc:chgData name="Maggie Bohm" userId="571282b2550de325" providerId="LiveId" clId="{BC1CEF96-62B4-4845-980C-633C6D42E13D}" dt="2020-04-02T15:04:03.602" v="671"/>
        <pc:sldMasterMkLst>
          <pc:docMk/>
          <pc:sldMasterMk cId="3922914931" sldId="2147483648"/>
        </pc:sldMasterMkLst>
        <pc:spChg chg="mod">
          <ac:chgData name="Maggie Bohm" userId="571282b2550de325" providerId="LiveId" clId="{BC1CEF96-62B4-4845-980C-633C6D42E13D}" dt="2020-04-02T15:04:03.602" v="671"/>
          <ac:spMkLst>
            <pc:docMk/>
            <pc:sldMasterMk cId="3922914931" sldId="2147483648"/>
            <ac:spMk id="2" creationId="{0EFD8AC3-B65D-40D7-BCF8-CE3CEE68BA65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asterMk cId="3922914931" sldId="2147483648"/>
            <ac:spMk id="3" creationId="{37E52A81-7563-4569-A79B-FF7DB6BD106B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asterMk cId="3922914931" sldId="2147483648"/>
            <ac:spMk id="4" creationId="{8968839D-D8C9-41AF-999C-6E5F0244DA5C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asterMk cId="3922914931" sldId="2147483648"/>
            <ac:spMk id="5" creationId="{123729BE-3BE1-4042-A6A3-14B1EDF9DB39}"/>
          </ac:spMkLst>
        </pc:spChg>
        <pc:spChg chg="mod">
          <ac:chgData name="Maggie Bohm" userId="571282b2550de325" providerId="LiveId" clId="{BC1CEF96-62B4-4845-980C-633C6D42E13D}" dt="2020-04-02T15:04:03.602" v="671"/>
          <ac:spMkLst>
            <pc:docMk/>
            <pc:sldMasterMk cId="3922914931" sldId="2147483648"/>
            <ac:spMk id="6" creationId="{C74E4BD3-F30C-4415-B712-8D36F7972C06}"/>
          </ac:spMkLst>
        </pc:sp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2362512765" sldId="2147483649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2362512765" sldId="2147483649"/>
              <ac:spMk id="2" creationId="{F7DA2629-4669-441A-AE12-655D5CBFBE71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2362512765" sldId="2147483649"/>
              <ac:spMk id="3" creationId="{AF7E97FA-3AD0-4251-966F-9E3F8318D719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1099712522" sldId="2147483651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1099712522" sldId="2147483651"/>
              <ac:spMk id="2" creationId="{124EF654-AA49-4CD2-86A7-7C00292B55F7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1099712522" sldId="2147483651"/>
              <ac:spMk id="3" creationId="{8AC11BB1-7AE4-4D01-A153-74EE35B96423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554340247" sldId="2147483652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554340247" sldId="2147483652"/>
              <ac:spMk id="3" creationId="{88D04B2A-23EB-41DF-8542-3875D7CA88B9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554340247" sldId="2147483652"/>
              <ac:spMk id="4" creationId="{7ACCAD2E-E5D2-4A59-A998-83A919CB361C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3816942997" sldId="2147483653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816942997" sldId="2147483653"/>
              <ac:spMk id="2" creationId="{FDEB4B80-6929-4BC9-A987-FF79106B741B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816942997" sldId="2147483653"/>
              <ac:spMk id="3" creationId="{9F47F594-9973-48B4-8DCE-D4B597059B8F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816942997" sldId="2147483653"/>
              <ac:spMk id="4" creationId="{D2EB4604-4526-414A-BA92-903DA7B54DD2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816942997" sldId="2147483653"/>
              <ac:spMk id="5" creationId="{E6EBF3FB-52A2-435E-B466-F50338606638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816942997" sldId="2147483653"/>
              <ac:spMk id="6" creationId="{EFE9D781-A528-4B27-A909-BC9E2792F9C1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2127000099" sldId="2147483656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2127000099" sldId="2147483656"/>
              <ac:spMk id="2" creationId="{D334219D-DB0D-4779-ABA2-CC5E7CDB13FD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2127000099" sldId="2147483656"/>
              <ac:spMk id="3" creationId="{B0466BEC-BA5A-4A87-9D47-7D095C1972F2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2127000099" sldId="2147483656"/>
              <ac:spMk id="4" creationId="{7C18FCC0-D923-417A-AD36-1FA2E0603418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3482281020" sldId="2147483657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482281020" sldId="2147483657"/>
              <ac:spMk id="2" creationId="{19A0F6CC-7FB3-4F51-B53B-276182767E31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482281020" sldId="2147483657"/>
              <ac:spMk id="3" creationId="{A745025E-DC5A-4013-B657-211A4E82B70E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482281020" sldId="2147483657"/>
              <ac:spMk id="4" creationId="{5C21244B-3522-4874-8056-AD84FF7972BF}"/>
            </ac:spMkLst>
          </pc:spChg>
        </pc:sldLayoutChg>
        <pc:sldLayoutChg chg="modSp">
          <pc:chgData name="Maggie Bohm" userId="571282b2550de325" providerId="LiveId" clId="{BC1CEF96-62B4-4845-980C-633C6D42E13D}" dt="2020-04-02T15:04:03.602" v="671"/>
          <pc:sldLayoutMkLst>
            <pc:docMk/>
            <pc:sldMasterMk cId="3922914931" sldId="2147483648"/>
            <pc:sldLayoutMk cId="3136573544" sldId="2147483659"/>
          </pc:sldLayoutMkLst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136573544" sldId="2147483659"/>
              <ac:spMk id="2" creationId="{8B4F1B1C-6DA4-4CF0-BC89-4DFF46446EE8}"/>
            </ac:spMkLst>
          </pc:spChg>
          <pc:spChg chg="mod">
            <ac:chgData name="Maggie Bohm" userId="571282b2550de325" providerId="LiveId" clId="{BC1CEF96-62B4-4845-980C-633C6D42E13D}" dt="2020-04-02T15:04:03.602" v="671"/>
            <ac:spMkLst>
              <pc:docMk/>
              <pc:sldMasterMk cId="3922914931" sldId="2147483648"/>
              <pc:sldLayoutMk cId="3136573544" sldId="2147483659"/>
              <ac:spMk id="3" creationId="{1FE108F4-53EA-4476-B637-7BE6BA62B90A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2ED488-8495-4CDF-A562-2425A121EE4C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27BB8C-5949-4DD6-9D4C-73F1CD41F9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342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27BB8C-5949-4DD6-9D4C-73F1CD41F99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3567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314450" marR="0" lvl="0" indent="-1314450" algn="l" defTabSz="914400" rtl="0" eaLnBrk="1" fontAlgn="auto" latinLnBrk="0" hangingPunct="1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PCR analysis of murine-derived commercial culture components for evidence of murine DNA. PCR analysis illustrates that murine DNA, indicated by the mouse-specific marker </a:t>
            </a:r>
            <a:r>
              <a:rPr lang="en-US" sz="18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ger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s present in both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rigel</a:t>
            </a:r>
            <a:r>
              <a:rPr lang="en-US" sz="18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orning) and the organoid growth medium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stiCult-human</a:t>
            </a:r>
            <a:r>
              <a:rPr lang="en-US" sz="18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emCell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chnologies) as well as confirming the detectable presence of murine DNA in </a:t>
            </a:r>
            <a:r>
              <a:rPr lang="en-US" sz="18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-WRN </a:t>
            </a:r>
            <a:r>
              <a:rPr lang="en-US" sz="180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dium</a:t>
            </a:r>
            <a:r>
              <a:rPr lang="en-US" sz="1800" baseline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y a second primer set.</a:t>
            </a:r>
            <a:endParaRPr lang="en-US" sz="180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1314450" marR="0" indent="-131445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27BB8C-5949-4DD6-9D4C-73F1CD41F99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844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3775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1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0962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5759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1164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899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948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849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903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448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413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47960-FBF9-4166-AE0D-8A75302C4906}" type="datetimeFigureOut">
              <a:rPr lang="en-US" smtClean="0"/>
              <a:t>10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27F8B-991A-44A6-9829-786AEDCF8E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20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E7AECCB-A40F-4B16-B823-CF5B794C7F29}"/>
              </a:ext>
            </a:extLst>
          </p:cNvPr>
          <p:cNvSpPr txBox="1"/>
          <p:nvPr/>
        </p:nvSpPr>
        <p:spPr>
          <a:xfrm>
            <a:off x="3661988" y="1255571"/>
            <a:ext cx="48278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 Analysis of Human Organoid Lines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A650259-8F12-49B8-B96A-248E816A97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0901477"/>
              </p:ext>
            </p:extLst>
          </p:nvPr>
        </p:nvGraphicFramePr>
        <p:xfrm>
          <a:off x="818105" y="1918333"/>
          <a:ext cx="10515598" cy="3000764"/>
        </p:xfrm>
        <a:graphic>
          <a:graphicData uri="http://schemas.openxmlformats.org/drawingml/2006/table">
            <a:tbl>
              <a:tblPr/>
              <a:tblGrid>
                <a:gridCol w="629455">
                  <a:extLst>
                    <a:ext uri="{9D8B030D-6E8A-4147-A177-3AD203B41FA5}">
                      <a16:colId xmlns:a16="http://schemas.microsoft.com/office/drawing/2014/main" val="473088220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3267950621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3239702628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024961042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83040151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017549752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3972772398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1061992287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749519882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1997094689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1550955316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613649130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62091842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3168463641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2280712190"/>
                    </a:ext>
                  </a:extLst>
                </a:gridCol>
                <a:gridCol w="543059">
                  <a:extLst>
                    <a:ext uri="{9D8B030D-6E8A-4147-A177-3AD203B41FA5}">
                      <a16:colId xmlns:a16="http://schemas.microsoft.com/office/drawing/2014/main" val="3439424565"/>
                    </a:ext>
                  </a:extLst>
                </a:gridCol>
                <a:gridCol w="580086">
                  <a:extLst>
                    <a:ext uri="{9D8B030D-6E8A-4147-A177-3AD203B41FA5}">
                      <a16:colId xmlns:a16="http://schemas.microsoft.com/office/drawing/2014/main" val="4109528733"/>
                    </a:ext>
                  </a:extLst>
                </a:gridCol>
                <a:gridCol w="580086">
                  <a:extLst>
                    <a:ext uri="{9D8B030D-6E8A-4147-A177-3AD203B41FA5}">
                      <a16:colId xmlns:a16="http://schemas.microsoft.com/office/drawing/2014/main" val="738239384"/>
                    </a:ext>
                  </a:extLst>
                </a:gridCol>
                <a:gridCol w="580086">
                  <a:extLst>
                    <a:ext uri="{9D8B030D-6E8A-4147-A177-3AD203B41FA5}">
                      <a16:colId xmlns:a16="http://schemas.microsoft.com/office/drawing/2014/main" val="710994106"/>
                    </a:ext>
                  </a:extLst>
                </a:gridCol>
              </a:tblGrid>
              <a:tr h="538785">
                <a:tc row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atient ID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16"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urce Tissue STR Loci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erived Organoids Percent Match to Source Tissue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63172484"/>
                  </a:ext>
                </a:extLst>
              </a:tr>
              <a:tr h="25081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MEL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SF1PO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1353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16553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1855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19543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215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25133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35135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558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7582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85117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GA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0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POX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vWA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olon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uodenum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82937795"/>
                  </a:ext>
                </a:extLst>
              </a:tr>
              <a:tr h="2721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-881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, Y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, 2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4645" marR="4645" marT="464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 9.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8278241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0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2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, 3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, 2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16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6, 2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 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 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9793161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1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9, 3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, 2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 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, 2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 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3394734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3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 15.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, 33.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, 2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6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 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, 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0041676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4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1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, 3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, 2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 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, 2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OL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302775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5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8, 3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, 2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 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1, 24.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, 9.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0701659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7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, Y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, 33.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2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, 26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.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2822065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8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, 1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, 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3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9, 2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, 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, 2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, 9.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315695"/>
                  </a:ext>
                </a:extLst>
              </a:tr>
              <a:tr h="241525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9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X, Y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5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.2, 3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8, 20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, 11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, 13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4, 25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, 17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0%</a:t>
                      </a:r>
                    </a:p>
                  </a:txBody>
                  <a:tcPr marL="4645" marR="4645" marT="464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196746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70346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5E1F4F99-86A5-4AFE-B309-31ADB956FDC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76171" y="410901"/>
            <a:ext cx="3758083" cy="559148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B9AE3DD-E69D-403E-B6BC-A4C3320A8F17}"/>
              </a:ext>
            </a:extLst>
          </p:cNvPr>
          <p:cNvSpPr txBox="1"/>
          <p:nvPr/>
        </p:nvSpPr>
        <p:spPr>
          <a:xfrm>
            <a:off x="6505559" y="2602888"/>
            <a:ext cx="4469890" cy="1919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CR analysis of murine-derived commercial culture components for evidence of murine DNA. PCR analysis illustrates that murine DNA, indicated by the mouse-specific marker </a:t>
            </a:r>
            <a:r>
              <a:rPr lang="en-US" sz="14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tger2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is present in both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rigel</a:t>
            </a:r>
            <a:r>
              <a:rPr lang="en-US" sz="14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Corning) and the organoid growth medium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stiCult-human</a:t>
            </a:r>
            <a:r>
              <a:rPr lang="en-US" sz="1400" baseline="30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M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emCell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chnologies) as well as confirming the detectable presence of murine DNA in L-WRN medium by a second primer set.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853892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91</TotalTime>
  <Words>573</Words>
  <Application>Microsoft Office PowerPoint</Application>
  <PresentationFormat>Widescreen</PresentationFormat>
  <Paragraphs>19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gie Bohm</dc:creator>
  <cp:lastModifiedBy>Dame, Michael</cp:lastModifiedBy>
  <cp:revision>26</cp:revision>
  <dcterms:created xsi:type="dcterms:W3CDTF">2020-04-02T19:39:36Z</dcterms:created>
  <dcterms:modified xsi:type="dcterms:W3CDTF">2020-10-29T01:40:26Z</dcterms:modified>
</cp:coreProperties>
</file>